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6000"/>
  </p:normalViewPr>
  <p:slideViewPr>
    <p:cSldViewPr snapToGrid="0">
      <p:cViewPr varScale="1">
        <p:scale>
          <a:sx n="107" d="100"/>
          <a:sy n="107" d="100"/>
        </p:scale>
        <p:origin x="6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1C2734-6A1A-7012-CE3D-F4749A5669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5DCEAED-8D46-5D77-DF42-FCF0ACA241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6E511D-BFED-0708-DA01-27404AE01B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BCC40-124B-7747-BA04-10F20C246F87}" type="datetimeFigureOut">
              <a:rPr lang="en-US" smtClean="0"/>
              <a:t>1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7CC2CD-B538-CE7E-2DA4-9DFF484DBD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BF6234-EF48-BF4A-3198-6C238B69B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B5131-51E7-834A-9A2F-92F070167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1324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E5B57A-1C81-6861-312A-7383DAC6A9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14DAF6-01C3-0AF6-7D0C-96C517870F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A7A8FF-3660-E0A2-86A4-AB8CB1DB7C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BCC40-124B-7747-BA04-10F20C246F87}" type="datetimeFigureOut">
              <a:rPr lang="en-US" smtClean="0"/>
              <a:t>1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303845-D418-514B-AB99-3D597653E3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1FE25B-18D1-C660-84DB-CDE62134B2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B5131-51E7-834A-9A2F-92F070167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3117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7CACCCA-AF79-D211-80EE-EA10087916A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212B67D-940A-A0A3-AB92-0AFE3DE28F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65D38C-DEC4-A56C-17ED-498D7BD51A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BCC40-124B-7747-BA04-10F20C246F87}" type="datetimeFigureOut">
              <a:rPr lang="en-US" smtClean="0"/>
              <a:t>1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D15294-C110-F487-A4D9-97FB250564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FA1616-91B7-9839-3DA9-7900982DF6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B5131-51E7-834A-9A2F-92F070167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2214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BFD252-BF7E-4BFA-F172-06870C27C7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F7EADF-EBB4-F40B-EFE2-0438B86BEA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AE65CA-63EF-A510-2297-F74554D703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BCC40-124B-7747-BA04-10F20C246F87}" type="datetimeFigureOut">
              <a:rPr lang="en-US" smtClean="0"/>
              <a:t>1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75FEBB-CAF8-985D-A811-28B59F2986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72FCB5-F28A-FE67-F780-0072D38DDC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B5131-51E7-834A-9A2F-92F070167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6164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69CBC9-E252-21BF-AD7A-745546F3B2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EEEE58-285F-13F0-CE82-BCC0F51616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AA0111-DD81-CCC7-3661-00801470C4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BCC40-124B-7747-BA04-10F20C246F87}" type="datetimeFigureOut">
              <a:rPr lang="en-US" smtClean="0"/>
              <a:t>1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1ACCD8-E7FF-CCF9-C91D-9E51B4D52F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259D5D-D8EC-F8C0-CA1E-246B128BAA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B5131-51E7-834A-9A2F-92F070167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214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CBB8A4-B0FC-EBAE-24C8-B600AB973E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ABA88F-C2DE-A92F-86F2-B37E45579E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AF64A36-44AF-F187-3DFA-251D098720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65DCC3-EE89-BEB4-5ACF-1BBC707EC2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BCC40-124B-7747-BA04-10F20C246F87}" type="datetimeFigureOut">
              <a:rPr lang="en-US" smtClean="0"/>
              <a:t>1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FEFBC1-DFD4-8AFE-FA36-3E448CA5BE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A88ABE-D145-DA7C-7D14-2E0359CFC0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B5131-51E7-834A-9A2F-92F070167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2733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669447-28ED-DB1D-7379-E9E57D7473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6D9C52-3EA4-E81E-20B9-98F2776112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D0239F-A03C-3AC8-5462-88666335A8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82AEC4F-3AF7-0F65-19DD-AC6952911D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B2DE150-8AE5-4573-2FEE-D5ACEB3843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303B622-CEEB-FFB1-5259-BEED74DDB5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BCC40-124B-7747-BA04-10F20C246F87}" type="datetimeFigureOut">
              <a:rPr lang="en-US" smtClean="0"/>
              <a:t>1/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460B0C1-A948-5F1F-CEFC-D2E402DA09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3FF1823-1A79-1E69-33F5-51B5BDF70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B5131-51E7-834A-9A2F-92F070167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4059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E2A627-2434-1170-1CB7-E2EF399C27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E778179-A969-26BC-2F51-A16047EC1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BCC40-124B-7747-BA04-10F20C246F87}" type="datetimeFigureOut">
              <a:rPr lang="en-US" smtClean="0"/>
              <a:t>1/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139B6D2-DB39-7619-9290-794FD46208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8968B05-3B8C-3583-9708-EFA31CD7C0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B5131-51E7-834A-9A2F-92F070167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2906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6B54D60-D70F-9A80-5F20-59FC2890A3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BCC40-124B-7747-BA04-10F20C246F87}" type="datetimeFigureOut">
              <a:rPr lang="en-US" smtClean="0"/>
              <a:t>1/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F002B18-1AD8-72B4-4E56-07C93433D9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4E15503-C8DB-4A87-A3E9-C0B5664C06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B5131-51E7-834A-9A2F-92F070167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660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A1A5F8-BD89-A62D-601F-1A59A5AA07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729A51-0E40-E550-364F-B8D6289391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10C4C72-3EBF-DE6E-251F-3A310FDF09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E0DBAE-0F15-ED29-A661-CABD685060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BCC40-124B-7747-BA04-10F20C246F87}" type="datetimeFigureOut">
              <a:rPr lang="en-US" smtClean="0"/>
              <a:t>1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2D9576-FDD1-07B2-EAB5-A73F9D901E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E6986C-875C-08DE-2C39-9CD9C71704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B5131-51E7-834A-9A2F-92F070167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164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BC8F21-DD38-900E-2368-A00F9D55BF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F1CFB86-52E3-B33E-1D9A-1E6AB0DBB01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A6F75F-AB6F-5BE6-6AC4-9D05C10F29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F0B18F-EAC9-26B9-F332-85E5D9A0A6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BCC40-124B-7747-BA04-10F20C246F87}" type="datetimeFigureOut">
              <a:rPr lang="en-US" smtClean="0"/>
              <a:t>1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C7053B-3C74-4C10-52FF-F6AB8379D8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3AC4C4-A853-26E3-0CB2-852C6144DC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B5131-51E7-834A-9A2F-92F070167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05579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7E29D30-3660-BD34-1D5A-FF0CF1B33C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23C945-D537-FA0C-30CE-F6C101C294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A1E4D5-F386-5F69-4927-7246D33BB9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1BCC40-124B-7747-BA04-10F20C246F87}" type="datetimeFigureOut">
              <a:rPr lang="en-US" smtClean="0"/>
              <a:t>1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1C890F-3FC4-62DA-4750-2FBC59E809F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39D908-8992-581B-245D-4D4B6B548F4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AB5131-51E7-834A-9A2F-92F070167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3262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E39601C4-9CB1-F461-358B-362D393B95EC}"/>
              </a:ext>
            </a:extLst>
          </p:cNvPr>
          <p:cNvSpPr txBox="1"/>
          <p:nvPr/>
        </p:nvSpPr>
        <p:spPr>
          <a:xfrm>
            <a:off x="432902" y="4421790"/>
            <a:ext cx="941100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Figure S2</a:t>
            </a:r>
            <a:r>
              <a:rPr lang="en-US" dirty="0"/>
              <a:t>: </a:t>
            </a:r>
            <a:r>
              <a:rPr lang="en-US" dirty="0" err="1"/>
              <a:t>ER:melanosome</a:t>
            </a:r>
            <a:r>
              <a:rPr lang="en-US" dirty="0"/>
              <a:t> MCS in cellular RPE models. Cells in culture were fixed and prepared for electron microscopy.  </a:t>
            </a:r>
            <a:r>
              <a:rPr lang="en-US" b="1" dirty="0"/>
              <a:t>A</a:t>
            </a:r>
            <a:r>
              <a:rPr lang="en-US" dirty="0"/>
              <a:t>) Primary porcine RPE isolated from porcine eye tissue and passaged once onto </a:t>
            </a:r>
            <a:r>
              <a:rPr lang="en-US" dirty="0" err="1"/>
              <a:t>transwell</a:t>
            </a:r>
            <a:r>
              <a:rPr lang="en-US" dirty="0"/>
              <a:t> membranes prior to fixation.  Images show ER at MCS false-</a:t>
            </a:r>
            <a:r>
              <a:rPr lang="en-US" dirty="0" err="1"/>
              <a:t>coloured</a:t>
            </a:r>
            <a:r>
              <a:rPr lang="en-US" dirty="0"/>
              <a:t> lilac. </a:t>
            </a:r>
            <a:r>
              <a:rPr lang="en-US" b="1" dirty="0"/>
              <a:t>B</a:t>
            </a:r>
            <a:r>
              <a:rPr lang="en-US" dirty="0"/>
              <a:t>) ARPE19 cells were cultured in X-Vivo medium for 6 weeks to gain pigmentation.  Magnified images of the boxed region is shown on the right with the ER at MCS false-</a:t>
            </a:r>
            <a:r>
              <a:rPr lang="en-US" dirty="0" err="1"/>
              <a:t>coloured</a:t>
            </a:r>
            <a:r>
              <a:rPr lang="en-US" dirty="0"/>
              <a:t> lilac. Scale bar, 250 nm.</a:t>
            </a: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16FCDCE5-7545-6AEE-3E0D-2C512C9A4B77}"/>
              </a:ext>
            </a:extLst>
          </p:cNvPr>
          <p:cNvGrpSpPr/>
          <p:nvPr/>
        </p:nvGrpSpPr>
        <p:grpSpPr>
          <a:xfrm>
            <a:off x="432902" y="623258"/>
            <a:ext cx="9301124" cy="3908287"/>
            <a:chOff x="432902" y="623258"/>
            <a:chExt cx="9301124" cy="3908287"/>
          </a:xfrm>
        </p:grpSpPr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59A7D3B6-AF91-B1CB-3D0F-5BC3D4B7EE0C}"/>
                </a:ext>
              </a:extLst>
            </p:cNvPr>
            <p:cNvGrpSpPr/>
            <p:nvPr/>
          </p:nvGrpSpPr>
          <p:grpSpPr>
            <a:xfrm>
              <a:off x="528991" y="977810"/>
              <a:ext cx="2624765" cy="3478758"/>
              <a:chOff x="528991" y="977810"/>
              <a:chExt cx="2624765" cy="3478758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4ECD5764-B2E4-3D06-B879-E9116BD92BCD}"/>
                  </a:ext>
                </a:extLst>
              </p:cNvPr>
              <p:cNvGrpSpPr/>
              <p:nvPr/>
            </p:nvGrpSpPr>
            <p:grpSpPr>
              <a:xfrm>
                <a:off x="528991" y="977810"/>
                <a:ext cx="2624765" cy="1763621"/>
                <a:chOff x="764498" y="719529"/>
                <a:chExt cx="5021705" cy="3374163"/>
              </a:xfrm>
            </p:grpSpPr>
            <p:pic>
              <p:nvPicPr>
                <p:cNvPr id="21" name="Picture 20">
                  <a:extLst>
                    <a:ext uri="{FF2B5EF4-FFF2-40B4-BE49-F238E27FC236}">
                      <a16:creationId xmlns:a16="http://schemas.microsoft.com/office/drawing/2014/main" id="{D6C17D64-29B2-29C5-C88E-E76B40DF2F4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screen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harpenSoften amount="20000"/>
                          </a14:imgEffect>
                          <a14:imgEffect>
                            <a14:brightnessContrast bright="8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764498" y="719529"/>
                  <a:ext cx="5021705" cy="3374163"/>
                </a:xfrm>
                <a:prstGeom prst="rect">
                  <a:avLst/>
                </a:prstGeom>
              </p:spPr>
            </p:pic>
            <p:sp>
              <p:nvSpPr>
                <p:cNvPr id="25" name="Freeform 24">
                  <a:extLst>
                    <a:ext uri="{FF2B5EF4-FFF2-40B4-BE49-F238E27FC236}">
                      <a16:creationId xmlns:a16="http://schemas.microsoft.com/office/drawing/2014/main" id="{0F8AED30-6D46-1366-63D2-C1C498309326}"/>
                    </a:ext>
                  </a:extLst>
                </p:cNvPr>
                <p:cNvSpPr/>
                <p:nvPr/>
              </p:nvSpPr>
              <p:spPr>
                <a:xfrm>
                  <a:off x="2934548" y="1357162"/>
                  <a:ext cx="512457" cy="442762"/>
                </a:xfrm>
                <a:custGeom>
                  <a:avLst/>
                  <a:gdLst>
                    <a:gd name="connsiteX0" fmla="*/ 501671 w 512457"/>
                    <a:gd name="connsiteY0" fmla="*/ 77002 h 442762"/>
                    <a:gd name="connsiteX1" fmla="*/ 501671 w 512457"/>
                    <a:gd name="connsiteY1" fmla="*/ 77002 h 442762"/>
                    <a:gd name="connsiteX2" fmla="*/ 482420 w 512457"/>
                    <a:gd name="connsiteY2" fmla="*/ 163630 h 442762"/>
                    <a:gd name="connsiteX3" fmla="*/ 472795 w 512457"/>
                    <a:gd name="connsiteY3" fmla="*/ 192505 h 442762"/>
                    <a:gd name="connsiteX4" fmla="*/ 453545 w 512457"/>
                    <a:gd name="connsiteY4" fmla="*/ 221381 h 442762"/>
                    <a:gd name="connsiteX5" fmla="*/ 424669 w 512457"/>
                    <a:gd name="connsiteY5" fmla="*/ 279133 h 442762"/>
                    <a:gd name="connsiteX6" fmla="*/ 395793 w 512457"/>
                    <a:gd name="connsiteY6" fmla="*/ 288758 h 442762"/>
                    <a:gd name="connsiteX7" fmla="*/ 338041 w 512457"/>
                    <a:gd name="connsiteY7" fmla="*/ 327259 h 442762"/>
                    <a:gd name="connsiteX8" fmla="*/ 318791 w 512457"/>
                    <a:gd name="connsiteY8" fmla="*/ 356135 h 442762"/>
                    <a:gd name="connsiteX9" fmla="*/ 261039 w 512457"/>
                    <a:gd name="connsiteY9" fmla="*/ 375385 h 442762"/>
                    <a:gd name="connsiteX10" fmla="*/ 203288 w 512457"/>
                    <a:gd name="connsiteY10" fmla="*/ 394636 h 442762"/>
                    <a:gd name="connsiteX11" fmla="*/ 174412 w 512457"/>
                    <a:gd name="connsiteY11" fmla="*/ 404261 h 442762"/>
                    <a:gd name="connsiteX12" fmla="*/ 145536 w 512457"/>
                    <a:gd name="connsiteY12" fmla="*/ 423512 h 442762"/>
                    <a:gd name="connsiteX13" fmla="*/ 87785 w 512457"/>
                    <a:gd name="connsiteY13" fmla="*/ 442762 h 442762"/>
                    <a:gd name="connsiteX14" fmla="*/ 1157 w 512457"/>
                    <a:gd name="connsiteY14" fmla="*/ 413886 h 442762"/>
                    <a:gd name="connsiteX15" fmla="*/ 30033 w 512457"/>
                    <a:gd name="connsiteY15" fmla="*/ 336884 h 442762"/>
                    <a:gd name="connsiteX16" fmla="*/ 58909 w 512457"/>
                    <a:gd name="connsiteY16" fmla="*/ 317634 h 442762"/>
                    <a:gd name="connsiteX17" fmla="*/ 68534 w 512457"/>
                    <a:gd name="connsiteY17" fmla="*/ 211756 h 442762"/>
                    <a:gd name="connsiteX18" fmla="*/ 49284 w 512457"/>
                    <a:gd name="connsiteY18" fmla="*/ 154004 h 442762"/>
                    <a:gd name="connsiteX19" fmla="*/ 78159 w 512457"/>
                    <a:gd name="connsiteY19" fmla="*/ 86627 h 442762"/>
                    <a:gd name="connsiteX20" fmla="*/ 107035 w 512457"/>
                    <a:gd name="connsiteY20" fmla="*/ 67377 h 442762"/>
                    <a:gd name="connsiteX21" fmla="*/ 126286 w 512457"/>
                    <a:gd name="connsiteY21" fmla="*/ 38501 h 442762"/>
                    <a:gd name="connsiteX22" fmla="*/ 184037 w 512457"/>
                    <a:gd name="connsiteY22" fmla="*/ 0 h 442762"/>
                    <a:gd name="connsiteX23" fmla="*/ 232164 w 512457"/>
                    <a:gd name="connsiteY23" fmla="*/ 9625 h 442762"/>
                    <a:gd name="connsiteX24" fmla="*/ 270665 w 512457"/>
                    <a:gd name="connsiteY24" fmla="*/ 173255 h 442762"/>
                    <a:gd name="connsiteX25" fmla="*/ 338041 w 512457"/>
                    <a:gd name="connsiteY25" fmla="*/ 134754 h 442762"/>
                    <a:gd name="connsiteX26" fmla="*/ 357292 w 512457"/>
                    <a:gd name="connsiteY26" fmla="*/ 77002 h 442762"/>
                    <a:gd name="connsiteX27" fmla="*/ 415044 w 512457"/>
                    <a:gd name="connsiteY27" fmla="*/ 57752 h 442762"/>
                    <a:gd name="connsiteX28" fmla="*/ 443919 w 512457"/>
                    <a:gd name="connsiteY28" fmla="*/ 48126 h 442762"/>
                    <a:gd name="connsiteX29" fmla="*/ 511296 w 512457"/>
                    <a:gd name="connsiteY29" fmla="*/ 77002 h 442762"/>
                    <a:gd name="connsiteX30" fmla="*/ 501671 w 512457"/>
                    <a:gd name="connsiteY30" fmla="*/ 77002 h 44276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</a:cxnLst>
                  <a:rect l="l" t="t" r="r" b="b"/>
                  <a:pathLst>
                    <a:path w="512457" h="442762">
                      <a:moveTo>
                        <a:pt x="501671" y="77002"/>
                      </a:moveTo>
                      <a:lnTo>
                        <a:pt x="501671" y="77002"/>
                      </a:lnTo>
                      <a:cubicBezTo>
                        <a:pt x="495254" y="105878"/>
                        <a:pt x="489594" y="134933"/>
                        <a:pt x="482420" y="163630"/>
                      </a:cubicBezTo>
                      <a:cubicBezTo>
                        <a:pt x="479959" y="173473"/>
                        <a:pt x="477332" y="183430"/>
                        <a:pt x="472795" y="192505"/>
                      </a:cubicBezTo>
                      <a:cubicBezTo>
                        <a:pt x="467622" y="202852"/>
                        <a:pt x="458718" y="211034"/>
                        <a:pt x="453545" y="221381"/>
                      </a:cubicBezTo>
                      <a:cubicBezTo>
                        <a:pt x="441922" y="244628"/>
                        <a:pt x="447653" y="260746"/>
                        <a:pt x="424669" y="279133"/>
                      </a:cubicBezTo>
                      <a:cubicBezTo>
                        <a:pt x="416746" y="285471"/>
                        <a:pt x="405418" y="285550"/>
                        <a:pt x="395793" y="288758"/>
                      </a:cubicBezTo>
                      <a:cubicBezTo>
                        <a:pt x="376542" y="301592"/>
                        <a:pt x="350874" y="308008"/>
                        <a:pt x="338041" y="327259"/>
                      </a:cubicBezTo>
                      <a:cubicBezTo>
                        <a:pt x="331624" y="336884"/>
                        <a:pt x="328601" y="350004"/>
                        <a:pt x="318791" y="356135"/>
                      </a:cubicBezTo>
                      <a:cubicBezTo>
                        <a:pt x="301583" y="366890"/>
                        <a:pt x="280290" y="368968"/>
                        <a:pt x="261039" y="375385"/>
                      </a:cubicBezTo>
                      <a:lnTo>
                        <a:pt x="203288" y="394636"/>
                      </a:lnTo>
                      <a:lnTo>
                        <a:pt x="174412" y="404261"/>
                      </a:lnTo>
                      <a:cubicBezTo>
                        <a:pt x="164787" y="410678"/>
                        <a:pt x="156107" y="418814"/>
                        <a:pt x="145536" y="423512"/>
                      </a:cubicBezTo>
                      <a:cubicBezTo>
                        <a:pt x="126993" y="431753"/>
                        <a:pt x="87785" y="442762"/>
                        <a:pt x="87785" y="442762"/>
                      </a:cubicBezTo>
                      <a:cubicBezTo>
                        <a:pt x="83316" y="442017"/>
                        <a:pt x="7924" y="437572"/>
                        <a:pt x="1157" y="413886"/>
                      </a:cubicBezTo>
                      <a:cubicBezTo>
                        <a:pt x="-4964" y="392463"/>
                        <a:pt x="14447" y="352470"/>
                        <a:pt x="30033" y="336884"/>
                      </a:cubicBezTo>
                      <a:cubicBezTo>
                        <a:pt x="38213" y="328704"/>
                        <a:pt x="49284" y="324051"/>
                        <a:pt x="58909" y="317634"/>
                      </a:cubicBezTo>
                      <a:cubicBezTo>
                        <a:pt x="79957" y="254487"/>
                        <a:pt x="84859" y="271617"/>
                        <a:pt x="68534" y="211756"/>
                      </a:cubicBezTo>
                      <a:cubicBezTo>
                        <a:pt x="63195" y="192179"/>
                        <a:pt x="49284" y="154004"/>
                        <a:pt x="49284" y="154004"/>
                      </a:cubicBezTo>
                      <a:cubicBezTo>
                        <a:pt x="56647" y="124552"/>
                        <a:pt x="56003" y="108783"/>
                        <a:pt x="78159" y="86627"/>
                      </a:cubicBezTo>
                      <a:cubicBezTo>
                        <a:pt x="86339" y="78447"/>
                        <a:pt x="97410" y="73794"/>
                        <a:pt x="107035" y="67377"/>
                      </a:cubicBezTo>
                      <a:cubicBezTo>
                        <a:pt x="113452" y="57752"/>
                        <a:pt x="117580" y="46119"/>
                        <a:pt x="126286" y="38501"/>
                      </a:cubicBezTo>
                      <a:cubicBezTo>
                        <a:pt x="143698" y="23266"/>
                        <a:pt x="184037" y="0"/>
                        <a:pt x="184037" y="0"/>
                      </a:cubicBezTo>
                      <a:cubicBezTo>
                        <a:pt x="200079" y="3208"/>
                        <a:pt x="226420" y="-5693"/>
                        <a:pt x="232164" y="9625"/>
                      </a:cubicBezTo>
                      <a:cubicBezTo>
                        <a:pt x="306661" y="208283"/>
                        <a:pt x="186282" y="116999"/>
                        <a:pt x="270665" y="173255"/>
                      </a:cubicBezTo>
                      <a:cubicBezTo>
                        <a:pt x="315480" y="164292"/>
                        <a:pt x="320079" y="175170"/>
                        <a:pt x="338041" y="134754"/>
                      </a:cubicBezTo>
                      <a:cubicBezTo>
                        <a:pt x="346282" y="116211"/>
                        <a:pt x="338041" y="83419"/>
                        <a:pt x="357292" y="77002"/>
                      </a:cubicBezTo>
                      <a:lnTo>
                        <a:pt x="415044" y="57752"/>
                      </a:lnTo>
                      <a:lnTo>
                        <a:pt x="443919" y="48126"/>
                      </a:lnTo>
                      <a:cubicBezTo>
                        <a:pt x="473370" y="55489"/>
                        <a:pt x="489140" y="54846"/>
                        <a:pt x="511296" y="77002"/>
                      </a:cubicBezTo>
                      <a:cubicBezTo>
                        <a:pt x="516369" y="82075"/>
                        <a:pt x="503275" y="77002"/>
                        <a:pt x="501671" y="77002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9" name="Freeform 28">
                  <a:extLst>
                    <a:ext uri="{FF2B5EF4-FFF2-40B4-BE49-F238E27FC236}">
                      <a16:creationId xmlns:a16="http://schemas.microsoft.com/office/drawing/2014/main" id="{1A41C6DE-C9DF-68DE-3050-C6016F88247C}"/>
                    </a:ext>
                  </a:extLst>
                </p:cNvPr>
                <p:cNvSpPr/>
                <p:nvPr/>
              </p:nvSpPr>
              <p:spPr>
                <a:xfrm>
                  <a:off x="2319688" y="1540042"/>
                  <a:ext cx="474662" cy="442762"/>
                </a:xfrm>
                <a:custGeom>
                  <a:avLst/>
                  <a:gdLst>
                    <a:gd name="connsiteX0" fmla="*/ 288758 w 474662"/>
                    <a:gd name="connsiteY0" fmla="*/ 0 h 442762"/>
                    <a:gd name="connsiteX1" fmla="*/ 288758 w 474662"/>
                    <a:gd name="connsiteY1" fmla="*/ 0 h 442762"/>
                    <a:gd name="connsiteX2" fmla="*/ 394636 w 474662"/>
                    <a:gd name="connsiteY2" fmla="*/ 57752 h 442762"/>
                    <a:gd name="connsiteX3" fmla="*/ 442763 w 474662"/>
                    <a:gd name="connsiteY3" fmla="*/ 96253 h 442762"/>
                    <a:gd name="connsiteX4" fmla="*/ 462013 w 474662"/>
                    <a:gd name="connsiteY4" fmla="*/ 125129 h 442762"/>
                    <a:gd name="connsiteX5" fmla="*/ 462013 w 474662"/>
                    <a:gd name="connsiteY5" fmla="*/ 288758 h 442762"/>
                    <a:gd name="connsiteX6" fmla="*/ 442763 w 474662"/>
                    <a:gd name="connsiteY6" fmla="*/ 346510 h 442762"/>
                    <a:gd name="connsiteX7" fmla="*/ 433137 w 474662"/>
                    <a:gd name="connsiteY7" fmla="*/ 375385 h 442762"/>
                    <a:gd name="connsiteX8" fmla="*/ 317634 w 474662"/>
                    <a:gd name="connsiteY8" fmla="*/ 433137 h 442762"/>
                    <a:gd name="connsiteX9" fmla="*/ 288758 w 474662"/>
                    <a:gd name="connsiteY9" fmla="*/ 442762 h 442762"/>
                    <a:gd name="connsiteX10" fmla="*/ 250257 w 474662"/>
                    <a:gd name="connsiteY10" fmla="*/ 375385 h 442762"/>
                    <a:gd name="connsiteX11" fmla="*/ 163630 w 474662"/>
                    <a:gd name="connsiteY11" fmla="*/ 336884 h 442762"/>
                    <a:gd name="connsiteX12" fmla="*/ 105878 w 474662"/>
                    <a:gd name="connsiteY12" fmla="*/ 317634 h 442762"/>
                    <a:gd name="connsiteX13" fmla="*/ 77003 w 474662"/>
                    <a:gd name="connsiteY13" fmla="*/ 308009 h 442762"/>
                    <a:gd name="connsiteX14" fmla="*/ 19251 w 474662"/>
                    <a:gd name="connsiteY14" fmla="*/ 298383 h 442762"/>
                    <a:gd name="connsiteX15" fmla="*/ 0 w 474662"/>
                    <a:gd name="connsiteY15" fmla="*/ 269507 h 442762"/>
                    <a:gd name="connsiteX16" fmla="*/ 48127 w 474662"/>
                    <a:gd name="connsiteY16" fmla="*/ 231006 h 442762"/>
                    <a:gd name="connsiteX17" fmla="*/ 77003 w 474662"/>
                    <a:gd name="connsiteY17" fmla="*/ 211756 h 442762"/>
                    <a:gd name="connsiteX18" fmla="*/ 96253 w 474662"/>
                    <a:gd name="connsiteY18" fmla="*/ 144379 h 442762"/>
                    <a:gd name="connsiteX19" fmla="*/ 105878 w 474662"/>
                    <a:gd name="connsiteY19" fmla="*/ 115503 h 442762"/>
                    <a:gd name="connsiteX20" fmla="*/ 144379 w 474662"/>
                    <a:gd name="connsiteY20" fmla="*/ 57752 h 442762"/>
                    <a:gd name="connsiteX21" fmla="*/ 202131 w 474662"/>
                    <a:gd name="connsiteY21" fmla="*/ 67377 h 442762"/>
                    <a:gd name="connsiteX22" fmla="*/ 221381 w 474662"/>
                    <a:gd name="connsiteY22" fmla="*/ 38501 h 442762"/>
                    <a:gd name="connsiteX23" fmla="*/ 279133 w 474662"/>
                    <a:gd name="connsiteY23" fmla="*/ 9625 h 442762"/>
                    <a:gd name="connsiteX24" fmla="*/ 288758 w 474662"/>
                    <a:gd name="connsiteY24" fmla="*/ 0 h 44276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</a:cxnLst>
                  <a:rect l="l" t="t" r="r" b="b"/>
                  <a:pathLst>
                    <a:path w="474662" h="442762">
                      <a:moveTo>
                        <a:pt x="288758" y="0"/>
                      </a:moveTo>
                      <a:lnTo>
                        <a:pt x="288758" y="0"/>
                      </a:lnTo>
                      <a:cubicBezTo>
                        <a:pt x="288870" y="56"/>
                        <a:pt x="377050" y="40166"/>
                        <a:pt x="394636" y="57752"/>
                      </a:cubicBezTo>
                      <a:cubicBezTo>
                        <a:pt x="438174" y="101289"/>
                        <a:pt x="386548" y="77513"/>
                        <a:pt x="442763" y="96253"/>
                      </a:cubicBezTo>
                      <a:cubicBezTo>
                        <a:pt x="449180" y="105878"/>
                        <a:pt x="456840" y="114782"/>
                        <a:pt x="462013" y="125129"/>
                      </a:cubicBezTo>
                      <a:cubicBezTo>
                        <a:pt x="486659" y="174423"/>
                        <a:pt x="468895" y="242878"/>
                        <a:pt x="462013" y="288758"/>
                      </a:cubicBezTo>
                      <a:cubicBezTo>
                        <a:pt x="459003" y="308825"/>
                        <a:pt x="449180" y="327259"/>
                        <a:pt x="442763" y="346510"/>
                      </a:cubicBezTo>
                      <a:cubicBezTo>
                        <a:pt x="439555" y="356135"/>
                        <a:pt x="441579" y="369757"/>
                        <a:pt x="433137" y="375385"/>
                      </a:cubicBezTo>
                      <a:cubicBezTo>
                        <a:pt x="358504" y="425141"/>
                        <a:pt x="397333" y="406571"/>
                        <a:pt x="317634" y="433137"/>
                      </a:cubicBezTo>
                      <a:lnTo>
                        <a:pt x="288758" y="442762"/>
                      </a:lnTo>
                      <a:cubicBezTo>
                        <a:pt x="227278" y="422269"/>
                        <a:pt x="288655" y="452179"/>
                        <a:pt x="250257" y="375385"/>
                      </a:cubicBezTo>
                      <a:cubicBezTo>
                        <a:pt x="241106" y="357083"/>
                        <a:pt x="168140" y="338387"/>
                        <a:pt x="163630" y="336884"/>
                      </a:cubicBezTo>
                      <a:lnTo>
                        <a:pt x="105878" y="317634"/>
                      </a:lnTo>
                      <a:cubicBezTo>
                        <a:pt x="96253" y="314426"/>
                        <a:pt x="87011" y="309677"/>
                        <a:pt x="77003" y="308009"/>
                      </a:cubicBezTo>
                      <a:lnTo>
                        <a:pt x="19251" y="298383"/>
                      </a:lnTo>
                      <a:cubicBezTo>
                        <a:pt x="12834" y="288758"/>
                        <a:pt x="0" y="281075"/>
                        <a:pt x="0" y="269507"/>
                      </a:cubicBezTo>
                      <a:cubicBezTo>
                        <a:pt x="0" y="237058"/>
                        <a:pt x="30098" y="240021"/>
                        <a:pt x="48127" y="231006"/>
                      </a:cubicBezTo>
                      <a:cubicBezTo>
                        <a:pt x="58474" y="225833"/>
                        <a:pt x="67378" y="218173"/>
                        <a:pt x="77003" y="211756"/>
                      </a:cubicBezTo>
                      <a:cubicBezTo>
                        <a:pt x="100080" y="142521"/>
                        <a:pt x="72082" y="228981"/>
                        <a:pt x="96253" y="144379"/>
                      </a:cubicBezTo>
                      <a:cubicBezTo>
                        <a:pt x="99040" y="134623"/>
                        <a:pt x="100951" y="124372"/>
                        <a:pt x="105878" y="115503"/>
                      </a:cubicBezTo>
                      <a:cubicBezTo>
                        <a:pt x="117114" y="95278"/>
                        <a:pt x="144379" y="57752"/>
                        <a:pt x="144379" y="57752"/>
                      </a:cubicBezTo>
                      <a:cubicBezTo>
                        <a:pt x="163630" y="60960"/>
                        <a:pt x="183198" y="72110"/>
                        <a:pt x="202131" y="67377"/>
                      </a:cubicBezTo>
                      <a:cubicBezTo>
                        <a:pt x="213354" y="64571"/>
                        <a:pt x="213201" y="46681"/>
                        <a:pt x="221381" y="38501"/>
                      </a:cubicBezTo>
                      <a:cubicBezTo>
                        <a:pt x="234683" y="25199"/>
                        <a:pt x="260347" y="12756"/>
                        <a:pt x="279133" y="9625"/>
                      </a:cubicBezTo>
                      <a:cubicBezTo>
                        <a:pt x="288627" y="8042"/>
                        <a:pt x="287154" y="1604"/>
                        <a:pt x="288758" y="0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0" name="Freeform 29">
                  <a:extLst>
                    <a:ext uri="{FF2B5EF4-FFF2-40B4-BE49-F238E27FC236}">
                      <a16:creationId xmlns:a16="http://schemas.microsoft.com/office/drawing/2014/main" id="{216C9EC3-A440-96AD-07E1-5974E944B293}"/>
                    </a:ext>
                  </a:extLst>
                </p:cNvPr>
                <p:cNvSpPr/>
                <p:nvPr/>
              </p:nvSpPr>
              <p:spPr>
                <a:xfrm>
                  <a:off x="1463040" y="2040556"/>
                  <a:ext cx="221381" cy="298383"/>
                </a:xfrm>
                <a:custGeom>
                  <a:avLst/>
                  <a:gdLst>
                    <a:gd name="connsiteX0" fmla="*/ 221381 w 221381"/>
                    <a:gd name="connsiteY0" fmla="*/ 202130 h 298383"/>
                    <a:gd name="connsiteX1" fmla="*/ 221381 w 221381"/>
                    <a:gd name="connsiteY1" fmla="*/ 202130 h 298383"/>
                    <a:gd name="connsiteX2" fmla="*/ 115503 w 221381"/>
                    <a:gd name="connsiteY2" fmla="*/ 163629 h 298383"/>
                    <a:gd name="connsiteX3" fmla="*/ 105878 w 221381"/>
                    <a:gd name="connsiteY3" fmla="*/ 134753 h 298383"/>
                    <a:gd name="connsiteX4" fmla="*/ 134754 w 221381"/>
                    <a:gd name="connsiteY4" fmla="*/ 115503 h 298383"/>
                    <a:gd name="connsiteX5" fmla="*/ 163629 w 221381"/>
                    <a:gd name="connsiteY5" fmla="*/ 105878 h 298383"/>
                    <a:gd name="connsiteX6" fmla="*/ 173255 w 221381"/>
                    <a:gd name="connsiteY6" fmla="*/ 77002 h 298383"/>
                    <a:gd name="connsiteX7" fmla="*/ 144379 w 221381"/>
                    <a:gd name="connsiteY7" fmla="*/ 19250 h 298383"/>
                    <a:gd name="connsiteX8" fmla="*/ 86627 w 221381"/>
                    <a:gd name="connsiteY8" fmla="*/ 0 h 298383"/>
                    <a:gd name="connsiteX9" fmla="*/ 28876 w 221381"/>
                    <a:gd name="connsiteY9" fmla="*/ 9625 h 298383"/>
                    <a:gd name="connsiteX10" fmla="*/ 0 w 221381"/>
                    <a:gd name="connsiteY10" fmla="*/ 67377 h 298383"/>
                    <a:gd name="connsiteX11" fmla="*/ 28876 w 221381"/>
                    <a:gd name="connsiteY11" fmla="*/ 134753 h 298383"/>
                    <a:gd name="connsiteX12" fmla="*/ 57752 w 221381"/>
                    <a:gd name="connsiteY12" fmla="*/ 144379 h 298383"/>
                    <a:gd name="connsiteX13" fmla="*/ 57752 w 221381"/>
                    <a:gd name="connsiteY13" fmla="*/ 202130 h 298383"/>
                    <a:gd name="connsiteX14" fmla="*/ 28876 w 221381"/>
                    <a:gd name="connsiteY14" fmla="*/ 211756 h 298383"/>
                    <a:gd name="connsiteX15" fmla="*/ 38501 w 221381"/>
                    <a:gd name="connsiteY15" fmla="*/ 250257 h 298383"/>
                    <a:gd name="connsiteX16" fmla="*/ 48126 w 221381"/>
                    <a:gd name="connsiteY16" fmla="*/ 279132 h 298383"/>
                    <a:gd name="connsiteX17" fmla="*/ 105878 w 221381"/>
                    <a:gd name="connsiteY17" fmla="*/ 298383 h 298383"/>
                    <a:gd name="connsiteX18" fmla="*/ 154004 w 221381"/>
                    <a:gd name="connsiteY18" fmla="*/ 288758 h 298383"/>
                    <a:gd name="connsiteX19" fmla="*/ 221381 w 221381"/>
                    <a:gd name="connsiteY19" fmla="*/ 202130 h 29838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</a:cxnLst>
                  <a:rect l="l" t="t" r="r" b="b"/>
                  <a:pathLst>
                    <a:path w="221381" h="298383">
                      <a:moveTo>
                        <a:pt x="221381" y="202130"/>
                      </a:moveTo>
                      <a:lnTo>
                        <a:pt x="221381" y="202130"/>
                      </a:lnTo>
                      <a:cubicBezTo>
                        <a:pt x="146770" y="193840"/>
                        <a:pt x="141508" y="215638"/>
                        <a:pt x="115503" y="163629"/>
                      </a:cubicBezTo>
                      <a:cubicBezTo>
                        <a:pt x="110966" y="154554"/>
                        <a:pt x="109086" y="144378"/>
                        <a:pt x="105878" y="134753"/>
                      </a:cubicBezTo>
                      <a:cubicBezTo>
                        <a:pt x="115503" y="128336"/>
                        <a:pt x="124407" y="120676"/>
                        <a:pt x="134754" y="115503"/>
                      </a:cubicBezTo>
                      <a:cubicBezTo>
                        <a:pt x="143829" y="110966"/>
                        <a:pt x="156455" y="113052"/>
                        <a:pt x="163629" y="105878"/>
                      </a:cubicBezTo>
                      <a:cubicBezTo>
                        <a:pt x="170803" y="98704"/>
                        <a:pt x="170046" y="86627"/>
                        <a:pt x="173255" y="77002"/>
                      </a:cubicBezTo>
                      <a:cubicBezTo>
                        <a:pt x="168011" y="61270"/>
                        <a:pt x="160090" y="29069"/>
                        <a:pt x="144379" y="19250"/>
                      </a:cubicBezTo>
                      <a:cubicBezTo>
                        <a:pt x="127171" y="8495"/>
                        <a:pt x="86627" y="0"/>
                        <a:pt x="86627" y="0"/>
                      </a:cubicBezTo>
                      <a:cubicBezTo>
                        <a:pt x="67377" y="3208"/>
                        <a:pt x="46332" y="897"/>
                        <a:pt x="28876" y="9625"/>
                      </a:cubicBezTo>
                      <a:cubicBezTo>
                        <a:pt x="13948" y="17089"/>
                        <a:pt x="4556" y="53710"/>
                        <a:pt x="0" y="67377"/>
                      </a:cubicBezTo>
                      <a:cubicBezTo>
                        <a:pt x="5780" y="90498"/>
                        <a:pt x="8102" y="118134"/>
                        <a:pt x="28876" y="134753"/>
                      </a:cubicBezTo>
                      <a:cubicBezTo>
                        <a:pt x="36799" y="141091"/>
                        <a:pt x="48127" y="141170"/>
                        <a:pt x="57752" y="144379"/>
                      </a:cubicBezTo>
                      <a:cubicBezTo>
                        <a:pt x="64168" y="163629"/>
                        <a:pt x="77002" y="182880"/>
                        <a:pt x="57752" y="202130"/>
                      </a:cubicBezTo>
                      <a:cubicBezTo>
                        <a:pt x="50578" y="209304"/>
                        <a:pt x="38501" y="208547"/>
                        <a:pt x="28876" y="211756"/>
                      </a:cubicBezTo>
                      <a:cubicBezTo>
                        <a:pt x="32084" y="224590"/>
                        <a:pt x="34867" y="237537"/>
                        <a:pt x="38501" y="250257"/>
                      </a:cubicBezTo>
                      <a:cubicBezTo>
                        <a:pt x="41288" y="260012"/>
                        <a:pt x="39870" y="273235"/>
                        <a:pt x="48126" y="279132"/>
                      </a:cubicBezTo>
                      <a:cubicBezTo>
                        <a:pt x="64638" y="290926"/>
                        <a:pt x="105878" y="298383"/>
                        <a:pt x="105878" y="298383"/>
                      </a:cubicBezTo>
                      <a:cubicBezTo>
                        <a:pt x="121920" y="295175"/>
                        <a:pt x="141090" y="298802"/>
                        <a:pt x="154004" y="288758"/>
                      </a:cubicBezTo>
                      <a:cubicBezTo>
                        <a:pt x="231689" y="228336"/>
                        <a:pt x="210152" y="216568"/>
                        <a:pt x="221381" y="202130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1" name="Freeform 30">
                  <a:extLst>
                    <a:ext uri="{FF2B5EF4-FFF2-40B4-BE49-F238E27FC236}">
                      <a16:creationId xmlns:a16="http://schemas.microsoft.com/office/drawing/2014/main" id="{6F115FF6-EDDE-CD4B-2770-A3D5CB475FFF}"/>
                    </a:ext>
                  </a:extLst>
                </p:cNvPr>
                <p:cNvSpPr/>
                <p:nvPr/>
              </p:nvSpPr>
              <p:spPr>
                <a:xfrm>
                  <a:off x="1347537" y="2791137"/>
                  <a:ext cx="233795" cy="462202"/>
                </a:xfrm>
                <a:custGeom>
                  <a:avLst/>
                  <a:gdLst>
                    <a:gd name="connsiteX0" fmla="*/ 19250 w 233795"/>
                    <a:gd name="connsiteY0" fmla="*/ 279322 h 462202"/>
                    <a:gd name="connsiteX1" fmla="*/ 19250 w 233795"/>
                    <a:gd name="connsiteY1" fmla="*/ 279322 h 462202"/>
                    <a:gd name="connsiteX2" fmla="*/ 9625 w 233795"/>
                    <a:gd name="connsiteY2" fmla="*/ 192695 h 462202"/>
                    <a:gd name="connsiteX3" fmla="*/ 0 w 233795"/>
                    <a:gd name="connsiteY3" fmla="*/ 154194 h 462202"/>
                    <a:gd name="connsiteX4" fmla="*/ 9625 w 233795"/>
                    <a:gd name="connsiteY4" fmla="*/ 106067 h 462202"/>
                    <a:gd name="connsiteX5" fmla="*/ 19250 w 233795"/>
                    <a:gd name="connsiteY5" fmla="*/ 77191 h 462202"/>
                    <a:gd name="connsiteX6" fmla="*/ 77002 w 233795"/>
                    <a:gd name="connsiteY6" fmla="*/ 57941 h 462202"/>
                    <a:gd name="connsiteX7" fmla="*/ 163629 w 233795"/>
                    <a:gd name="connsiteY7" fmla="*/ 9815 h 462202"/>
                    <a:gd name="connsiteX8" fmla="*/ 182880 w 233795"/>
                    <a:gd name="connsiteY8" fmla="*/ 38690 h 462202"/>
                    <a:gd name="connsiteX9" fmla="*/ 211756 w 233795"/>
                    <a:gd name="connsiteY9" fmla="*/ 96442 h 462202"/>
                    <a:gd name="connsiteX10" fmla="*/ 221381 w 233795"/>
                    <a:gd name="connsiteY10" fmla="*/ 125318 h 462202"/>
                    <a:gd name="connsiteX11" fmla="*/ 221381 w 233795"/>
                    <a:gd name="connsiteY11" fmla="*/ 365949 h 462202"/>
                    <a:gd name="connsiteX12" fmla="*/ 202130 w 233795"/>
                    <a:gd name="connsiteY12" fmla="*/ 462202 h 462202"/>
                    <a:gd name="connsiteX13" fmla="*/ 134754 w 233795"/>
                    <a:gd name="connsiteY13" fmla="*/ 452577 h 462202"/>
                    <a:gd name="connsiteX14" fmla="*/ 67377 w 233795"/>
                    <a:gd name="connsiteY14" fmla="*/ 375575 h 462202"/>
                    <a:gd name="connsiteX15" fmla="*/ 48126 w 233795"/>
                    <a:gd name="connsiteY15" fmla="*/ 317823 h 462202"/>
                    <a:gd name="connsiteX16" fmla="*/ 19250 w 233795"/>
                    <a:gd name="connsiteY16" fmla="*/ 279322 h 46220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</a:cxnLst>
                  <a:rect l="l" t="t" r="r" b="b"/>
                  <a:pathLst>
                    <a:path w="233795" h="462202">
                      <a:moveTo>
                        <a:pt x="19250" y="279322"/>
                      </a:moveTo>
                      <a:lnTo>
                        <a:pt x="19250" y="279322"/>
                      </a:lnTo>
                      <a:cubicBezTo>
                        <a:pt x="16042" y="250446"/>
                        <a:pt x="14043" y="221411"/>
                        <a:pt x="9625" y="192695"/>
                      </a:cubicBezTo>
                      <a:cubicBezTo>
                        <a:pt x="7614" y="179620"/>
                        <a:pt x="0" y="167423"/>
                        <a:pt x="0" y="154194"/>
                      </a:cubicBezTo>
                      <a:cubicBezTo>
                        <a:pt x="0" y="137834"/>
                        <a:pt x="5657" y="121939"/>
                        <a:pt x="9625" y="106067"/>
                      </a:cubicBezTo>
                      <a:cubicBezTo>
                        <a:pt x="12086" y="96224"/>
                        <a:pt x="10994" y="83088"/>
                        <a:pt x="19250" y="77191"/>
                      </a:cubicBezTo>
                      <a:cubicBezTo>
                        <a:pt x="35762" y="65397"/>
                        <a:pt x="77002" y="57941"/>
                        <a:pt x="77002" y="57941"/>
                      </a:cubicBezTo>
                      <a:cubicBezTo>
                        <a:pt x="124578" y="-13423"/>
                        <a:pt x="92816" y="-4349"/>
                        <a:pt x="163629" y="9815"/>
                      </a:cubicBezTo>
                      <a:cubicBezTo>
                        <a:pt x="170046" y="19440"/>
                        <a:pt x="177707" y="28343"/>
                        <a:pt x="182880" y="38690"/>
                      </a:cubicBezTo>
                      <a:cubicBezTo>
                        <a:pt x="222733" y="118395"/>
                        <a:pt x="156582" y="13682"/>
                        <a:pt x="211756" y="96442"/>
                      </a:cubicBezTo>
                      <a:cubicBezTo>
                        <a:pt x="214964" y="106067"/>
                        <a:pt x="218920" y="115475"/>
                        <a:pt x="221381" y="125318"/>
                      </a:cubicBezTo>
                      <a:cubicBezTo>
                        <a:pt x="243888" y="215350"/>
                        <a:pt x="230714" y="239951"/>
                        <a:pt x="221381" y="365949"/>
                      </a:cubicBezTo>
                      <a:cubicBezTo>
                        <a:pt x="217168" y="422832"/>
                        <a:pt x="215869" y="420988"/>
                        <a:pt x="202130" y="462202"/>
                      </a:cubicBezTo>
                      <a:cubicBezTo>
                        <a:pt x="179671" y="458994"/>
                        <a:pt x="156484" y="459096"/>
                        <a:pt x="134754" y="452577"/>
                      </a:cubicBezTo>
                      <a:cubicBezTo>
                        <a:pt x="105641" y="443843"/>
                        <a:pt x="74269" y="396251"/>
                        <a:pt x="67377" y="375575"/>
                      </a:cubicBezTo>
                      <a:cubicBezTo>
                        <a:pt x="60960" y="356324"/>
                        <a:pt x="59382" y="334707"/>
                        <a:pt x="48126" y="317823"/>
                      </a:cubicBezTo>
                      <a:cubicBezTo>
                        <a:pt x="6066" y="254732"/>
                        <a:pt x="24063" y="285739"/>
                        <a:pt x="19250" y="279322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2" name="Freeform 31">
                  <a:extLst>
                    <a:ext uri="{FF2B5EF4-FFF2-40B4-BE49-F238E27FC236}">
                      <a16:creationId xmlns:a16="http://schemas.microsoft.com/office/drawing/2014/main" id="{4C327B90-B94A-B679-67BC-2B6776B956FE}"/>
                    </a:ext>
                  </a:extLst>
                </p:cNvPr>
                <p:cNvSpPr/>
                <p:nvPr/>
              </p:nvSpPr>
              <p:spPr>
                <a:xfrm>
                  <a:off x="1626669" y="3291840"/>
                  <a:ext cx="357152" cy="424898"/>
                </a:xfrm>
                <a:custGeom>
                  <a:avLst/>
                  <a:gdLst>
                    <a:gd name="connsiteX0" fmla="*/ 57752 w 357152"/>
                    <a:gd name="connsiteY0" fmla="*/ 144379 h 424898"/>
                    <a:gd name="connsiteX1" fmla="*/ 57752 w 357152"/>
                    <a:gd name="connsiteY1" fmla="*/ 144379 h 424898"/>
                    <a:gd name="connsiteX2" fmla="*/ 105878 w 357152"/>
                    <a:gd name="connsiteY2" fmla="*/ 38501 h 424898"/>
                    <a:gd name="connsiteX3" fmla="*/ 163630 w 357152"/>
                    <a:gd name="connsiteY3" fmla="*/ 0 h 424898"/>
                    <a:gd name="connsiteX4" fmla="*/ 298384 w 357152"/>
                    <a:gd name="connsiteY4" fmla="*/ 28876 h 424898"/>
                    <a:gd name="connsiteX5" fmla="*/ 327259 w 357152"/>
                    <a:gd name="connsiteY5" fmla="*/ 38501 h 424898"/>
                    <a:gd name="connsiteX6" fmla="*/ 346510 w 357152"/>
                    <a:gd name="connsiteY6" fmla="*/ 67377 h 424898"/>
                    <a:gd name="connsiteX7" fmla="*/ 346510 w 357152"/>
                    <a:gd name="connsiteY7" fmla="*/ 163629 h 424898"/>
                    <a:gd name="connsiteX8" fmla="*/ 327259 w 357152"/>
                    <a:gd name="connsiteY8" fmla="*/ 192505 h 424898"/>
                    <a:gd name="connsiteX9" fmla="*/ 298384 w 357152"/>
                    <a:gd name="connsiteY9" fmla="*/ 202131 h 424898"/>
                    <a:gd name="connsiteX10" fmla="*/ 269508 w 357152"/>
                    <a:gd name="connsiteY10" fmla="*/ 221381 h 424898"/>
                    <a:gd name="connsiteX11" fmla="*/ 221382 w 357152"/>
                    <a:gd name="connsiteY11" fmla="*/ 308008 h 424898"/>
                    <a:gd name="connsiteX12" fmla="*/ 192506 w 357152"/>
                    <a:gd name="connsiteY12" fmla="*/ 327259 h 424898"/>
                    <a:gd name="connsiteX13" fmla="*/ 144379 w 357152"/>
                    <a:gd name="connsiteY13" fmla="*/ 375385 h 424898"/>
                    <a:gd name="connsiteX14" fmla="*/ 115504 w 357152"/>
                    <a:gd name="connsiteY14" fmla="*/ 385011 h 424898"/>
                    <a:gd name="connsiteX15" fmla="*/ 57752 w 357152"/>
                    <a:gd name="connsiteY15" fmla="*/ 423512 h 424898"/>
                    <a:gd name="connsiteX16" fmla="*/ 86628 w 357152"/>
                    <a:gd name="connsiteY16" fmla="*/ 404261 h 424898"/>
                    <a:gd name="connsiteX17" fmla="*/ 173255 w 357152"/>
                    <a:gd name="connsiteY17" fmla="*/ 327259 h 424898"/>
                    <a:gd name="connsiteX18" fmla="*/ 134754 w 357152"/>
                    <a:gd name="connsiteY18" fmla="*/ 231006 h 424898"/>
                    <a:gd name="connsiteX19" fmla="*/ 115504 w 357152"/>
                    <a:gd name="connsiteY19" fmla="*/ 202131 h 424898"/>
                    <a:gd name="connsiteX20" fmla="*/ 9626 w 357152"/>
                    <a:gd name="connsiteY20" fmla="*/ 202131 h 424898"/>
                    <a:gd name="connsiteX21" fmla="*/ 9626 w 357152"/>
                    <a:gd name="connsiteY21" fmla="*/ 202131 h 424898"/>
                    <a:gd name="connsiteX22" fmla="*/ 0 w 357152"/>
                    <a:gd name="connsiteY22" fmla="*/ 211756 h 42489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</a:cxnLst>
                  <a:rect l="l" t="t" r="r" b="b"/>
                  <a:pathLst>
                    <a:path w="357152" h="424898">
                      <a:moveTo>
                        <a:pt x="57752" y="144379"/>
                      </a:moveTo>
                      <a:lnTo>
                        <a:pt x="57752" y="144379"/>
                      </a:lnTo>
                      <a:cubicBezTo>
                        <a:pt x="62205" y="132504"/>
                        <a:pt x="83443" y="58132"/>
                        <a:pt x="105878" y="38501"/>
                      </a:cubicBezTo>
                      <a:cubicBezTo>
                        <a:pt x="123290" y="23266"/>
                        <a:pt x="163630" y="0"/>
                        <a:pt x="163630" y="0"/>
                      </a:cubicBezTo>
                      <a:cubicBezTo>
                        <a:pt x="260768" y="12142"/>
                        <a:pt x="216092" y="1445"/>
                        <a:pt x="298384" y="28876"/>
                      </a:cubicBezTo>
                      <a:lnTo>
                        <a:pt x="327259" y="38501"/>
                      </a:lnTo>
                      <a:cubicBezTo>
                        <a:pt x="333676" y="48126"/>
                        <a:pt x="341337" y="57030"/>
                        <a:pt x="346510" y="67377"/>
                      </a:cubicBezTo>
                      <a:cubicBezTo>
                        <a:pt x="363058" y="100474"/>
                        <a:pt x="358130" y="124896"/>
                        <a:pt x="346510" y="163629"/>
                      </a:cubicBezTo>
                      <a:cubicBezTo>
                        <a:pt x="343186" y="174709"/>
                        <a:pt x="336292" y="185278"/>
                        <a:pt x="327259" y="192505"/>
                      </a:cubicBezTo>
                      <a:cubicBezTo>
                        <a:pt x="319337" y="198843"/>
                        <a:pt x="307459" y="197594"/>
                        <a:pt x="298384" y="202131"/>
                      </a:cubicBezTo>
                      <a:cubicBezTo>
                        <a:pt x="288037" y="207304"/>
                        <a:pt x="279133" y="214964"/>
                        <a:pt x="269508" y="221381"/>
                      </a:cubicBezTo>
                      <a:cubicBezTo>
                        <a:pt x="259478" y="251472"/>
                        <a:pt x="249752" y="289095"/>
                        <a:pt x="221382" y="308008"/>
                      </a:cubicBezTo>
                      <a:lnTo>
                        <a:pt x="192506" y="327259"/>
                      </a:lnTo>
                      <a:cubicBezTo>
                        <a:pt x="173254" y="356136"/>
                        <a:pt x="176465" y="359342"/>
                        <a:pt x="144379" y="375385"/>
                      </a:cubicBezTo>
                      <a:cubicBezTo>
                        <a:pt x="135304" y="379922"/>
                        <a:pt x="124373" y="380084"/>
                        <a:pt x="115504" y="385011"/>
                      </a:cubicBezTo>
                      <a:cubicBezTo>
                        <a:pt x="95279" y="396247"/>
                        <a:pt x="77003" y="410679"/>
                        <a:pt x="57752" y="423512"/>
                      </a:cubicBezTo>
                      <a:cubicBezTo>
                        <a:pt x="48127" y="429929"/>
                        <a:pt x="78448" y="412441"/>
                        <a:pt x="86628" y="404261"/>
                      </a:cubicBezTo>
                      <a:cubicBezTo>
                        <a:pt x="152559" y="338329"/>
                        <a:pt x="121727" y="361610"/>
                        <a:pt x="173255" y="327259"/>
                      </a:cubicBezTo>
                      <a:cubicBezTo>
                        <a:pt x="156829" y="195849"/>
                        <a:pt x="187552" y="283804"/>
                        <a:pt x="134754" y="231006"/>
                      </a:cubicBezTo>
                      <a:cubicBezTo>
                        <a:pt x="126574" y="222826"/>
                        <a:pt x="126776" y="204732"/>
                        <a:pt x="115504" y="202131"/>
                      </a:cubicBezTo>
                      <a:cubicBezTo>
                        <a:pt x="81115" y="194195"/>
                        <a:pt x="44919" y="202131"/>
                        <a:pt x="9626" y="202131"/>
                      </a:cubicBezTo>
                      <a:lnTo>
                        <a:pt x="9626" y="202131"/>
                      </a:lnTo>
                      <a:lnTo>
                        <a:pt x="0" y="211756"/>
                      </a:lnTo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3" name="Freeform 32">
                  <a:extLst>
                    <a:ext uri="{FF2B5EF4-FFF2-40B4-BE49-F238E27FC236}">
                      <a16:creationId xmlns:a16="http://schemas.microsoft.com/office/drawing/2014/main" id="{889012BE-D4EB-9DD0-BAE8-D0BC6B25B395}"/>
                    </a:ext>
                  </a:extLst>
                </p:cNvPr>
                <p:cNvSpPr/>
                <p:nvPr/>
              </p:nvSpPr>
              <p:spPr>
                <a:xfrm>
                  <a:off x="3615328" y="3330341"/>
                  <a:ext cx="234777" cy="183569"/>
                </a:xfrm>
                <a:custGeom>
                  <a:avLst/>
                  <a:gdLst>
                    <a:gd name="connsiteX0" fmla="*/ 71148 w 234777"/>
                    <a:gd name="connsiteY0" fmla="*/ 0 h 183569"/>
                    <a:gd name="connsiteX1" fmla="*/ 71148 w 234777"/>
                    <a:gd name="connsiteY1" fmla="*/ 0 h 183569"/>
                    <a:gd name="connsiteX2" fmla="*/ 196276 w 234777"/>
                    <a:gd name="connsiteY2" fmla="*/ 9625 h 183569"/>
                    <a:gd name="connsiteX3" fmla="*/ 225152 w 234777"/>
                    <a:gd name="connsiteY3" fmla="*/ 19251 h 183569"/>
                    <a:gd name="connsiteX4" fmla="*/ 234777 w 234777"/>
                    <a:gd name="connsiteY4" fmla="*/ 48126 h 183569"/>
                    <a:gd name="connsiteX5" fmla="*/ 205901 w 234777"/>
                    <a:gd name="connsiteY5" fmla="*/ 144379 h 183569"/>
                    <a:gd name="connsiteX6" fmla="*/ 177026 w 234777"/>
                    <a:gd name="connsiteY6" fmla="*/ 154004 h 183569"/>
                    <a:gd name="connsiteX7" fmla="*/ 119274 w 234777"/>
                    <a:gd name="connsiteY7" fmla="*/ 182880 h 183569"/>
                    <a:gd name="connsiteX8" fmla="*/ 109649 w 234777"/>
                    <a:gd name="connsiteY8" fmla="*/ 154004 h 183569"/>
                    <a:gd name="connsiteX9" fmla="*/ 80773 w 234777"/>
                    <a:gd name="connsiteY9" fmla="*/ 134754 h 183569"/>
                    <a:gd name="connsiteX10" fmla="*/ 61523 w 234777"/>
                    <a:gd name="connsiteY10" fmla="*/ 105878 h 183569"/>
                    <a:gd name="connsiteX11" fmla="*/ 13396 w 234777"/>
                    <a:gd name="connsiteY11" fmla="*/ 96253 h 183569"/>
                    <a:gd name="connsiteX12" fmla="*/ 51897 w 234777"/>
                    <a:gd name="connsiteY12" fmla="*/ 28876 h 183569"/>
                    <a:gd name="connsiteX13" fmla="*/ 71148 w 234777"/>
                    <a:gd name="connsiteY13" fmla="*/ 0 h 18356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</a:cxnLst>
                  <a:rect l="l" t="t" r="r" b="b"/>
                  <a:pathLst>
                    <a:path w="234777" h="183569">
                      <a:moveTo>
                        <a:pt x="71148" y="0"/>
                      </a:moveTo>
                      <a:lnTo>
                        <a:pt x="71148" y="0"/>
                      </a:lnTo>
                      <a:cubicBezTo>
                        <a:pt x="112857" y="3208"/>
                        <a:pt x="154767" y="4436"/>
                        <a:pt x="196276" y="9625"/>
                      </a:cubicBezTo>
                      <a:cubicBezTo>
                        <a:pt x="206344" y="10883"/>
                        <a:pt x="217978" y="12077"/>
                        <a:pt x="225152" y="19251"/>
                      </a:cubicBezTo>
                      <a:cubicBezTo>
                        <a:pt x="232326" y="26425"/>
                        <a:pt x="231569" y="38501"/>
                        <a:pt x="234777" y="48126"/>
                      </a:cubicBezTo>
                      <a:cubicBezTo>
                        <a:pt x="230565" y="77614"/>
                        <a:pt x="234143" y="121786"/>
                        <a:pt x="205901" y="144379"/>
                      </a:cubicBezTo>
                      <a:cubicBezTo>
                        <a:pt x="197979" y="150717"/>
                        <a:pt x="186651" y="150796"/>
                        <a:pt x="177026" y="154004"/>
                      </a:cubicBezTo>
                      <a:cubicBezTo>
                        <a:pt x="172163" y="157246"/>
                        <a:pt x="130660" y="188573"/>
                        <a:pt x="119274" y="182880"/>
                      </a:cubicBezTo>
                      <a:cubicBezTo>
                        <a:pt x="110199" y="178342"/>
                        <a:pt x="115987" y="161927"/>
                        <a:pt x="109649" y="154004"/>
                      </a:cubicBezTo>
                      <a:cubicBezTo>
                        <a:pt x="102422" y="144971"/>
                        <a:pt x="90398" y="141171"/>
                        <a:pt x="80773" y="134754"/>
                      </a:cubicBezTo>
                      <a:cubicBezTo>
                        <a:pt x="74356" y="125129"/>
                        <a:pt x="71567" y="111617"/>
                        <a:pt x="61523" y="105878"/>
                      </a:cubicBezTo>
                      <a:cubicBezTo>
                        <a:pt x="47319" y="97761"/>
                        <a:pt x="21513" y="110457"/>
                        <a:pt x="13396" y="96253"/>
                      </a:cubicBezTo>
                      <a:cubicBezTo>
                        <a:pt x="-25514" y="28162"/>
                        <a:pt x="30605" y="44844"/>
                        <a:pt x="51897" y="28876"/>
                      </a:cubicBezTo>
                      <a:cubicBezTo>
                        <a:pt x="57637" y="24571"/>
                        <a:pt x="67939" y="4813"/>
                        <a:pt x="71148" y="0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4" name="Freeform 33">
                  <a:extLst>
                    <a:ext uri="{FF2B5EF4-FFF2-40B4-BE49-F238E27FC236}">
                      <a16:creationId xmlns:a16="http://schemas.microsoft.com/office/drawing/2014/main" id="{1ED62A01-3CB0-2B46-6DD2-9E1EF451446F}"/>
                    </a:ext>
                  </a:extLst>
                </p:cNvPr>
                <p:cNvSpPr/>
                <p:nvPr/>
              </p:nvSpPr>
              <p:spPr>
                <a:xfrm>
                  <a:off x="4523347" y="3012707"/>
                  <a:ext cx="530212" cy="356135"/>
                </a:xfrm>
                <a:custGeom>
                  <a:avLst/>
                  <a:gdLst>
                    <a:gd name="connsiteX0" fmla="*/ 10152 w 530212"/>
                    <a:gd name="connsiteY0" fmla="*/ 48127 h 356135"/>
                    <a:gd name="connsiteX1" fmla="*/ 10152 w 530212"/>
                    <a:gd name="connsiteY1" fmla="*/ 48127 h 356135"/>
                    <a:gd name="connsiteX2" fmla="*/ 87154 w 530212"/>
                    <a:gd name="connsiteY2" fmla="*/ 9626 h 356135"/>
                    <a:gd name="connsiteX3" fmla="*/ 116030 w 530212"/>
                    <a:gd name="connsiteY3" fmla="*/ 0 h 356135"/>
                    <a:gd name="connsiteX4" fmla="*/ 193032 w 530212"/>
                    <a:gd name="connsiteY4" fmla="*/ 9626 h 356135"/>
                    <a:gd name="connsiteX5" fmla="*/ 250784 w 530212"/>
                    <a:gd name="connsiteY5" fmla="*/ 38501 h 356135"/>
                    <a:gd name="connsiteX6" fmla="*/ 289285 w 530212"/>
                    <a:gd name="connsiteY6" fmla="*/ 96253 h 356135"/>
                    <a:gd name="connsiteX7" fmla="*/ 298910 w 530212"/>
                    <a:gd name="connsiteY7" fmla="*/ 125129 h 356135"/>
                    <a:gd name="connsiteX8" fmla="*/ 395162 w 530212"/>
                    <a:gd name="connsiteY8" fmla="*/ 221381 h 356135"/>
                    <a:gd name="connsiteX9" fmla="*/ 452914 w 530212"/>
                    <a:gd name="connsiteY9" fmla="*/ 240632 h 356135"/>
                    <a:gd name="connsiteX10" fmla="*/ 481790 w 530212"/>
                    <a:gd name="connsiteY10" fmla="*/ 250257 h 356135"/>
                    <a:gd name="connsiteX11" fmla="*/ 529916 w 530212"/>
                    <a:gd name="connsiteY11" fmla="*/ 298384 h 356135"/>
                    <a:gd name="connsiteX12" fmla="*/ 520291 w 530212"/>
                    <a:gd name="connsiteY12" fmla="*/ 327259 h 356135"/>
                    <a:gd name="connsiteX13" fmla="*/ 491415 w 530212"/>
                    <a:gd name="connsiteY13" fmla="*/ 356135 h 356135"/>
                    <a:gd name="connsiteX14" fmla="*/ 404788 w 530212"/>
                    <a:gd name="connsiteY14" fmla="*/ 346510 h 356135"/>
                    <a:gd name="connsiteX15" fmla="*/ 347036 w 530212"/>
                    <a:gd name="connsiteY15" fmla="*/ 308009 h 356135"/>
                    <a:gd name="connsiteX16" fmla="*/ 327786 w 530212"/>
                    <a:gd name="connsiteY16" fmla="*/ 279133 h 356135"/>
                    <a:gd name="connsiteX17" fmla="*/ 298910 w 530212"/>
                    <a:gd name="connsiteY17" fmla="*/ 250257 h 356135"/>
                    <a:gd name="connsiteX18" fmla="*/ 289285 w 530212"/>
                    <a:gd name="connsiteY18" fmla="*/ 221381 h 356135"/>
                    <a:gd name="connsiteX19" fmla="*/ 241158 w 530212"/>
                    <a:gd name="connsiteY19" fmla="*/ 173255 h 356135"/>
                    <a:gd name="connsiteX20" fmla="*/ 231533 w 530212"/>
                    <a:gd name="connsiteY20" fmla="*/ 144379 h 356135"/>
                    <a:gd name="connsiteX21" fmla="*/ 173781 w 530212"/>
                    <a:gd name="connsiteY21" fmla="*/ 96253 h 356135"/>
                    <a:gd name="connsiteX22" fmla="*/ 144906 w 530212"/>
                    <a:gd name="connsiteY22" fmla="*/ 86628 h 356135"/>
                    <a:gd name="connsiteX23" fmla="*/ 125655 w 530212"/>
                    <a:gd name="connsiteY23" fmla="*/ 115504 h 356135"/>
                    <a:gd name="connsiteX24" fmla="*/ 67904 w 530212"/>
                    <a:gd name="connsiteY24" fmla="*/ 144379 h 356135"/>
                    <a:gd name="connsiteX25" fmla="*/ 527 w 530212"/>
                    <a:gd name="connsiteY25" fmla="*/ 105878 h 356135"/>
                    <a:gd name="connsiteX26" fmla="*/ 10152 w 530212"/>
                    <a:gd name="connsiteY26" fmla="*/ 48127 h 35613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</a:cxnLst>
                  <a:rect l="l" t="t" r="r" b="b"/>
                  <a:pathLst>
                    <a:path w="530212" h="356135">
                      <a:moveTo>
                        <a:pt x="10152" y="48127"/>
                      </a:moveTo>
                      <a:lnTo>
                        <a:pt x="10152" y="48127"/>
                      </a:lnTo>
                      <a:cubicBezTo>
                        <a:pt x="35819" y="35293"/>
                        <a:pt x="61029" y="21501"/>
                        <a:pt x="87154" y="9626"/>
                      </a:cubicBezTo>
                      <a:cubicBezTo>
                        <a:pt x="96391" y="5427"/>
                        <a:pt x="105884" y="0"/>
                        <a:pt x="116030" y="0"/>
                      </a:cubicBezTo>
                      <a:cubicBezTo>
                        <a:pt x="141897" y="0"/>
                        <a:pt x="167365" y="6417"/>
                        <a:pt x="193032" y="9626"/>
                      </a:cubicBezTo>
                      <a:cubicBezTo>
                        <a:pt x="213629" y="16491"/>
                        <a:pt x="235418" y="20940"/>
                        <a:pt x="250784" y="38501"/>
                      </a:cubicBezTo>
                      <a:cubicBezTo>
                        <a:pt x="266019" y="55913"/>
                        <a:pt x="289285" y="96253"/>
                        <a:pt x="289285" y="96253"/>
                      </a:cubicBezTo>
                      <a:cubicBezTo>
                        <a:pt x="292493" y="105878"/>
                        <a:pt x="293983" y="116260"/>
                        <a:pt x="298910" y="125129"/>
                      </a:cubicBezTo>
                      <a:cubicBezTo>
                        <a:pt x="322243" y="167129"/>
                        <a:pt x="346162" y="205047"/>
                        <a:pt x="395162" y="221381"/>
                      </a:cubicBezTo>
                      <a:lnTo>
                        <a:pt x="452914" y="240632"/>
                      </a:lnTo>
                      <a:lnTo>
                        <a:pt x="481790" y="250257"/>
                      </a:lnTo>
                      <a:cubicBezTo>
                        <a:pt x="498635" y="261487"/>
                        <a:pt x="525905" y="274320"/>
                        <a:pt x="529916" y="298384"/>
                      </a:cubicBezTo>
                      <a:cubicBezTo>
                        <a:pt x="531584" y="308392"/>
                        <a:pt x="525919" y="318817"/>
                        <a:pt x="520291" y="327259"/>
                      </a:cubicBezTo>
                      <a:cubicBezTo>
                        <a:pt x="512740" y="338585"/>
                        <a:pt x="501040" y="346510"/>
                        <a:pt x="491415" y="356135"/>
                      </a:cubicBezTo>
                      <a:cubicBezTo>
                        <a:pt x="462539" y="352927"/>
                        <a:pt x="432350" y="355697"/>
                        <a:pt x="404788" y="346510"/>
                      </a:cubicBezTo>
                      <a:cubicBezTo>
                        <a:pt x="382839" y="339194"/>
                        <a:pt x="347036" y="308009"/>
                        <a:pt x="347036" y="308009"/>
                      </a:cubicBezTo>
                      <a:cubicBezTo>
                        <a:pt x="340619" y="298384"/>
                        <a:pt x="335192" y="288020"/>
                        <a:pt x="327786" y="279133"/>
                      </a:cubicBezTo>
                      <a:cubicBezTo>
                        <a:pt x="319072" y="268676"/>
                        <a:pt x="306461" y="261583"/>
                        <a:pt x="298910" y="250257"/>
                      </a:cubicBezTo>
                      <a:cubicBezTo>
                        <a:pt x="293282" y="241815"/>
                        <a:pt x="293822" y="230456"/>
                        <a:pt x="289285" y="221381"/>
                      </a:cubicBezTo>
                      <a:cubicBezTo>
                        <a:pt x="273244" y="189299"/>
                        <a:pt x="270032" y="192505"/>
                        <a:pt x="241158" y="173255"/>
                      </a:cubicBezTo>
                      <a:cubicBezTo>
                        <a:pt x="237950" y="163630"/>
                        <a:pt x="237161" y="152821"/>
                        <a:pt x="231533" y="144379"/>
                      </a:cubicBezTo>
                      <a:cubicBezTo>
                        <a:pt x="220890" y="128415"/>
                        <a:pt x="191535" y="105130"/>
                        <a:pt x="173781" y="96253"/>
                      </a:cubicBezTo>
                      <a:cubicBezTo>
                        <a:pt x="164706" y="91716"/>
                        <a:pt x="154531" y="89836"/>
                        <a:pt x="144906" y="86628"/>
                      </a:cubicBezTo>
                      <a:cubicBezTo>
                        <a:pt x="138489" y="96253"/>
                        <a:pt x="133835" y="107324"/>
                        <a:pt x="125655" y="115504"/>
                      </a:cubicBezTo>
                      <a:cubicBezTo>
                        <a:pt x="106997" y="134162"/>
                        <a:pt x="91388" y="136551"/>
                        <a:pt x="67904" y="144379"/>
                      </a:cubicBezTo>
                      <a:cubicBezTo>
                        <a:pt x="29893" y="136777"/>
                        <a:pt x="13678" y="145332"/>
                        <a:pt x="527" y="105878"/>
                      </a:cubicBezTo>
                      <a:cubicBezTo>
                        <a:pt x="-2517" y="96747"/>
                        <a:pt x="8548" y="57752"/>
                        <a:pt x="10152" y="48127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5" name="Freeform 34">
                  <a:extLst>
                    <a:ext uri="{FF2B5EF4-FFF2-40B4-BE49-F238E27FC236}">
                      <a16:creationId xmlns:a16="http://schemas.microsoft.com/office/drawing/2014/main" id="{949F8C47-FAA0-0A08-90B8-D138FFDB6310}"/>
                    </a:ext>
                  </a:extLst>
                </p:cNvPr>
                <p:cNvSpPr/>
                <p:nvPr/>
              </p:nvSpPr>
              <p:spPr>
                <a:xfrm>
                  <a:off x="3172549" y="3349592"/>
                  <a:ext cx="283383" cy="317633"/>
                </a:xfrm>
                <a:custGeom>
                  <a:avLst/>
                  <a:gdLst>
                    <a:gd name="connsiteX0" fmla="*/ 225169 w 283383"/>
                    <a:gd name="connsiteY0" fmla="*/ 0 h 317633"/>
                    <a:gd name="connsiteX1" fmla="*/ 225169 w 283383"/>
                    <a:gd name="connsiteY1" fmla="*/ 0 h 317633"/>
                    <a:gd name="connsiteX2" fmla="*/ 128916 w 283383"/>
                    <a:gd name="connsiteY2" fmla="*/ 67376 h 317633"/>
                    <a:gd name="connsiteX3" fmla="*/ 100040 w 283383"/>
                    <a:gd name="connsiteY3" fmla="*/ 77002 h 317633"/>
                    <a:gd name="connsiteX4" fmla="*/ 42289 w 283383"/>
                    <a:gd name="connsiteY4" fmla="*/ 115503 h 317633"/>
                    <a:gd name="connsiteX5" fmla="*/ 13413 w 283383"/>
                    <a:gd name="connsiteY5" fmla="*/ 134753 h 317633"/>
                    <a:gd name="connsiteX6" fmla="*/ 13413 w 283383"/>
                    <a:gd name="connsiteY6" fmla="*/ 240631 h 317633"/>
                    <a:gd name="connsiteX7" fmla="*/ 71165 w 283383"/>
                    <a:gd name="connsiteY7" fmla="*/ 269507 h 317633"/>
                    <a:gd name="connsiteX8" fmla="*/ 157792 w 283383"/>
                    <a:gd name="connsiteY8" fmla="*/ 308008 h 317633"/>
                    <a:gd name="connsiteX9" fmla="*/ 186668 w 283383"/>
                    <a:gd name="connsiteY9" fmla="*/ 317633 h 317633"/>
                    <a:gd name="connsiteX10" fmla="*/ 282920 w 283383"/>
                    <a:gd name="connsiteY10" fmla="*/ 279132 h 317633"/>
                    <a:gd name="connsiteX11" fmla="*/ 273295 w 283383"/>
                    <a:gd name="connsiteY11" fmla="*/ 231006 h 317633"/>
                    <a:gd name="connsiteX12" fmla="*/ 234794 w 283383"/>
                    <a:gd name="connsiteY12" fmla="*/ 173254 h 317633"/>
                    <a:gd name="connsiteX13" fmla="*/ 244419 w 283383"/>
                    <a:gd name="connsiteY13" fmla="*/ 105877 h 317633"/>
                    <a:gd name="connsiteX14" fmla="*/ 282920 w 283383"/>
                    <a:gd name="connsiteY14" fmla="*/ 48126 h 317633"/>
                    <a:gd name="connsiteX15" fmla="*/ 225169 w 283383"/>
                    <a:gd name="connsiteY15" fmla="*/ 0 h 3176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</a:cxnLst>
                  <a:rect l="l" t="t" r="r" b="b"/>
                  <a:pathLst>
                    <a:path w="283383" h="317633">
                      <a:moveTo>
                        <a:pt x="225169" y="0"/>
                      </a:moveTo>
                      <a:lnTo>
                        <a:pt x="225169" y="0"/>
                      </a:lnTo>
                      <a:cubicBezTo>
                        <a:pt x="193085" y="22459"/>
                        <a:pt x="166070" y="54991"/>
                        <a:pt x="128916" y="67376"/>
                      </a:cubicBezTo>
                      <a:cubicBezTo>
                        <a:pt x="119291" y="70585"/>
                        <a:pt x="108909" y="72075"/>
                        <a:pt x="100040" y="77002"/>
                      </a:cubicBezTo>
                      <a:cubicBezTo>
                        <a:pt x="79816" y="88238"/>
                        <a:pt x="61539" y="102669"/>
                        <a:pt x="42289" y="115503"/>
                      </a:cubicBezTo>
                      <a:lnTo>
                        <a:pt x="13413" y="134753"/>
                      </a:lnTo>
                      <a:cubicBezTo>
                        <a:pt x="-123" y="175362"/>
                        <a:pt x="-8354" y="186213"/>
                        <a:pt x="13413" y="240631"/>
                      </a:cubicBezTo>
                      <a:cubicBezTo>
                        <a:pt x="19155" y="254985"/>
                        <a:pt x="59008" y="265455"/>
                        <a:pt x="71165" y="269507"/>
                      </a:cubicBezTo>
                      <a:cubicBezTo>
                        <a:pt x="116923" y="300013"/>
                        <a:pt x="89067" y="285100"/>
                        <a:pt x="157792" y="308008"/>
                      </a:cubicBezTo>
                      <a:lnTo>
                        <a:pt x="186668" y="317633"/>
                      </a:lnTo>
                      <a:cubicBezTo>
                        <a:pt x="213139" y="314324"/>
                        <a:pt x="277054" y="326065"/>
                        <a:pt x="282920" y="279132"/>
                      </a:cubicBezTo>
                      <a:cubicBezTo>
                        <a:pt x="284949" y="262899"/>
                        <a:pt x="280065" y="245899"/>
                        <a:pt x="273295" y="231006"/>
                      </a:cubicBezTo>
                      <a:cubicBezTo>
                        <a:pt x="263721" y="209943"/>
                        <a:pt x="234794" y="173254"/>
                        <a:pt x="234794" y="173254"/>
                      </a:cubicBezTo>
                      <a:cubicBezTo>
                        <a:pt x="238002" y="150795"/>
                        <a:pt x="236275" y="127052"/>
                        <a:pt x="244419" y="105877"/>
                      </a:cubicBezTo>
                      <a:cubicBezTo>
                        <a:pt x="252724" y="84283"/>
                        <a:pt x="282920" y="48126"/>
                        <a:pt x="282920" y="48126"/>
                      </a:cubicBezTo>
                      <a:cubicBezTo>
                        <a:pt x="271026" y="12444"/>
                        <a:pt x="234794" y="8021"/>
                        <a:pt x="225169" y="0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0125AD34-B700-1D8C-B878-9C409014348A}"/>
                  </a:ext>
                </a:extLst>
              </p:cNvPr>
              <p:cNvGrpSpPr/>
              <p:nvPr/>
            </p:nvGrpSpPr>
            <p:grpSpPr>
              <a:xfrm>
                <a:off x="528991" y="2772265"/>
                <a:ext cx="2624765" cy="1684303"/>
                <a:chOff x="5981074" y="788927"/>
                <a:chExt cx="5150039" cy="3304764"/>
              </a:xfrm>
            </p:grpSpPr>
            <p:pic>
              <p:nvPicPr>
                <p:cNvPr id="16" name="Picture 15">
                  <a:extLst>
                    <a:ext uri="{FF2B5EF4-FFF2-40B4-BE49-F238E27FC236}">
                      <a16:creationId xmlns:a16="http://schemas.microsoft.com/office/drawing/2014/main" id="{9CDF4A50-0477-6181-FF16-1837EC3D5E5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screen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harpenSoften amount="36000"/>
                          </a14:imgEffect>
                          <a14:imgEffect>
                            <a14:brightnessContrast bright="12000" contrast="8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5981074" y="788927"/>
                  <a:ext cx="5150039" cy="3304764"/>
                </a:xfrm>
                <a:prstGeom prst="rect">
                  <a:avLst/>
                </a:prstGeom>
              </p:spPr>
            </p:pic>
            <p:sp>
              <p:nvSpPr>
                <p:cNvPr id="18" name="Freeform 17">
                  <a:extLst>
                    <a:ext uri="{FF2B5EF4-FFF2-40B4-BE49-F238E27FC236}">
                      <a16:creationId xmlns:a16="http://schemas.microsoft.com/office/drawing/2014/main" id="{9F279876-5016-6D32-7A17-26ECB84AF229}"/>
                    </a:ext>
                  </a:extLst>
                </p:cNvPr>
                <p:cNvSpPr/>
                <p:nvPr/>
              </p:nvSpPr>
              <p:spPr>
                <a:xfrm>
                  <a:off x="9577137" y="1982720"/>
                  <a:ext cx="1540042" cy="529474"/>
                </a:xfrm>
                <a:custGeom>
                  <a:avLst/>
                  <a:gdLst>
                    <a:gd name="connsiteX0" fmla="*/ 115503 w 1540042"/>
                    <a:gd name="connsiteY0" fmla="*/ 250341 h 529474"/>
                    <a:gd name="connsiteX1" fmla="*/ 115503 w 1540042"/>
                    <a:gd name="connsiteY1" fmla="*/ 250341 h 529474"/>
                    <a:gd name="connsiteX2" fmla="*/ 48126 w 1540042"/>
                    <a:gd name="connsiteY2" fmla="*/ 202215 h 529474"/>
                    <a:gd name="connsiteX3" fmla="*/ 9625 w 1540042"/>
                    <a:gd name="connsiteY3" fmla="*/ 144463 h 529474"/>
                    <a:gd name="connsiteX4" fmla="*/ 0 w 1540042"/>
                    <a:gd name="connsiteY4" fmla="*/ 115587 h 529474"/>
                    <a:gd name="connsiteX5" fmla="*/ 28876 w 1540042"/>
                    <a:gd name="connsiteY5" fmla="*/ 28960 h 529474"/>
                    <a:gd name="connsiteX6" fmla="*/ 57751 w 1540042"/>
                    <a:gd name="connsiteY6" fmla="*/ 19335 h 529474"/>
                    <a:gd name="connsiteX7" fmla="*/ 86627 w 1540042"/>
                    <a:gd name="connsiteY7" fmla="*/ 84 h 529474"/>
                    <a:gd name="connsiteX8" fmla="*/ 182880 w 1540042"/>
                    <a:gd name="connsiteY8" fmla="*/ 19335 h 529474"/>
                    <a:gd name="connsiteX9" fmla="*/ 240631 w 1540042"/>
                    <a:gd name="connsiteY9" fmla="*/ 57836 h 529474"/>
                    <a:gd name="connsiteX10" fmla="*/ 298383 w 1540042"/>
                    <a:gd name="connsiteY10" fmla="*/ 96337 h 529474"/>
                    <a:gd name="connsiteX11" fmla="*/ 327259 w 1540042"/>
                    <a:gd name="connsiteY11" fmla="*/ 125213 h 529474"/>
                    <a:gd name="connsiteX12" fmla="*/ 346509 w 1540042"/>
                    <a:gd name="connsiteY12" fmla="*/ 154088 h 529474"/>
                    <a:gd name="connsiteX13" fmla="*/ 375385 w 1540042"/>
                    <a:gd name="connsiteY13" fmla="*/ 163714 h 529474"/>
                    <a:gd name="connsiteX14" fmla="*/ 462012 w 1540042"/>
                    <a:gd name="connsiteY14" fmla="*/ 202215 h 529474"/>
                    <a:gd name="connsiteX15" fmla="*/ 490888 w 1540042"/>
                    <a:gd name="connsiteY15" fmla="*/ 211840 h 529474"/>
                    <a:gd name="connsiteX16" fmla="*/ 519764 w 1540042"/>
                    <a:gd name="connsiteY16" fmla="*/ 221465 h 529474"/>
                    <a:gd name="connsiteX17" fmla="*/ 750770 w 1540042"/>
                    <a:gd name="connsiteY17" fmla="*/ 211840 h 529474"/>
                    <a:gd name="connsiteX18" fmla="*/ 827772 w 1540042"/>
                    <a:gd name="connsiteY18" fmla="*/ 192589 h 529474"/>
                    <a:gd name="connsiteX19" fmla="*/ 875899 w 1540042"/>
                    <a:gd name="connsiteY19" fmla="*/ 182964 h 529474"/>
                    <a:gd name="connsiteX20" fmla="*/ 1097280 w 1540042"/>
                    <a:gd name="connsiteY20" fmla="*/ 192589 h 529474"/>
                    <a:gd name="connsiteX21" fmla="*/ 1164657 w 1540042"/>
                    <a:gd name="connsiteY21" fmla="*/ 211840 h 529474"/>
                    <a:gd name="connsiteX22" fmla="*/ 1280160 w 1540042"/>
                    <a:gd name="connsiteY22" fmla="*/ 231091 h 529474"/>
                    <a:gd name="connsiteX23" fmla="*/ 1395663 w 1540042"/>
                    <a:gd name="connsiteY23" fmla="*/ 269592 h 529474"/>
                    <a:gd name="connsiteX24" fmla="*/ 1424539 w 1540042"/>
                    <a:gd name="connsiteY24" fmla="*/ 279217 h 529474"/>
                    <a:gd name="connsiteX25" fmla="*/ 1482290 w 1540042"/>
                    <a:gd name="connsiteY25" fmla="*/ 317718 h 529474"/>
                    <a:gd name="connsiteX26" fmla="*/ 1511166 w 1540042"/>
                    <a:gd name="connsiteY26" fmla="*/ 336968 h 529474"/>
                    <a:gd name="connsiteX27" fmla="*/ 1540042 w 1540042"/>
                    <a:gd name="connsiteY27" fmla="*/ 394720 h 529474"/>
                    <a:gd name="connsiteX28" fmla="*/ 1530417 w 1540042"/>
                    <a:gd name="connsiteY28" fmla="*/ 462097 h 529474"/>
                    <a:gd name="connsiteX29" fmla="*/ 1472665 w 1540042"/>
                    <a:gd name="connsiteY29" fmla="*/ 500598 h 529474"/>
                    <a:gd name="connsiteX30" fmla="*/ 1414914 w 1540042"/>
                    <a:gd name="connsiteY30" fmla="*/ 529474 h 529474"/>
                    <a:gd name="connsiteX31" fmla="*/ 1347537 w 1540042"/>
                    <a:gd name="connsiteY31" fmla="*/ 510223 h 529474"/>
                    <a:gd name="connsiteX32" fmla="*/ 1289785 w 1540042"/>
                    <a:gd name="connsiteY32" fmla="*/ 471722 h 529474"/>
                    <a:gd name="connsiteX33" fmla="*/ 1260909 w 1540042"/>
                    <a:gd name="connsiteY33" fmla="*/ 452472 h 529474"/>
                    <a:gd name="connsiteX34" fmla="*/ 1232034 w 1540042"/>
                    <a:gd name="connsiteY34" fmla="*/ 423596 h 529474"/>
                    <a:gd name="connsiteX35" fmla="*/ 1145406 w 1540042"/>
                    <a:gd name="connsiteY35" fmla="*/ 385095 h 529474"/>
                    <a:gd name="connsiteX36" fmla="*/ 1116530 w 1540042"/>
                    <a:gd name="connsiteY36" fmla="*/ 375469 h 529474"/>
                    <a:gd name="connsiteX37" fmla="*/ 914400 w 1540042"/>
                    <a:gd name="connsiteY37" fmla="*/ 385095 h 529474"/>
                    <a:gd name="connsiteX38" fmla="*/ 856648 w 1540042"/>
                    <a:gd name="connsiteY38" fmla="*/ 404345 h 529474"/>
                    <a:gd name="connsiteX39" fmla="*/ 702644 w 1540042"/>
                    <a:gd name="connsiteY39" fmla="*/ 413971 h 529474"/>
                    <a:gd name="connsiteX40" fmla="*/ 442762 w 1540042"/>
                    <a:gd name="connsiteY40" fmla="*/ 404345 h 529474"/>
                    <a:gd name="connsiteX41" fmla="*/ 221381 w 1540042"/>
                    <a:gd name="connsiteY41" fmla="*/ 385095 h 529474"/>
                    <a:gd name="connsiteX42" fmla="*/ 163629 w 1540042"/>
                    <a:gd name="connsiteY42" fmla="*/ 365844 h 529474"/>
                    <a:gd name="connsiteX43" fmla="*/ 154004 w 1540042"/>
                    <a:gd name="connsiteY43" fmla="*/ 336968 h 529474"/>
                    <a:gd name="connsiteX44" fmla="*/ 134754 w 1540042"/>
                    <a:gd name="connsiteY44" fmla="*/ 308093 h 529474"/>
                    <a:gd name="connsiteX45" fmla="*/ 115503 w 1540042"/>
                    <a:gd name="connsiteY45" fmla="*/ 250341 h 52947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</a:cxnLst>
                  <a:rect l="l" t="t" r="r" b="b"/>
                  <a:pathLst>
                    <a:path w="1540042" h="529474">
                      <a:moveTo>
                        <a:pt x="115503" y="250341"/>
                      </a:moveTo>
                      <a:lnTo>
                        <a:pt x="115503" y="250341"/>
                      </a:lnTo>
                      <a:cubicBezTo>
                        <a:pt x="93044" y="234299"/>
                        <a:pt x="67642" y="221731"/>
                        <a:pt x="48126" y="202215"/>
                      </a:cubicBezTo>
                      <a:cubicBezTo>
                        <a:pt x="31766" y="185855"/>
                        <a:pt x="9625" y="144463"/>
                        <a:pt x="9625" y="144463"/>
                      </a:cubicBezTo>
                      <a:cubicBezTo>
                        <a:pt x="6417" y="134838"/>
                        <a:pt x="0" y="125733"/>
                        <a:pt x="0" y="115587"/>
                      </a:cubicBezTo>
                      <a:cubicBezTo>
                        <a:pt x="0" y="91163"/>
                        <a:pt x="5632" y="47555"/>
                        <a:pt x="28876" y="28960"/>
                      </a:cubicBezTo>
                      <a:cubicBezTo>
                        <a:pt x="36798" y="22622"/>
                        <a:pt x="48126" y="22543"/>
                        <a:pt x="57751" y="19335"/>
                      </a:cubicBezTo>
                      <a:cubicBezTo>
                        <a:pt x="67376" y="12918"/>
                        <a:pt x="75116" y="1235"/>
                        <a:pt x="86627" y="84"/>
                      </a:cubicBezTo>
                      <a:cubicBezTo>
                        <a:pt x="97169" y="-970"/>
                        <a:pt x="162391" y="7952"/>
                        <a:pt x="182880" y="19335"/>
                      </a:cubicBezTo>
                      <a:cubicBezTo>
                        <a:pt x="203104" y="30571"/>
                        <a:pt x="221381" y="45002"/>
                        <a:pt x="240631" y="57836"/>
                      </a:cubicBezTo>
                      <a:cubicBezTo>
                        <a:pt x="240636" y="57839"/>
                        <a:pt x="298379" y="96333"/>
                        <a:pt x="298383" y="96337"/>
                      </a:cubicBezTo>
                      <a:cubicBezTo>
                        <a:pt x="308008" y="105962"/>
                        <a:pt x="318545" y="114756"/>
                        <a:pt x="327259" y="125213"/>
                      </a:cubicBezTo>
                      <a:cubicBezTo>
                        <a:pt x="334665" y="134100"/>
                        <a:pt x="337476" y="146862"/>
                        <a:pt x="346509" y="154088"/>
                      </a:cubicBezTo>
                      <a:cubicBezTo>
                        <a:pt x="354432" y="160426"/>
                        <a:pt x="366310" y="159177"/>
                        <a:pt x="375385" y="163714"/>
                      </a:cubicBezTo>
                      <a:cubicBezTo>
                        <a:pt x="466898" y="209470"/>
                        <a:pt x="313031" y="152554"/>
                        <a:pt x="462012" y="202215"/>
                      </a:cubicBezTo>
                      <a:lnTo>
                        <a:pt x="490888" y="211840"/>
                      </a:lnTo>
                      <a:lnTo>
                        <a:pt x="519764" y="221465"/>
                      </a:lnTo>
                      <a:cubicBezTo>
                        <a:pt x="596766" y="218257"/>
                        <a:pt x="674038" y="219034"/>
                        <a:pt x="750770" y="211840"/>
                      </a:cubicBezTo>
                      <a:cubicBezTo>
                        <a:pt x="777112" y="209370"/>
                        <a:pt x="801828" y="197778"/>
                        <a:pt x="827772" y="192589"/>
                      </a:cubicBezTo>
                      <a:lnTo>
                        <a:pt x="875899" y="182964"/>
                      </a:lnTo>
                      <a:cubicBezTo>
                        <a:pt x="949693" y="186172"/>
                        <a:pt x="1023618" y="187132"/>
                        <a:pt x="1097280" y="192589"/>
                      </a:cubicBezTo>
                      <a:cubicBezTo>
                        <a:pt x="1122857" y="194484"/>
                        <a:pt x="1140692" y="205849"/>
                        <a:pt x="1164657" y="211840"/>
                      </a:cubicBezTo>
                      <a:cubicBezTo>
                        <a:pt x="1202185" y="221222"/>
                        <a:pt x="1242135" y="225658"/>
                        <a:pt x="1280160" y="231091"/>
                      </a:cubicBezTo>
                      <a:lnTo>
                        <a:pt x="1395663" y="269592"/>
                      </a:lnTo>
                      <a:cubicBezTo>
                        <a:pt x="1405288" y="272800"/>
                        <a:pt x="1416097" y="273589"/>
                        <a:pt x="1424539" y="279217"/>
                      </a:cubicBezTo>
                      <a:lnTo>
                        <a:pt x="1482290" y="317718"/>
                      </a:lnTo>
                      <a:lnTo>
                        <a:pt x="1511166" y="336968"/>
                      </a:lnTo>
                      <a:cubicBezTo>
                        <a:pt x="1520900" y="351569"/>
                        <a:pt x="1540042" y="374794"/>
                        <a:pt x="1540042" y="394720"/>
                      </a:cubicBezTo>
                      <a:cubicBezTo>
                        <a:pt x="1540042" y="417407"/>
                        <a:pt x="1538843" y="441033"/>
                        <a:pt x="1530417" y="462097"/>
                      </a:cubicBezTo>
                      <a:cubicBezTo>
                        <a:pt x="1516732" y="496309"/>
                        <a:pt x="1497785" y="488039"/>
                        <a:pt x="1472665" y="500598"/>
                      </a:cubicBezTo>
                      <a:cubicBezTo>
                        <a:pt x="1398019" y="537920"/>
                        <a:pt x="1487502" y="505276"/>
                        <a:pt x="1414914" y="529474"/>
                      </a:cubicBezTo>
                      <a:cubicBezTo>
                        <a:pt x="1405854" y="527209"/>
                        <a:pt x="1358834" y="516499"/>
                        <a:pt x="1347537" y="510223"/>
                      </a:cubicBezTo>
                      <a:cubicBezTo>
                        <a:pt x="1327312" y="498987"/>
                        <a:pt x="1309036" y="484556"/>
                        <a:pt x="1289785" y="471722"/>
                      </a:cubicBezTo>
                      <a:cubicBezTo>
                        <a:pt x="1280160" y="465305"/>
                        <a:pt x="1269089" y="460652"/>
                        <a:pt x="1260909" y="452472"/>
                      </a:cubicBezTo>
                      <a:cubicBezTo>
                        <a:pt x="1251284" y="442847"/>
                        <a:pt x="1242491" y="432310"/>
                        <a:pt x="1232034" y="423596"/>
                      </a:cubicBezTo>
                      <a:cubicBezTo>
                        <a:pt x="1201527" y="398173"/>
                        <a:pt x="1187378" y="399086"/>
                        <a:pt x="1145406" y="385095"/>
                      </a:cubicBezTo>
                      <a:lnTo>
                        <a:pt x="1116530" y="375469"/>
                      </a:lnTo>
                      <a:cubicBezTo>
                        <a:pt x="1049153" y="378678"/>
                        <a:pt x="981440" y="377646"/>
                        <a:pt x="914400" y="385095"/>
                      </a:cubicBezTo>
                      <a:cubicBezTo>
                        <a:pt x="894232" y="387336"/>
                        <a:pt x="876900" y="403079"/>
                        <a:pt x="856648" y="404345"/>
                      </a:cubicBezTo>
                      <a:lnTo>
                        <a:pt x="702644" y="413971"/>
                      </a:lnTo>
                      <a:lnTo>
                        <a:pt x="442762" y="404345"/>
                      </a:lnTo>
                      <a:cubicBezTo>
                        <a:pt x="338517" y="399260"/>
                        <a:pt x="314385" y="395429"/>
                        <a:pt x="221381" y="385095"/>
                      </a:cubicBezTo>
                      <a:cubicBezTo>
                        <a:pt x="202130" y="378678"/>
                        <a:pt x="170046" y="385095"/>
                        <a:pt x="163629" y="365844"/>
                      </a:cubicBezTo>
                      <a:cubicBezTo>
                        <a:pt x="160421" y="356219"/>
                        <a:pt x="158541" y="346043"/>
                        <a:pt x="154004" y="336968"/>
                      </a:cubicBezTo>
                      <a:cubicBezTo>
                        <a:pt x="148831" y="326621"/>
                        <a:pt x="139927" y="318440"/>
                        <a:pt x="134754" y="308093"/>
                      </a:cubicBezTo>
                      <a:cubicBezTo>
                        <a:pt x="124113" y="286812"/>
                        <a:pt x="118711" y="259966"/>
                        <a:pt x="115503" y="250341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9" name="Freeform 18">
                  <a:extLst>
                    <a:ext uri="{FF2B5EF4-FFF2-40B4-BE49-F238E27FC236}">
                      <a16:creationId xmlns:a16="http://schemas.microsoft.com/office/drawing/2014/main" id="{43455AEC-5651-2642-ACC4-3B9E3CDC9CBC}"/>
                    </a:ext>
                  </a:extLst>
                </p:cNvPr>
                <p:cNvSpPr/>
                <p:nvPr/>
              </p:nvSpPr>
              <p:spPr>
                <a:xfrm>
                  <a:off x="8624237" y="2916455"/>
                  <a:ext cx="1155030" cy="606391"/>
                </a:xfrm>
                <a:custGeom>
                  <a:avLst/>
                  <a:gdLst>
                    <a:gd name="connsiteX0" fmla="*/ 856647 w 1155030"/>
                    <a:gd name="connsiteY0" fmla="*/ 481263 h 606391"/>
                    <a:gd name="connsiteX1" fmla="*/ 856647 w 1155030"/>
                    <a:gd name="connsiteY1" fmla="*/ 481263 h 606391"/>
                    <a:gd name="connsiteX2" fmla="*/ 885523 w 1155030"/>
                    <a:gd name="connsiteY2" fmla="*/ 404261 h 606391"/>
                    <a:gd name="connsiteX3" fmla="*/ 895148 w 1155030"/>
                    <a:gd name="connsiteY3" fmla="*/ 375385 h 606391"/>
                    <a:gd name="connsiteX4" fmla="*/ 952900 w 1155030"/>
                    <a:gd name="connsiteY4" fmla="*/ 336884 h 606391"/>
                    <a:gd name="connsiteX5" fmla="*/ 1010651 w 1155030"/>
                    <a:gd name="connsiteY5" fmla="*/ 317633 h 606391"/>
                    <a:gd name="connsiteX6" fmla="*/ 1020277 w 1155030"/>
                    <a:gd name="connsiteY6" fmla="*/ 211756 h 606391"/>
                    <a:gd name="connsiteX7" fmla="*/ 1001026 w 1155030"/>
                    <a:gd name="connsiteY7" fmla="*/ 86627 h 606391"/>
                    <a:gd name="connsiteX8" fmla="*/ 981776 w 1155030"/>
                    <a:gd name="connsiteY8" fmla="*/ 28876 h 606391"/>
                    <a:gd name="connsiteX9" fmla="*/ 972150 w 1155030"/>
                    <a:gd name="connsiteY9" fmla="*/ 0 h 606391"/>
                    <a:gd name="connsiteX10" fmla="*/ 856647 w 1155030"/>
                    <a:gd name="connsiteY10" fmla="*/ 9625 h 606391"/>
                    <a:gd name="connsiteX11" fmla="*/ 798896 w 1155030"/>
                    <a:gd name="connsiteY11" fmla="*/ 48126 h 606391"/>
                    <a:gd name="connsiteX12" fmla="*/ 741144 w 1155030"/>
                    <a:gd name="connsiteY12" fmla="*/ 86627 h 606391"/>
                    <a:gd name="connsiteX13" fmla="*/ 712268 w 1155030"/>
                    <a:gd name="connsiteY13" fmla="*/ 105878 h 606391"/>
                    <a:gd name="connsiteX14" fmla="*/ 683392 w 1155030"/>
                    <a:gd name="connsiteY14" fmla="*/ 115503 h 606391"/>
                    <a:gd name="connsiteX15" fmla="*/ 625641 w 1155030"/>
                    <a:gd name="connsiteY15" fmla="*/ 144379 h 606391"/>
                    <a:gd name="connsiteX16" fmla="*/ 596765 w 1155030"/>
                    <a:gd name="connsiteY16" fmla="*/ 163629 h 606391"/>
                    <a:gd name="connsiteX17" fmla="*/ 539014 w 1155030"/>
                    <a:gd name="connsiteY17" fmla="*/ 182880 h 606391"/>
                    <a:gd name="connsiteX18" fmla="*/ 510138 w 1155030"/>
                    <a:gd name="connsiteY18" fmla="*/ 192505 h 606391"/>
                    <a:gd name="connsiteX19" fmla="*/ 481262 w 1155030"/>
                    <a:gd name="connsiteY19" fmla="*/ 202130 h 606391"/>
                    <a:gd name="connsiteX20" fmla="*/ 423510 w 1155030"/>
                    <a:gd name="connsiteY20" fmla="*/ 240631 h 606391"/>
                    <a:gd name="connsiteX21" fmla="*/ 394635 w 1155030"/>
                    <a:gd name="connsiteY21" fmla="*/ 250257 h 606391"/>
                    <a:gd name="connsiteX22" fmla="*/ 336883 w 1155030"/>
                    <a:gd name="connsiteY22" fmla="*/ 279132 h 606391"/>
                    <a:gd name="connsiteX23" fmla="*/ 279131 w 1155030"/>
                    <a:gd name="connsiteY23" fmla="*/ 317633 h 606391"/>
                    <a:gd name="connsiteX24" fmla="*/ 250256 w 1155030"/>
                    <a:gd name="connsiteY24" fmla="*/ 336884 h 606391"/>
                    <a:gd name="connsiteX25" fmla="*/ 192504 w 1155030"/>
                    <a:gd name="connsiteY25" fmla="*/ 356134 h 606391"/>
                    <a:gd name="connsiteX26" fmla="*/ 125127 w 1155030"/>
                    <a:gd name="connsiteY26" fmla="*/ 346509 h 606391"/>
                    <a:gd name="connsiteX27" fmla="*/ 67376 w 1155030"/>
                    <a:gd name="connsiteY27" fmla="*/ 336884 h 606391"/>
                    <a:gd name="connsiteX28" fmla="*/ 38500 w 1155030"/>
                    <a:gd name="connsiteY28" fmla="*/ 356134 h 606391"/>
                    <a:gd name="connsiteX29" fmla="*/ 9624 w 1155030"/>
                    <a:gd name="connsiteY29" fmla="*/ 442762 h 606391"/>
                    <a:gd name="connsiteX30" fmla="*/ 28875 w 1155030"/>
                    <a:gd name="connsiteY30" fmla="*/ 471638 h 606391"/>
                    <a:gd name="connsiteX31" fmla="*/ 19249 w 1155030"/>
                    <a:gd name="connsiteY31" fmla="*/ 500513 h 606391"/>
                    <a:gd name="connsiteX32" fmla="*/ 38500 w 1155030"/>
                    <a:gd name="connsiteY32" fmla="*/ 558265 h 606391"/>
                    <a:gd name="connsiteX33" fmla="*/ 125127 w 1155030"/>
                    <a:gd name="connsiteY33" fmla="*/ 606391 h 606391"/>
                    <a:gd name="connsiteX34" fmla="*/ 327258 w 1155030"/>
                    <a:gd name="connsiteY34" fmla="*/ 577516 h 606391"/>
                    <a:gd name="connsiteX35" fmla="*/ 385009 w 1155030"/>
                    <a:gd name="connsiteY35" fmla="*/ 558265 h 606391"/>
                    <a:gd name="connsiteX36" fmla="*/ 413885 w 1155030"/>
                    <a:gd name="connsiteY36" fmla="*/ 548640 h 606391"/>
                    <a:gd name="connsiteX37" fmla="*/ 442761 w 1155030"/>
                    <a:gd name="connsiteY37" fmla="*/ 529389 h 606391"/>
                    <a:gd name="connsiteX38" fmla="*/ 490887 w 1155030"/>
                    <a:gd name="connsiteY38" fmla="*/ 519764 h 606391"/>
                    <a:gd name="connsiteX39" fmla="*/ 885523 w 1155030"/>
                    <a:gd name="connsiteY39" fmla="*/ 529389 h 606391"/>
                    <a:gd name="connsiteX40" fmla="*/ 943275 w 1155030"/>
                    <a:gd name="connsiteY40" fmla="*/ 539014 h 606391"/>
                    <a:gd name="connsiteX41" fmla="*/ 981776 w 1155030"/>
                    <a:gd name="connsiteY41" fmla="*/ 548640 h 606391"/>
                    <a:gd name="connsiteX42" fmla="*/ 1155030 w 1155030"/>
                    <a:gd name="connsiteY42" fmla="*/ 539014 h 606391"/>
                    <a:gd name="connsiteX43" fmla="*/ 895148 w 1155030"/>
                    <a:gd name="connsiteY43" fmla="*/ 462012 h 606391"/>
                    <a:gd name="connsiteX44" fmla="*/ 856647 w 1155030"/>
                    <a:gd name="connsiteY44" fmla="*/ 481263 h 60639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</a:cxnLst>
                  <a:rect l="l" t="t" r="r" b="b"/>
                  <a:pathLst>
                    <a:path w="1155030" h="606391">
                      <a:moveTo>
                        <a:pt x="856647" y="481263"/>
                      </a:moveTo>
                      <a:lnTo>
                        <a:pt x="856647" y="481263"/>
                      </a:lnTo>
                      <a:cubicBezTo>
                        <a:pt x="866272" y="455596"/>
                        <a:pt x="876155" y="430023"/>
                        <a:pt x="885523" y="404261"/>
                      </a:cubicBezTo>
                      <a:cubicBezTo>
                        <a:pt x="888990" y="394726"/>
                        <a:pt x="887974" y="382559"/>
                        <a:pt x="895148" y="375385"/>
                      </a:cubicBezTo>
                      <a:cubicBezTo>
                        <a:pt x="911508" y="359025"/>
                        <a:pt x="930951" y="344201"/>
                        <a:pt x="952900" y="336884"/>
                      </a:cubicBezTo>
                      <a:lnTo>
                        <a:pt x="1010651" y="317633"/>
                      </a:lnTo>
                      <a:cubicBezTo>
                        <a:pt x="1013860" y="282341"/>
                        <a:pt x="1020277" y="247194"/>
                        <a:pt x="1020277" y="211756"/>
                      </a:cubicBezTo>
                      <a:cubicBezTo>
                        <a:pt x="1020277" y="192244"/>
                        <a:pt x="1008353" y="113492"/>
                        <a:pt x="1001026" y="86627"/>
                      </a:cubicBezTo>
                      <a:cubicBezTo>
                        <a:pt x="995687" y="67050"/>
                        <a:pt x="988193" y="48126"/>
                        <a:pt x="981776" y="28876"/>
                      </a:cubicBezTo>
                      <a:lnTo>
                        <a:pt x="972150" y="0"/>
                      </a:lnTo>
                      <a:cubicBezTo>
                        <a:pt x="933649" y="3208"/>
                        <a:pt x="893872" y="-715"/>
                        <a:pt x="856647" y="9625"/>
                      </a:cubicBezTo>
                      <a:cubicBezTo>
                        <a:pt x="834355" y="15817"/>
                        <a:pt x="818146" y="35292"/>
                        <a:pt x="798896" y="48126"/>
                      </a:cubicBezTo>
                      <a:lnTo>
                        <a:pt x="741144" y="86627"/>
                      </a:lnTo>
                      <a:cubicBezTo>
                        <a:pt x="731519" y="93044"/>
                        <a:pt x="723243" y="102220"/>
                        <a:pt x="712268" y="105878"/>
                      </a:cubicBezTo>
                      <a:lnTo>
                        <a:pt x="683392" y="115503"/>
                      </a:lnTo>
                      <a:cubicBezTo>
                        <a:pt x="600647" y="170666"/>
                        <a:pt x="705336" y="104532"/>
                        <a:pt x="625641" y="144379"/>
                      </a:cubicBezTo>
                      <a:cubicBezTo>
                        <a:pt x="615294" y="149552"/>
                        <a:pt x="607336" y="158931"/>
                        <a:pt x="596765" y="163629"/>
                      </a:cubicBezTo>
                      <a:cubicBezTo>
                        <a:pt x="578222" y="171870"/>
                        <a:pt x="558264" y="176463"/>
                        <a:pt x="539014" y="182880"/>
                      </a:cubicBezTo>
                      <a:lnTo>
                        <a:pt x="510138" y="192505"/>
                      </a:lnTo>
                      <a:lnTo>
                        <a:pt x="481262" y="202130"/>
                      </a:lnTo>
                      <a:cubicBezTo>
                        <a:pt x="462011" y="214964"/>
                        <a:pt x="445459" y="233314"/>
                        <a:pt x="423510" y="240631"/>
                      </a:cubicBezTo>
                      <a:cubicBezTo>
                        <a:pt x="413885" y="243840"/>
                        <a:pt x="403710" y="245720"/>
                        <a:pt x="394635" y="250257"/>
                      </a:cubicBezTo>
                      <a:cubicBezTo>
                        <a:pt x="320011" y="287570"/>
                        <a:pt x="409454" y="254943"/>
                        <a:pt x="336883" y="279132"/>
                      </a:cubicBezTo>
                      <a:lnTo>
                        <a:pt x="279131" y="317633"/>
                      </a:lnTo>
                      <a:cubicBezTo>
                        <a:pt x="269506" y="324050"/>
                        <a:pt x="261230" y="333226"/>
                        <a:pt x="250256" y="336884"/>
                      </a:cubicBezTo>
                      <a:lnTo>
                        <a:pt x="192504" y="356134"/>
                      </a:lnTo>
                      <a:lnTo>
                        <a:pt x="125127" y="346509"/>
                      </a:lnTo>
                      <a:cubicBezTo>
                        <a:pt x="105838" y="343542"/>
                        <a:pt x="86772" y="334729"/>
                        <a:pt x="67376" y="336884"/>
                      </a:cubicBezTo>
                      <a:cubicBezTo>
                        <a:pt x="55879" y="338161"/>
                        <a:pt x="48125" y="349717"/>
                        <a:pt x="38500" y="356134"/>
                      </a:cubicBezTo>
                      <a:cubicBezTo>
                        <a:pt x="5410" y="405770"/>
                        <a:pt x="-12158" y="399198"/>
                        <a:pt x="9624" y="442762"/>
                      </a:cubicBezTo>
                      <a:cubicBezTo>
                        <a:pt x="14797" y="453109"/>
                        <a:pt x="22458" y="462013"/>
                        <a:pt x="28875" y="471638"/>
                      </a:cubicBezTo>
                      <a:cubicBezTo>
                        <a:pt x="25666" y="481263"/>
                        <a:pt x="18129" y="490429"/>
                        <a:pt x="19249" y="500513"/>
                      </a:cubicBezTo>
                      <a:cubicBezTo>
                        <a:pt x="21490" y="520681"/>
                        <a:pt x="21616" y="547009"/>
                        <a:pt x="38500" y="558265"/>
                      </a:cubicBezTo>
                      <a:cubicBezTo>
                        <a:pt x="104693" y="602394"/>
                        <a:pt x="74302" y="589450"/>
                        <a:pt x="125127" y="606391"/>
                      </a:cubicBezTo>
                      <a:cubicBezTo>
                        <a:pt x="289742" y="595417"/>
                        <a:pt x="223752" y="612018"/>
                        <a:pt x="327258" y="577516"/>
                      </a:cubicBezTo>
                      <a:lnTo>
                        <a:pt x="385009" y="558265"/>
                      </a:lnTo>
                      <a:lnTo>
                        <a:pt x="413885" y="548640"/>
                      </a:lnTo>
                      <a:cubicBezTo>
                        <a:pt x="423510" y="542223"/>
                        <a:pt x="431929" y="533451"/>
                        <a:pt x="442761" y="529389"/>
                      </a:cubicBezTo>
                      <a:cubicBezTo>
                        <a:pt x="458079" y="523645"/>
                        <a:pt x="474527" y="519764"/>
                        <a:pt x="490887" y="519764"/>
                      </a:cubicBezTo>
                      <a:cubicBezTo>
                        <a:pt x="622471" y="519764"/>
                        <a:pt x="753978" y="526181"/>
                        <a:pt x="885523" y="529389"/>
                      </a:cubicBezTo>
                      <a:cubicBezTo>
                        <a:pt x="904774" y="532597"/>
                        <a:pt x="924138" y="535186"/>
                        <a:pt x="943275" y="539014"/>
                      </a:cubicBezTo>
                      <a:cubicBezTo>
                        <a:pt x="956247" y="541608"/>
                        <a:pt x="968547" y="548640"/>
                        <a:pt x="981776" y="548640"/>
                      </a:cubicBezTo>
                      <a:cubicBezTo>
                        <a:pt x="1039616" y="548640"/>
                        <a:pt x="1097279" y="542223"/>
                        <a:pt x="1155030" y="539014"/>
                      </a:cubicBezTo>
                      <a:cubicBezTo>
                        <a:pt x="1133614" y="389103"/>
                        <a:pt x="1168019" y="472119"/>
                        <a:pt x="895148" y="462012"/>
                      </a:cubicBezTo>
                      <a:cubicBezTo>
                        <a:pt x="891942" y="461893"/>
                        <a:pt x="863064" y="478055"/>
                        <a:pt x="856647" y="481263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0" name="Freeform 19">
                  <a:extLst>
                    <a:ext uri="{FF2B5EF4-FFF2-40B4-BE49-F238E27FC236}">
                      <a16:creationId xmlns:a16="http://schemas.microsoft.com/office/drawing/2014/main" id="{56C04826-8AE1-7CB5-DCFF-974365A694CB}"/>
                    </a:ext>
                  </a:extLst>
                </p:cNvPr>
                <p:cNvSpPr/>
                <p:nvPr/>
              </p:nvSpPr>
              <p:spPr>
                <a:xfrm>
                  <a:off x="6477802" y="2290813"/>
                  <a:ext cx="781173" cy="356134"/>
                </a:xfrm>
                <a:custGeom>
                  <a:avLst/>
                  <a:gdLst>
                    <a:gd name="connsiteX0" fmla="*/ 259882 w 781173"/>
                    <a:gd name="connsiteY0" fmla="*/ 192505 h 356134"/>
                    <a:gd name="connsiteX1" fmla="*/ 259882 w 781173"/>
                    <a:gd name="connsiteY1" fmla="*/ 192505 h 356134"/>
                    <a:gd name="connsiteX2" fmla="*/ 346510 w 781173"/>
                    <a:gd name="connsiteY2" fmla="*/ 202130 h 356134"/>
                    <a:gd name="connsiteX3" fmla="*/ 365760 w 781173"/>
                    <a:gd name="connsiteY3" fmla="*/ 173254 h 356134"/>
                    <a:gd name="connsiteX4" fmla="*/ 394636 w 781173"/>
                    <a:gd name="connsiteY4" fmla="*/ 154004 h 356134"/>
                    <a:gd name="connsiteX5" fmla="*/ 442762 w 781173"/>
                    <a:gd name="connsiteY5" fmla="*/ 96252 h 356134"/>
                    <a:gd name="connsiteX6" fmla="*/ 471638 w 781173"/>
                    <a:gd name="connsiteY6" fmla="*/ 77002 h 356134"/>
                    <a:gd name="connsiteX7" fmla="*/ 490889 w 781173"/>
                    <a:gd name="connsiteY7" fmla="*/ 48126 h 356134"/>
                    <a:gd name="connsiteX8" fmla="*/ 577516 w 781173"/>
                    <a:gd name="connsiteY8" fmla="*/ 19250 h 356134"/>
                    <a:gd name="connsiteX9" fmla="*/ 606392 w 781173"/>
                    <a:gd name="connsiteY9" fmla="*/ 9625 h 356134"/>
                    <a:gd name="connsiteX10" fmla="*/ 635267 w 781173"/>
                    <a:gd name="connsiteY10" fmla="*/ 0 h 356134"/>
                    <a:gd name="connsiteX11" fmla="*/ 750771 w 781173"/>
                    <a:gd name="connsiteY11" fmla="*/ 9625 h 356134"/>
                    <a:gd name="connsiteX12" fmla="*/ 779646 w 781173"/>
                    <a:gd name="connsiteY12" fmla="*/ 28875 h 356134"/>
                    <a:gd name="connsiteX13" fmla="*/ 731520 w 781173"/>
                    <a:gd name="connsiteY13" fmla="*/ 163629 h 356134"/>
                    <a:gd name="connsiteX14" fmla="*/ 702644 w 781173"/>
                    <a:gd name="connsiteY14" fmla="*/ 182880 h 356134"/>
                    <a:gd name="connsiteX15" fmla="*/ 625642 w 781173"/>
                    <a:gd name="connsiteY15" fmla="*/ 231006 h 356134"/>
                    <a:gd name="connsiteX16" fmla="*/ 596766 w 781173"/>
                    <a:gd name="connsiteY16" fmla="*/ 250256 h 356134"/>
                    <a:gd name="connsiteX17" fmla="*/ 539015 w 781173"/>
                    <a:gd name="connsiteY17" fmla="*/ 269507 h 356134"/>
                    <a:gd name="connsiteX18" fmla="*/ 452387 w 781173"/>
                    <a:gd name="connsiteY18" fmla="*/ 327259 h 356134"/>
                    <a:gd name="connsiteX19" fmla="*/ 423512 w 781173"/>
                    <a:gd name="connsiteY19" fmla="*/ 346509 h 356134"/>
                    <a:gd name="connsiteX20" fmla="*/ 394636 w 781173"/>
                    <a:gd name="connsiteY20" fmla="*/ 356134 h 356134"/>
                    <a:gd name="connsiteX21" fmla="*/ 327259 w 781173"/>
                    <a:gd name="connsiteY21" fmla="*/ 346509 h 356134"/>
                    <a:gd name="connsiteX22" fmla="*/ 269507 w 781173"/>
                    <a:gd name="connsiteY22" fmla="*/ 327259 h 356134"/>
                    <a:gd name="connsiteX23" fmla="*/ 105878 w 781173"/>
                    <a:gd name="connsiteY23" fmla="*/ 308008 h 356134"/>
                    <a:gd name="connsiteX24" fmla="*/ 0 w 781173"/>
                    <a:gd name="connsiteY24" fmla="*/ 298383 h 356134"/>
                    <a:gd name="connsiteX25" fmla="*/ 9625 w 781173"/>
                    <a:gd name="connsiteY25" fmla="*/ 269507 h 356134"/>
                    <a:gd name="connsiteX26" fmla="*/ 48126 w 781173"/>
                    <a:gd name="connsiteY26" fmla="*/ 259882 h 356134"/>
                    <a:gd name="connsiteX27" fmla="*/ 105878 w 781173"/>
                    <a:gd name="connsiteY27" fmla="*/ 240631 h 356134"/>
                    <a:gd name="connsiteX28" fmla="*/ 134754 w 781173"/>
                    <a:gd name="connsiteY28" fmla="*/ 231006 h 356134"/>
                    <a:gd name="connsiteX29" fmla="*/ 163630 w 781173"/>
                    <a:gd name="connsiteY29" fmla="*/ 221381 h 356134"/>
                    <a:gd name="connsiteX30" fmla="*/ 221381 w 781173"/>
                    <a:gd name="connsiteY30" fmla="*/ 192505 h 356134"/>
                    <a:gd name="connsiteX31" fmla="*/ 259882 w 781173"/>
                    <a:gd name="connsiteY31" fmla="*/ 192505 h 35613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</a:cxnLst>
                  <a:rect l="l" t="t" r="r" b="b"/>
                  <a:pathLst>
                    <a:path w="781173" h="356134">
                      <a:moveTo>
                        <a:pt x="259882" y="192505"/>
                      </a:moveTo>
                      <a:lnTo>
                        <a:pt x="259882" y="192505"/>
                      </a:lnTo>
                      <a:cubicBezTo>
                        <a:pt x="288758" y="195713"/>
                        <a:pt x="317925" y="207327"/>
                        <a:pt x="346510" y="202130"/>
                      </a:cubicBezTo>
                      <a:cubicBezTo>
                        <a:pt x="357891" y="200061"/>
                        <a:pt x="357580" y="181434"/>
                        <a:pt x="365760" y="173254"/>
                      </a:cubicBezTo>
                      <a:cubicBezTo>
                        <a:pt x="373940" y="165074"/>
                        <a:pt x="385011" y="160421"/>
                        <a:pt x="394636" y="154004"/>
                      </a:cubicBezTo>
                      <a:cubicBezTo>
                        <a:pt x="413564" y="125611"/>
                        <a:pt x="414970" y="119412"/>
                        <a:pt x="442762" y="96252"/>
                      </a:cubicBezTo>
                      <a:cubicBezTo>
                        <a:pt x="451649" y="88846"/>
                        <a:pt x="462013" y="83419"/>
                        <a:pt x="471638" y="77002"/>
                      </a:cubicBezTo>
                      <a:cubicBezTo>
                        <a:pt x="478055" y="67377"/>
                        <a:pt x="481079" y="54257"/>
                        <a:pt x="490889" y="48126"/>
                      </a:cubicBezTo>
                      <a:cubicBezTo>
                        <a:pt x="490894" y="48123"/>
                        <a:pt x="563075" y="24063"/>
                        <a:pt x="577516" y="19250"/>
                      </a:cubicBezTo>
                      <a:lnTo>
                        <a:pt x="606392" y="9625"/>
                      </a:lnTo>
                      <a:lnTo>
                        <a:pt x="635267" y="0"/>
                      </a:lnTo>
                      <a:cubicBezTo>
                        <a:pt x="673768" y="3208"/>
                        <a:pt x="712886" y="2048"/>
                        <a:pt x="750771" y="9625"/>
                      </a:cubicBezTo>
                      <a:cubicBezTo>
                        <a:pt x="762114" y="11894"/>
                        <a:pt x="777377" y="17532"/>
                        <a:pt x="779646" y="28875"/>
                      </a:cubicBezTo>
                      <a:cubicBezTo>
                        <a:pt x="787127" y="66279"/>
                        <a:pt x="766504" y="140306"/>
                        <a:pt x="731520" y="163629"/>
                      </a:cubicBezTo>
                      <a:lnTo>
                        <a:pt x="702644" y="182880"/>
                      </a:lnTo>
                      <a:cubicBezTo>
                        <a:pt x="656468" y="252143"/>
                        <a:pt x="721855" y="166866"/>
                        <a:pt x="625642" y="231006"/>
                      </a:cubicBezTo>
                      <a:cubicBezTo>
                        <a:pt x="616017" y="237423"/>
                        <a:pt x="607337" y="245558"/>
                        <a:pt x="596766" y="250256"/>
                      </a:cubicBezTo>
                      <a:cubicBezTo>
                        <a:pt x="578223" y="258497"/>
                        <a:pt x="539015" y="269507"/>
                        <a:pt x="539015" y="269507"/>
                      </a:cubicBezTo>
                      <a:lnTo>
                        <a:pt x="452387" y="327259"/>
                      </a:lnTo>
                      <a:cubicBezTo>
                        <a:pt x="442762" y="333676"/>
                        <a:pt x="434486" y="342851"/>
                        <a:pt x="423512" y="346509"/>
                      </a:cubicBezTo>
                      <a:lnTo>
                        <a:pt x="394636" y="356134"/>
                      </a:lnTo>
                      <a:cubicBezTo>
                        <a:pt x="372177" y="352926"/>
                        <a:pt x="349365" y="351610"/>
                        <a:pt x="327259" y="346509"/>
                      </a:cubicBezTo>
                      <a:cubicBezTo>
                        <a:pt x="307487" y="341946"/>
                        <a:pt x="289642" y="329776"/>
                        <a:pt x="269507" y="327259"/>
                      </a:cubicBezTo>
                      <a:cubicBezTo>
                        <a:pt x="208106" y="319583"/>
                        <a:pt x="168311" y="314251"/>
                        <a:pt x="105878" y="308008"/>
                      </a:cubicBezTo>
                      <a:lnTo>
                        <a:pt x="0" y="298383"/>
                      </a:lnTo>
                      <a:cubicBezTo>
                        <a:pt x="3208" y="288758"/>
                        <a:pt x="1702" y="275845"/>
                        <a:pt x="9625" y="269507"/>
                      </a:cubicBezTo>
                      <a:cubicBezTo>
                        <a:pt x="19955" y="261243"/>
                        <a:pt x="35455" y="263683"/>
                        <a:pt x="48126" y="259882"/>
                      </a:cubicBezTo>
                      <a:cubicBezTo>
                        <a:pt x="67562" y="254051"/>
                        <a:pt x="86627" y="247048"/>
                        <a:pt x="105878" y="240631"/>
                      </a:cubicBezTo>
                      <a:lnTo>
                        <a:pt x="134754" y="231006"/>
                      </a:lnTo>
                      <a:lnTo>
                        <a:pt x="163630" y="221381"/>
                      </a:lnTo>
                      <a:cubicBezTo>
                        <a:pt x="191861" y="202559"/>
                        <a:pt x="189499" y="200475"/>
                        <a:pt x="221381" y="192505"/>
                      </a:cubicBezTo>
                      <a:cubicBezTo>
                        <a:pt x="224494" y="191727"/>
                        <a:pt x="253465" y="192505"/>
                        <a:pt x="259882" y="192505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E77C316D-8921-6FA1-ABA3-481568B07725}"/>
                </a:ext>
              </a:extLst>
            </p:cNvPr>
            <p:cNvSpPr txBox="1"/>
            <p:nvPr/>
          </p:nvSpPr>
          <p:spPr>
            <a:xfrm>
              <a:off x="432902" y="623258"/>
              <a:ext cx="47220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/>
                <a:t>A.</a:t>
              </a: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EE671699-AD88-8F19-C56D-2107A6D96092}"/>
                </a:ext>
              </a:extLst>
            </p:cNvPr>
            <p:cNvGrpSpPr/>
            <p:nvPr/>
          </p:nvGrpSpPr>
          <p:grpSpPr>
            <a:xfrm>
              <a:off x="3130011" y="632638"/>
              <a:ext cx="6604015" cy="3852334"/>
              <a:chOff x="3220323" y="632638"/>
              <a:chExt cx="6604015" cy="3852334"/>
            </a:xfrm>
          </p:grpSpPr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2DF08B39-1D3B-E702-93DD-4A8A7C6A972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310359" y="978221"/>
                <a:ext cx="3315618" cy="3481851"/>
              </a:xfrm>
              <a:prstGeom prst="rect">
                <a:avLst/>
              </a:prstGeom>
            </p:spPr>
          </p:pic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E20DDF7F-1EDA-5940-1FA8-150BBE02ED57}"/>
                  </a:ext>
                </a:extLst>
              </p:cNvPr>
              <p:cNvSpPr/>
              <p:nvPr/>
            </p:nvSpPr>
            <p:spPr>
              <a:xfrm>
                <a:off x="3651882" y="1441709"/>
                <a:ext cx="1322024" cy="1487277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8B6FE3FA-2127-ABCC-9E83-967EF1AD99D7}"/>
                  </a:ext>
                </a:extLst>
              </p:cNvPr>
              <p:cNvCxnSpPr/>
              <p:nvPr/>
            </p:nvCxnSpPr>
            <p:spPr>
              <a:xfrm flipV="1">
                <a:off x="4968168" y="978221"/>
                <a:ext cx="1749588" cy="46348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>
                <a:extLst>
                  <a:ext uri="{FF2B5EF4-FFF2-40B4-BE49-F238E27FC236}">
                    <a16:creationId xmlns:a16="http://schemas.microsoft.com/office/drawing/2014/main" id="{086AD1DE-C233-D1DC-B8CB-99CD68E297EA}"/>
                  </a:ext>
                </a:extLst>
              </p:cNvPr>
              <p:cNvCxnSpPr/>
              <p:nvPr/>
            </p:nvCxnSpPr>
            <p:spPr>
              <a:xfrm>
                <a:off x="4968168" y="2928986"/>
                <a:ext cx="1749588" cy="155598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0291831E-139B-24DD-5315-4E9A730ABBDA}"/>
                  </a:ext>
                </a:extLst>
              </p:cNvPr>
              <p:cNvSpPr txBox="1"/>
              <p:nvPr/>
            </p:nvSpPr>
            <p:spPr>
              <a:xfrm>
                <a:off x="3220323" y="632638"/>
                <a:ext cx="47220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B.</a:t>
                </a:r>
              </a:p>
            </p:txBody>
          </p:sp>
          <p:grpSp>
            <p:nvGrpSpPr>
              <p:cNvPr id="51" name="Group 50">
                <a:extLst>
                  <a:ext uri="{FF2B5EF4-FFF2-40B4-BE49-F238E27FC236}">
                    <a16:creationId xmlns:a16="http://schemas.microsoft.com/office/drawing/2014/main" id="{1A1DFE69-6DBB-A461-590E-3737811E5E74}"/>
                  </a:ext>
                </a:extLst>
              </p:cNvPr>
              <p:cNvGrpSpPr/>
              <p:nvPr/>
            </p:nvGrpSpPr>
            <p:grpSpPr>
              <a:xfrm>
                <a:off x="6717756" y="978221"/>
                <a:ext cx="3106582" cy="3487627"/>
                <a:chOff x="3896336" y="896307"/>
                <a:chExt cx="3106582" cy="3487627"/>
              </a:xfrm>
            </p:grpSpPr>
            <p:pic>
              <p:nvPicPr>
                <p:cNvPr id="48" name="Picture 47">
                  <a:extLst>
                    <a:ext uri="{FF2B5EF4-FFF2-40B4-BE49-F238E27FC236}">
                      <a16:creationId xmlns:a16="http://schemas.microsoft.com/office/drawing/2014/main" id="{100CB7C9-8C56-356F-AAB7-C6837F89139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 cstate="screen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3896336" y="902084"/>
                  <a:ext cx="3106582" cy="3481850"/>
                </a:xfrm>
                <a:prstGeom prst="rect">
                  <a:avLst/>
                </a:prstGeom>
                <a:ln w="19050">
                  <a:solidFill>
                    <a:schemeClr val="tx1"/>
                  </a:solidFill>
                </a:ln>
              </p:spPr>
            </p:pic>
            <p:sp>
              <p:nvSpPr>
                <p:cNvPr id="11" name="Freeform 10">
                  <a:extLst>
                    <a:ext uri="{FF2B5EF4-FFF2-40B4-BE49-F238E27FC236}">
                      <a16:creationId xmlns:a16="http://schemas.microsoft.com/office/drawing/2014/main" id="{CDDC49E9-68D7-1B02-72A0-0996AC7E2187}"/>
                    </a:ext>
                  </a:extLst>
                </p:cNvPr>
                <p:cNvSpPr/>
                <p:nvPr/>
              </p:nvSpPr>
              <p:spPr>
                <a:xfrm>
                  <a:off x="4350235" y="896307"/>
                  <a:ext cx="1176098" cy="1012503"/>
                </a:xfrm>
                <a:custGeom>
                  <a:avLst/>
                  <a:gdLst>
                    <a:gd name="connsiteX0" fmla="*/ 157036 w 729604"/>
                    <a:gd name="connsiteY0" fmla="*/ 316195 h 628116"/>
                    <a:gd name="connsiteX1" fmla="*/ 157036 w 729604"/>
                    <a:gd name="connsiteY1" fmla="*/ 316195 h 628116"/>
                    <a:gd name="connsiteX2" fmla="*/ 127126 w 729604"/>
                    <a:gd name="connsiteY2" fmla="*/ 358924 h 628116"/>
                    <a:gd name="connsiteX3" fmla="*/ 110034 w 729604"/>
                    <a:gd name="connsiteY3" fmla="*/ 384561 h 628116"/>
                    <a:gd name="connsiteX4" fmla="*/ 101489 w 729604"/>
                    <a:gd name="connsiteY4" fmla="*/ 397380 h 628116"/>
                    <a:gd name="connsiteX5" fmla="*/ 92943 w 729604"/>
                    <a:gd name="connsiteY5" fmla="*/ 423017 h 628116"/>
                    <a:gd name="connsiteX6" fmla="*/ 80124 w 729604"/>
                    <a:gd name="connsiteY6" fmla="*/ 448654 h 628116"/>
                    <a:gd name="connsiteX7" fmla="*/ 75851 w 729604"/>
                    <a:gd name="connsiteY7" fmla="*/ 487110 h 628116"/>
                    <a:gd name="connsiteX8" fmla="*/ 37395 w 729604"/>
                    <a:gd name="connsiteY8" fmla="*/ 529839 h 628116"/>
                    <a:gd name="connsiteX9" fmla="*/ 24576 w 729604"/>
                    <a:gd name="connsiteY9" fmla="*/ 534112 h 628116"/>
                    <a:gd name="connsiteX10" fmla="*/ 11758 w 729604"/>
                    <a:gd name="connsiteY10" fmla="*/ 542658 h 628116"/>
                    <a:gd name="connsiteX11" fmla="*/ 7485 w 729604"/>
                    <a:gd name="connsiteY11" fmla="*/ 628116 h 628116"/>
                    <a:gd name="connsiteX12" fmla="*/ 20303 w 729604"/>
                    <a:gd name="connsiteY12" fmla="*/ 602479 h 628116"/>
                    <a:gd name="connsiteX13" fmla="*/ 41668 w 729604"/>
                    <a:gd name="connsiteY13" fmla="*/ 576841 h 628116"/>
                    <a:gd name="connsiteX14" fmla="*/ 54487 w 729604"/>
                    <a:gd name="connsiteY14" fmla="*/ 568295 h 628116"/>
                    <a:gd name="connsiteX15" fmla="*/ 63032 w 729604"/>
                    <a:gd name="connsiteY15" fmla="*/ 555477 h 628116"/>
                    <a:gd name="connsiteX16" fmla="*/ 75851 w 729604"/>
                    <a:gd name="connsiteY16" fmla="*/ 546931 h 628116"/>
                    <a:gd name="connsiteX17" fmla="*/ 80124 w 729604"/>
                    <a:gd name="connsiteY17" fmla="*/ 534112 h 628116"/>
                    <a:gd name="connsiteX18" fmla="*/ 92943 w 729604"/>
                    <a:gd name="connsiteY18" fmla="*/ 521294 h 628116"/>
                    <a:gd name="connsiteX19" fmla="*/ 101489 w 729604"/>
                    <a:gd name="connsiteY19" fmla="*/ 495656 h 628116"/>
                    <a:gd name="connsiteX20" fmla="*/ 118580 w 729604"/>
                    <a:gd name="connsiteY20" fmla="*/ 470019 h 628116"/>
                    <a:gd name="connsiteX21" fmla="*/ 127126 w 729604"/>
                    <a:gd name="connsiteY21" fmla="*/ 457200 h 628116"/>
                    <a:gd name="connsiteX22" fmla="*/ 135672 w 729604"/>
                    <a:gd name="connsiteY22" fmla="*/ 431563 h 628116"/>
                    <a:gd name="connsiteX23" fmla="*/ 144218 w 729604"/>
                    <a:gd name="connsiteY23" fmla="*/ 388834 h 628116"/>
                    <a:gd name="connsiteX24" fmla="*/ 148490 w 729604"/>
                    <a:gd name="connsiteY24" fmla="*/ 376015 h 628116"/>
                    <a:gd name="connsiteX25" fmla="*/ 161309 w 729604"/>
                    <a:gd name="connsiteY25" fmla="*/ 367469 h 628116"/>
                    <a:gd name="connsiteX26" fmla="*/ 191219 w 729604"/>
                    <a:gd name="connsiteY26" fmla="*/ 337559 h 628116"/>
                    <a:gd name="connsiteX27" fmla="*/ 212584 w 729604"/>
                    <a:gd name="connsiteY27" fmla="*/ 316195 h 628116"/>
                    <a:gd name="connsiteX28" fmla="*/ 221130 w 729604"/>
                    <a:gd name="connsiteY28" fmla="*/ 303376 h 628116"/>
                    <a:gd name="connsiteX29" fmla="*/ 246767 w 729604"/>
                    <a:gd name="connsiteY29" fmla="*/ 286284 h 628116"/>
                    <a:gd name="connsiteX30" fmla="*/ 255313 w 729604"/>
                    <a:gd name="connsiteY30" fmla="*/ 273466 h 628116"/>
                    <a:gd name="connsiteX31" fmla="*/ 293769 w 729604"/>
                    <a:gd name="connsiteY31" fmla="*/ 252101 h 628116"/>
                    <a:gd name="connsiteX32" fmla="*/ 340771 w 729604"/>
                    <a:gd name="connsiteY32" fmla="*/ 209372 h 628116"/>
                    <a:gd name="connsiteX33" fmla="*/ 353589 w 729604"/>
                    <a:gd name="connsiteY33" fmla="*/ 205099 h 628116"/>
                    <a:gd name="connsiteX34" fmla="*/ 379227 w 729604"/>
                    <a:gd name="connsiteY34" fmla="*/ 188008 h 628116"/>
                    <a:gd name="connsiteX35" fmla="*/ 392046 w 729604"/>
                    <a:gd name="connsiteY35" fmla="*/ 179462 h 628116"/>
                    <a:gd name="connsiteX36" fmla="*/ 430502 w 729604"/>
                    <a:gd name="connsiteY36" fmla="*/ 162370 h 628116"/>
                    <a:gd name="connsiteX37" fmla="*/ 443320 w 729604"/>
                    <a:gd name="connsiteY37" fmla="*/ 158097 h 628116"/>
                    <a:gd name="connsiteX38" fmla="*/ 468958 w 729604"/>
                    <a:gd name="connsiteY38" fmla="*/ 141006 h 628116"/>
                    <a:gd name="connsiteX39" fmla="*/ 494595 w 729604"/>
                    <a:gd name="connsiteY39" fmla="*/ 128187 h 628116"/>
                    <a:gd name="connsiteX40" fmla="*/ 507414 w 729604"/>
                    <a:gd name="connsiteY40" fmla="*/ 123914 h 628116"/>
                    <a:gd name="connsiteX41" fmla="*/ 520232 w 729604"/>
                    <a:gd name="connsiteY41" fmla="*/ 115368 h 628116"/>
                    <a:gd name="connsiteX42" fmla="*/ 545870 w 729604"/>
                    <a:gd name="connsiteY42" fmla="*/ 106823 h 628116"/>
                    <a:gd name="connsiteX43" fmla="*/ 571507 w 729604"/>
                    <a:gd name="connsiteY43" fmla="*/ 89731 h 628116"/>
                    <a:gd name="connsiteX44" fmla="*/ 627055 w 729604"/>
                    <a:gd name="connsiteY44" fmla="*/ 64094 h 628116"/>
                    <a:gd name="connsiteX45" fmla="*/ 639874 w 729604"/>
                    <a:gd name="connsiteY45" fmla="*/ 55548 h 628116"/>
                    <a:gd name="connsiteX46" fmla="*/ 665511 w 729604"/>
                    <a:gd name="connsiteY46" fmla="*/ 47002 h 628116"/>
                    <a:gd name="connsiteX47" fmla="*/ 691148 w 729604"/>
                    <a:gd name="connsiteY47" fmla="*/ 34183 h 628116"/>
                    <a:gd name="connsiteX48" fmla="*/ 703967 w 729604"/>
                    <a:gd name="connsiteY48" fmla="*/ 25638 h 628116"/>
                    <a:gd name="connsiteX49" fmla="*/ 729604 w 729604"/>
                    <a:gd name="connsiteY49" fmla="*/ 17092 h 628116"/>
                    <a:gd name="connsiteX50" fmla="*/ 716786 w 729604"/>
                    <a:gd name="connsiteY50" fmla="*/ 8546 h 628116"/>
                    <a:gd name="connsiteX51" fmla="*/ 674057 w 729604"/>
                    <a:gd name="connsiteY51" fmla="*/ 0 h 628116"/>
                    <a:gd name="connsiteX52" fmla="*/ 601418 w 729604"/>
                    <a:gd name="connsiteY52" fmla="*/ 4273 h 628116"/>
                    <a:gd name="connsiteX53" fmla="*/ 575780 w 729604"/>
                    <a:gd name="connsiteY53" fmla="*/ 21365 h 628116"/>
                    <a:gd name="connsiteX54" fmla="*/ 554416 w 729604"/>
                    <a:gd name="connsiteY54" fmla="*/ 38456 h 628116"/>
                    <a:gd name="connsiteX55" fmla="*/ 541597 w 729604"/>
                    <a:gd name="connsiteY55" fmla="*/ 47002 h 628116"/>
                    <a:gd name="connsiteX56" fmla="*/ 477503 w 729604"/>
                    <a:gd name="connsiteY56" fmla="*/ 59821 h 628116"/>
                    <a:gd name="connsiteX57" fmla="*/ 447593 w 729604"/>
                    <a:gd name="connsiteY57" fmla="*/ 68367 h 628116"/>
                    <a:gd name="connsiteX58" fmla="*/ 434775 w 729604"/>
                    <a:gd name="connsiteY58" fmla="*/ 76912 h 628116"/>
                    <a:gd name="connsiteX59" fmla="*/ 421956 w 729604"/>
                    <a:gd name="connsiteY59" fmla="*/ 102550 h 628116"/>
                    <a:gd name="connsiteX60" fmla="*/ 409137 w 729604"/>
                    <a:gd name="connsiteY60" fmla="*/ 111095 h 628116"/>
                    <a:gd name="connsiteX61" fmla="*/ 396318 w 729604"/>
                    <a:gd name="connsiteY61" fmla="*/ 136733 h 628116"/>
                    <a:gd name="connsiteX62" fmla="*/ 383500 w 729604"/>
                    <a:gd name="connsiteY62" fmla="*/ 141006 h 628116"/>
                    <a:gd name="connsiteX63" fmla="*/ 357862 w 729604"/>
                    <a:gd name="connsiteY63" fmla="*/ 162370 h 628116"/>
                    <a:gd name="connsiteX64" fmla="*/ 345044 w 729604"/>
                    <a:gd name="connsiteY64" fmla="*/ 166643 h 628116"/>
                    <a:gd name="connsiteX65" fmla="*/ 319406 w 729604"/>
                    <a:gd name="connsiteY65" fmla="*/ 188008 h 628116"/>
                    <a:gd name="connsiteX66" fmla="*/ 306588 w 729604"/>
                    <a:gd name="connsiteY66" fmla="*/ 192281 h 628116"/>
                    <a:gd name="connsiteX67" fmla="*/ 280950 w 729604"/>
                    <a:gd name="connsiteY67" fmla="*/ 209372 h 628116"/>
                    <a:gd name="connsiteX68" fmla="*/ 255313 w 729604"/>
                    <a:gd name="connsiteY68" fmla="*/ 217918 h 628116"/>
                    <a:gd name="connsiteX69" fmla="*/ 242494 w 729604"/>
                    <a:gd name="connsiteY69" fmla="*/ 222191 h 628116"/>
                    <a:gd name="connsiteX70" fmla="*/ 225403 w 729604"/>
                    <a:gd name="connsiteY70" fmla="*/ 226464 h 628116"/>
                    <a:gd name="connsiteX71" fmla="*/ 204038 w 729604"/>
                    <a:gd name="connsiteY71" fmla="*/ 230737 h 628116"/>
                    <a:gd name="connsiteX72" fmla="*/ 191219 w 729604"/>
                    <a:gd name="connsiteY72" fmla="*/ 235009 h 628116"/>
                    <a:gd name="connsiteX73" fmla="*/ 186946 w 729604"/>
                    <a:gd name="connsiteY73" fmla="*/ 247828 h 628116"/>
                    <a:gd name="connsiteX74" fmla="*/ 178401 w 729604"/>
                    <a:gd name="connsiteY74" fmla="*/ 260647 h 628116"/>
                    <a:gd name="connsiteX75" fmla="*/ 157036 w 729604"/>
                    <a:gd name="connsiteY75" fmla="*/ 316195 h 62811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</a:cxnLst>
                  <a:rect l="l" t="t" r="r" b="b"/>
                  <a:pathLst>
                    <a:path w="729604" h="628116">
                      <a:moveTo>
                        <a:pt x="157036" y="316195"/>
                      </a:moveTo>
                      <a:lnTo>
                        <a:pt x="157036" y="316195"/>
                      </a:lnTo>
                      <a:lnTo>
                        <a:pt x="127126" y="358924"/>
                      </a:lnTo>
                      <a:cubicBezTo>
                        <a:pt x="127102" y="358959"/>
                        <a:pt x="110057" y="384526"/>
                        <a:pt x="110034" y="384561"/>
                      </a:cubicBezTo>
                      <a:cubicBezTo>
                        <a:pt x="107186" y="388834"/>
                        <a:pt x="103113" y="392508"/>
                        <a:pt x="101489" y="397380"/>
                      </a:cubicBezTo>
                      <a:cubicBezTo>
                        <a:pt x="98640" y="405926"/>
                        <a:pt x="97940" y="415522"/>
                        <a:pt x="92943" y="423017"/>
                      </a:cubicBezTo>
                      <a:cubicBezTo>
                        <a:pt x="81899" y="439583"/>
                        <a:pt x="86021" y="430964"/>
                        <a:pt x="80124" y="448654"/>
                      </a:cubicBezTo>
                      <a:cubicBezTo>
                        <a:pt x="78700" y="461473"/>
                        <a:pt x="77971" y="474388"/>
                        <a:pt x="75851" y="487110"/>
                      </a:cubicBezTo>
                      <a:cubicBezTo>
                        <a:pt x="72598" y="506626"/>
                        <a:pt x="55823" y="523696"/>
                        <a:pt x="37395" y="529839"/>
                      </a:cubicBezTo>
                      <a:lnTo>
                        <a:pt x="24576" y="534112"/>
                      </a:lnTo>
                      <a:cubicBezTo>
                        <a:pt x="20303" y="536961"/>
                        <a:pt x="15389" y="539027"/>
                        <a:pt x="11758" y="542658"/>
                      </a:cubicBezTo>
                      <a:cubicBezTo>
                        <a:pt x="-10853" y="565270"/>
                        <a:pt x="5797" y="599412"/>
                        <a:pt x="7485" y="628116"/>
                      </a:cubicBezTo>
                      <a:cubicBezTo>
                        <a:pt x="31978" y="591376"/>
                        <a:pt x="2613" y="637860"/>
                        <a:pt x="20303" y="602479"/>
                      </a:cubicBezTo>
                      <a:cubicBezTo>
                        <a:pt x="25104" y="592876"/>
                        <a:pt x="33568" y="583591"/>
                        <a:pt x="41668" y="576841"/>
                      </a:cubicBezTo>
                      <a:cubicBezTo>
                        <a:pt x="45613" y="573553"/>
                        <a:pt x="50214" y="571144"/>
                        <a:pt x="54487" y="568295"/>
                      </a:cubicBezTo>
                      <a:cubicBezTo>
                        <a:pt x="57335" y="564022"/>
                        <a:pt x="59401" y="559108"/>
                        <a:pt x="63032" y="555477"/>
                      </a:cubicBezTo>
                      <a:cubicBezTo>
                        <a:pt x="66663" y="551846"/>
                        <a:pt x="72643" y="550941"/>
                        <a:pt x="75851" y="546931"/>
                      </a:cubicBezTo>
                      <a:cubicBezTo>
                        <a:pt x="78665" y="543414"/>
                        <a:pt x="77625" y="537860"/>
                        <a:pt x="80124" y="534112"/>
                      </a:cubicBezTo>
                      <a:cubicBezTo>
                        <a:pt x="83476" y="529084"/>
                        <a:pt x="88670" y="525567"/>
                        <a:pt x="92943" y="521294"/>
                      </a:cubicBezTo>
                      <a:cubicBezTo>
                        <a:pt x="95792" y="512748"/>
                        <a:pt x="96492" y="503151"/>
                        <a:pt x="101489" y="495656"/>
                      </a:cubicBezTo>
                      <a:lnTo>
                        <a:pt x="118580" y="470019"/>
                      </a:lnTo>
                      <a:cubicBezTo>
                        <a:pt x="121429" y="465746"/>
                        <a:pt x="125502" y="462072"/>
                        <a:pt x="127126" y="457200"/>
                      </a:cubicBezTo>
                      <a:lnTo>
                        <a:pt x="135672" y="431563"/>
                      </a:lnTo>
                      <a:cubicBezTo>
                        <a:pt x="139031" y="411408"/>
                        <a:pt x="139117" y="406688"/>
                        <a:pt x="144218" y="388834"/>
                      </a:cubicBezTo>
                      <a:cubicBezTo>
                        <a:pt x="145455" y="384503"/>
                        <a:pt x="145676" y="379532"/>
                        <a:pt x="148490" y="376015"/>
                      </a:cubicBezTo>
                      <a:cubicBezTo>
                        <a:pt x="151698" y="372005"/>
                        <a:pt x="157036" y="370318"/>
                        <a:pt x="161309" y="367469"/>
                      </a:cubicBezTo>
                      <a:cubicBezTo>
                        <a:pt x="180899" y="338085"/>
                        <a:pt x="168657" y="345080"/>
                        <a:pt x="191219" y="337559"/>
                      </a:cubicBezTo>
                      <a:cubicBezTo>
                        <a:pt x="214009" y="303374"/>
                        <a:pt x="184097" y="344681"/>
                        <a:pt x="212584" y="316195"/>
                      </a:cubicBezTo>
                      <a:cubicBezTo>
                        <a:pt x="216215" y="312564"/>
                        <a:pt x="217265" y="306758"/>
                        <a:pt x="221130" y="303376"/>
                      </a:cubicBezTo>
                      <a:cubicBezTo>
                        <a:pt x="228859" y="296613"/>
                        <a:pt x="246767" y="286284"/>
                        <a:pt x="246767" y="286284"/>
                      </a:cubicBezTo>
                      <a:cubicBezTo>
                        <a:pt x="249616" y="282011"/>
                        <a:pt x="251448" y="276848"/>
                        <a:pt x="255313" y="273466"/>
                      </a:cubicBezTo>
                      <a:cubicBezTo>
                        <a:pt x="273397" y="257642"/>
                        <a:pt x="276162" y="257970"/>
                        <a:pt x="293769" y="252101"/>
                      </a:cubicBezTo>
                      <a:cubicBezTo>
                        <a:pt x="304154" y="241716"/>
                        <a:pt x="323286" y="218115"/>
                        <a:pt x="340771" y="209372"/>
                      </a:cubicBezTo>
                      <a:cubicBezTo>
                        <a:pt x="344799" y="207358"/>
                        <a:pt x="349652" y="207286"/>
                        <a:pt x="353589" y="205099"/>
                      </a:cubicBezTo>
                      <a:cubicBezTo>
                        <a:pt x="362567" y="200111"/>
                        <a:pt x="370681" y="193705"/>
                        <a:pt x="379227" y="188008"/>
                      </a:cubicBezTo>
                      <a:cubicBezTo>
                        <a:pt x="383500" y="185159"/>
                        <a:pt x="387174" y="181086"/>
                        <a:pt x="392046" y="179462"/>
                      </a:cubicBezTo>
                      <a:cubicBezTo>
                        <a:pt x="458181" y="157416"/>
                        <a:pt x="389877" y="182683"/>
                        <a:pt x="430502" y="162370"/>
                      </a:cubicBezTo>
                      <a:cubicBezTo>
                        <a:pt x="434530" y="160356"/>
                        <a:pt x="439383" y="160284"/>
                        <a:pt x="443320" y="158097"/>
                      </a:cubicBezTo>
                      <a:cubicBezTo>
                        <a:pt x="452298" y="153109"/>
                        <a:pt x="459214" y="144254"/>
                        <a:pt x="468958" y="141006"/>
                      </a:cubicBezTo>
                      <a:cubicBezTo>
                        <a:pt x="501179" y="130265"/>
                        <a:pt x="461460" y="144755"/>
                        <a:pt x="494595" y="128187"/>
                      </a:cubicBezTo>
                      <a:cubicBezTo>
                        <a:pt x="498624" y="126173"/>
                        <a:pt x="503141" y="125338"/>
                        <a:pt x="507414" y="123914"/>
                      </a:cubicBezTo>
                      <a:cubicBezTo>
                        <a:pt x="511687" y="121065"/>
                        <a:pt x="515539" y="117454"/>
                        <a:pt x="520232" y="115368"/>
                      </a:cubicBezTo>
                      <a:cubicBezTo>
                        <a:pt x="528464" y="111710"/>
                        <a:pt x="545870" y="106823"/>
                        <a:pt x="545870" y="106823"/>
                      </a:cubicBezTo>
                      <a:cubicBezTo>
                        <a:pt x="554416" y="101126"/>
                        <a:pt x="561763" y="92979"/>
                        <a:pt x="571507" y="89731"/>
                      </a:cubicBezTo>
                      <a:cubicBezTo>
                        <a:pt x="592820" y="82627"/>
                        <a:pt x="603678" y="79679"/>
                        <a:pt x="627055" y="64094"/>
                      </a:cubicBezTo>
                      <a:cubicBezTo>
                        <a:pt x="631328" y="61245"/>
                        <a:pt x="635181" y="57634"/>
                        <a:pt x="639874" y="55548"/>
                      </a:cubicBezTo>
                      <a:cubicBezTo>
                        <a:pt x="648106" y="51889"/>
                        <a:pt x="658016" y="51999"/>
                        <a:pt x="665511" y="47002"/>
                      </a:cubicBezTo>
                      <a:cubicBezTo>
                        <a:pt x="702241" y="22516"/>
                        <a:pt x="655775" y="51869"/>
                        <a:pt x="691148" y="34183"/>
                      </a:cubicBezTo>
                      <a:cubicBezTo>
                        <a:pt x="695741" y="31886"/>
                        <a:pt x="699274" y="27724"/>
                        <a:pt x="703967" y="25638"/>
                      </a:cubicBezTo>
                      <a:cubicBezTo>
                        <a:pt x="712199" y="21980"/>
                        <a:pt x="729604" y="17092"/>
                        <a:pt x="729604" y="17092"/>
                      </a:cubicBezTo>
                      <a:cubicBezTo>
                        <a:pt x="725331" y="14243"/>
                        <a:pt x="721506" y="10569"/>
                        <a:pt x="716786" y="8546"/>
                      </a:cubicBezTo>
                      <a:cubicBezTo>
                        <a:pt x="708674" y="5069"/>
                        <a:pt x="679840" y="964"/>
                        <a:pt x="674057" y="0"/>
                      </a:cubicBezTo>
                      <a:cubicBezTo>
                        <a:pt x="649844" y="1424"/>
                        <a:pt x="625119" y="-880"/>
                        <a:pt x="601418" y="4273"/>
                      </a:cubicBezTo>
                      <a:cubicBezTo>
                        <a:pt x="591381" y="6455"/>
                        <a:pt x="575780" y="21365"/>
                        <a:pt x="575780" y="21365"/>
                      </a:cubicBezTo>
                      <a:cubicBezTo>
                        <a:pt x="561374" y="42973"/>
                        <a:pt x="575054" y="28136"/>
                        <a:pt x="554416" y="38456"/>
                      </a:cubicBezTo>
                      <a:cubicBezTo>
                        <a:pt x="549823" y="40753"/>
                        <a:pt x="546290" y="44916"/>
                        <a:pt x="541597" y="47002"/>
                      </a:cubicBezTo>
                      <a:cubicBezTo>
                        <a:pt x="516348" y="58224"/>
                        <a:pt x="506838" y="56562"/>
                        <a:pt x="477503" y="59821"/>
                      </a:cubicBezTo>
                      <a:cubicBezTo>
                        <a:pt x="472027" y="61190"/>
                        <a:pt x="453723" y="65302"/>
                        <a:pt x="447593" y="68367"/>
                      </a:cubicBezTo>
                      <a:cubicBezTo>
                        <a:pt x="443000" y="70663"/>
                        <a:pt x="439048" y="74064"/>
                        <a:pt x="434775" y="76912"/>
                      </a:cubicBezTo>
                      <a:cubicBezTo>
                        <a:pt x="431300" y="87337"/>
                        <a:pt x="430239" y="94267"/>
                        <a:pt x="421956" y="102550"/>
                      </a:cubicBezTo>
                      <a:cubicBezTo>
                        <a:pt x="418325" y="106181"/>
                        <a:pt x="413410" y="108247"/>
                        <a:pt x="409137" y="111095"/>
                      </a:cubicBezTo>
                      <a:cubicBezTo>
                        <a:pt x="406322" y="119540"/>
                        <a:pt x="403848" y="130708"/>
                        <a:pt x="396318" y="136733"/>
                      </a:cubicBezTo>
                      <a:cubicBezTo>
                        <a:pt x="392801" y="139547"/>
                        <a:pt x="387773" y="139582"/>
                        <a:pt x="383500" y="141006"/>
                      </a:cubicBezTo>
                      <a:cubicBezTo>
                        <a:pt x="374050" y="150455"/>
                        <a:pt x="369759" y="156421"/>
                        <a:pt x="357862" y="162370"/>
                      </a:cubicBezTo>
                      <a:cubicBezTo>
                        <a:pt x="353834" y="164384"/>
                        <a:pt x="349072" y="164629"/>
                        <a:pt x="345044" y="166643"/>
                      </a:cubicBezTo>
                      <a:cubicBezTo>
                        <a:pt x="317084" y="180623"/>
                        <a:pt x="347756" y="169107"/>
                        <a:pt x="319406" y="188008"/>
                      </a:cubicBezTo>
                      <a:cubicBezTo>
                        <a:pt x="315659" y="190506"/>
                        <a:pt x="310525" y="190094"/>
                        <a:pt x="306588" y="192281"/>
                      </a:cubicBezTo>
                      <a:cubicBezTo>
                        <a:pt x="297610" y="197269"/>
                        <a:pt x="290694" y="206124"/>
                        <a:pt x="280950" y="209372"/>
                      </a:cubicBezTo>
                      <a:lnTo>
                        <a:pt x="255313" y="217918"/>
                      </a:lnTo>
                      <a:cubicBezTo>
                        <a:pt x="251040" y="219342"/>
                        <a:pt x="246864" y="221099"/>
                        <a:pt x="242494" y="222191"/>
                      </a:cubicBezTo>
                      <a:cubicBezTo>
                        <a:pt x="236797" y="223615"/>
                        <a:pt x="231136" y="225190"/>
                        <a:pt x="225403" y="226464"/>
                      </a:cubicBezTo>
                      <a:cubicBezTo>
                        <a:pt x="218313" y="228040"/>
                        <a:pt x="211084" y="228976"/>
                        <a:pt x="204038" y="230737"/>
                      </a:cubicBezTo>
                      <a:cubicBezTo>
                        <a:pt x="199668" y="231829"/>
                        <a:pt x="195492" y="233585"/>
                        <a:pt x="191219" y="235009"/>
                      </a:cubicBezTo>
                      <a:cubicBezTo>
                        <a:pt x="189795" y="239282"/>
                        <a:pt x="188960" y="243799"/>
                        <a:pt x="186946" y="247828"/>
                      </a:cubicBezTo>
                      <a:cubicBezTo>
                        <a:pt x="184650" y="252421"/>
                        <a:pt x="179408" y="255611"/>
                        <a:pt x="178401" y="260647"/>
                      </a:cubicBezTo>
                      <a:cubicBezTo>
                        <a:pt x="176446" y="270423"/>
                        <a:pt x="178401" y="280587"/>
                        <a:pt x="157036" y="316195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accent4"/>
                    </a:solidFill>
                  </a:endParaRPr>
                </a:p>
              </p:txBody>
            </p:sp>
            <p:sp>
              <p:nvSpPr>
                <p:cNvPr id="12" name="Freeform 11">
                  <a:extLst>
                    <a:ext uri="{FF2B5EF4-FFF2-40B4-BE49-F238E27FC236}">
                      <a16:creationId xmlns:a16="http://schemas.microsoft.com/office/drawing/2014/main" id="{0EF44432-C1A1-6822-BD7A-463B98EA04C0}"/>
                    </a:ext>
                  </a:extLst>
                </p:cNvPr>
                <p:cNvSpPr/>
                <p:nvPr/>
              </p:nvSpPr>
              <p:spPr>
                <a:xfrm>
                  <a:off x="5780906" y="1154599"/>
                  <a:ext cx="587844" cy="420154"/>
                </a:xfrm>
                <a:custGeom>
                  <a:avLst/>
                  <a:gdLst>
                    <a:gd name="connsiteX0" fmla="*/ 0 w 364675"/>
                    <a:gd name="connsiteY0" fmla="*/ 29910 h 260647"/>
                    <a:gd name="connsiteX1" fmla="*/ 0 w 364675"/>
                    <a:gd name="connsiteY1" fmla="*/ 29910 h 260647"/>
                    <a:gd name="connsiteX2" fmla="*/ 38456 w 364675"/>
                    <a:gd name="connsiteY2" fmla="*/ 21364 h 260647"/>
                    <a:gd name="connsiteX3" fmla="*/ 64093 w 364675"/>
                    <a:gd name="connsiteY3" fmla="*/ 8546 h 260647"/>
                    <a:gd name="connsiteX4" fmla="*/ 102549 w 364675"/>
                    <a:gd name="connsiteY4" fmla="*/ 0 h 260647"/>
                    <a:gd name="connsiteX5" fmla="*/ 183734 w 364675"/>
                    <a:gd name="connsiteY5" fmla="*/ 4273 h 260647"/>
                    <a:gd name="connsiteX6" fmla="*/ 200826 w 364675"/>
                    <a:gd name="connsiteY6" fmla="*/ 8546 h 260647"/>
                    <a:gd name="connsiteX7" fmla="*/ 269192 w 364675"/>
                    <a:gd name="connsiteY7" fmla="*/ 17092 h 260647"/>
                    <a:gd name="connsiteX8" fmla="*/ 294829 w 364675"/>
                    <a:gd name="connsiteY8" fmla="*/ 25637 h 260647"/>
                    <a:gd name="connsiteX9" fmla="*/ 324740 w 364675"/>
                    <a:gd name="connsiteY9" fmla="*/ 42729 h 260647"/>
                    <a:gd name="connsiteX10" fmla="*/ 333286 w 364675"/>
                    <a:gd name="connsiteY10" fmla="*/ 55548 h 260647"/>
                    <a:gd name="connsiteX11" fmla="*/ 358923 w 364675"/>
                    <a:gd name="connsiteY11" fmla="*/ 81185 h 260647"/>
                    <a:gd name="connsiteX12" fmla="*/ 358923 w 364675"/>
                    <a:gd name="connsiteY12" fmla="*/ 136733 h 260647"/>
                    <a:gd name="connsiteX13" fmla="*/ 341831 w 364675"/>
                    <a:gd name="connsiteY13" fmla="*/ 179462 h 260647"/>
                    <a:gd name="connsiteX14" fmla="*/ 333286 w 364675"/>
                    <a:gd name="connsiteY14" fmla="*/ 205099 h 260647"/>
                    <a:gd name="connsiteX15" fmla="*/ 329013 w 364675"/>
                    <a:gd name="connsiteY15" fmla="*/ 217918 h 260647"/>
                    <a:gd name="connsiteX16" fmla="*/ 324740 w 364675"/>
                    <a:gd name="connsiteY16" fmla="*/ 230736 h 260647"/>
                    <a:gd name="connsiteX17" fmla="*/ 311921 w 364675"/>
                    <a:gd name="connsiteY17" fmla="*/ 243555 h 260647"/>
                    <a:gd name="connsiteX18" fmla="*/ 290557 w 364675"/>
                    <a:gd name="connsiteY18" fmla="*/ 260647 h 260647"/>
                    <a:gd name="connsiteX19" fmla="*/ 277738 w 364675"/>
                    <a:gd name="connsiteY19" fmla="*/ 252101 h 260647"/>
                    <a:gd name="connsiteX20" fmla="*/ 256373 w 364675"/>
                    <a:gd name="connsiteY20" fmla="*/ 230736 h 260647"/>
                    <a:gd name="connsiteX21" fmla="*/ 247828 w 364675"/>
                    <a:gd name="connsiteY21" fmla="*/ 217918 h 260647"/>
                    <a:gd name="connsiteX22" fmla="*/ 239282 w 364675"/>
                    <a:gd name="connsiteY22" fmla="*/ 166643 h 260647"/>
                    <a:gd name="connsiteX23" fmla="*/ 230736 w 364675"/>
                    <a:gd name="connsiteY23" fmla="*/ 141006 h 260647"/>
                    <a:gd name="connsiteX24" fmla="*/ 226463 w 364675"/>
                    <a:gd name="connsiteY24" fmla="*/ 128187 h 260647"/>
                    <a:gd name="connsiteX25" fmla="*/ 213644 w 364675"/>
                    <a:gd name="connsiteY25" fmla="*/ 119641 h 260647"/>
                    <a:gd name="connsiteX26" fmla="*/ 200826 w 364675"/>
                    <a:gd name="connsiteY26" fmla="*/ 106822 h 260647"/>
                    <a:gd name="connsiteX27" fmla="*/ 170915 w 364675"/>
                    <a:gd name="connsiteY27" fmla="*/ 98277 h 260647"/>
                    <a:gd name="connsiteX28" fmla="*/ 145278 w 364675"/>
                    <a:gd name="connsiteY28" fmla="*/ 89731 h 260647"/>
                    <a:gd name="connsiteX29" fmla="*/ 119641 w 364675"/>
                    <a:gd name="connsiteY29" fmla="*/ 76912 h 260647"/>
                    <a:gd name="connsiteX30" fmla="*/ 42728 w 364675"/>
                    <a:gd name="connsiteY30" fmla="*/ 72639 h 260647"/>
                    <a:gd name="connsiteX31" fmla="*/ 8545 w 364675"/>
                    <a:gd name="connsiteY31" fmla="*/ 68366 h 260647"/>
                    <a:gd name="connsiteX32" fmla="*/ 0 w 364675"/>
                    <a:gd name="connsiteY32" fmla="*/ 29910 h 26064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</a:cxnLst>
                  <a:rect l="l" t="t" r="r" b="b"/>
                  <a:pathLst>
                    <a:path w="364675" h="260647">
                      <a:moveTo>
                        <a:pt x="0" y="29910"/>
                      </a:moveTo>
                      <a:lnTo>
                        <a:pt x="0" y="29910"/>
                      </a:lnTo>
                      <a:cubicBezTo>
                        <a:pt x="12819" y="27061"/>
                        <a:pt x="25717" y="24549"/>
                        <a:pt x="38456" y="21364"/>
                      </a:cubicBezTo>
                      <a:cubicBezTo>
                        <a:pt x="67265" y="14162"/>
                        <a:pt x="34848" y="21080"/>
                        <a:pt x="64093" y="8546"/>
                      </a:cubicBezTo>
                      <a:cubicBezTo>
                        <a:pt x="69372" y="6283"/>
                        <a:pt x="98747" y="760"/>
                        <a:pt x="102549" y="0"/>
                      </a:cubicBezTo>
                      <a:cubicBezTo>
                        <a:pt x="129611" y="1424"/>
                        <a:pt x="156737" y="1925"/>
                        <a:pt x="183734" y="4273"/>
                      </a:cubicBezTo>
                      <a:cubicBezTo>
                        <a:pt x="189585" y="4782"/>
                        <a:pt x="195012" y="7715"/>
                        <a:pt x="200826" y="8546"/>
                      </a:cubicBezTo>
                      <a:cubicBezTo>
                        <a:pt x="221633" y="11518"/>
                        <a:pt x="247922" y="11775"/>
                        <a:pt x="269192" y="17092"/>
                      </a:cubicBezTo>
                      <a:cubicBezTo>
                        <a:pt x="277931" y="19277"/>
                        <a:pt x="287334" y="20640"/>
                        <a:pt x="294829" y="25637"/>
                      </a:cubicBezTo>
                      <a:cubicBezTo>
                        <a:pt x="312948" y="37716"/>
                        <a:pt x="303055" y="31886"/>
                        <a:pt x="324740" y="42729"/>
                      </a:cubicBezTo>
                      <a:cubicBezTo>
                        <a:pt x="327589" y="47002"/>
                        <a:pt x="329874" y="51710"/>
                        <a:pt x="333286" y="55548"/>
                      </a:cubicBezTo>
                      <a:cubicBezTo>
                        <a:pt x="341315" y="64581"/>
                        <a:pt x="358923" y="81185"/>
                        <a:pt x="358923" y="81185"/>
                      </a:cubicBezTo>
                      <a:cubicBezTo>
                        <a:pt x="366891" y="105088"/>
                        <a:pt x="366288" y="97454"/>
                        <a:pt x="358923" y="136733"/>
                      </a:cubicBezTo>
                      <a:cubicBezTo>
                        <a:pt x="353921" y="163409"/>
                        <a:pt x="350475" y="157852"/>
                        <a:pt x="341831" y="179462"/>
                      </a:cubicBezTo>
                      <a:cubicBezTo>
                        <a:pt x="338486" y="187826"/>
                        <a:pt x="336134" y="196553"/>
                        <a:pt x="333286" y="205099"/>
                      </a:cubicBezTo>
                      <a:lnTo>
                        <a:pt x="329013" y="217918"/>
                      </a:lnTo>
                      <a:cubicBezTo>
                        <a:pt x="327589" y="222191"/>
                        <a:pt x="327925" y="227551"/>
                        <a:pt x="324740" y="230736"/>
                      </a:cubicBezTo>
                      <a:cubicBezTo>
                        <a:pt x="320467" y="235009"/>
                        <a:pt x="315790" y="238913"/>
                        <a:pt x="311921" y="243555"/>
                      </a:cubicBezTo>
                      <a:cubicBezTo>
                        <a:pt x="297054" y="261396"/>
                        <a:pt x="311600" y="253632"/>
                        <a:pt x="290557" y="260647"/>
                      </a:cubicBezTo>
                      <a:cubicBezTo>
                        <a:pt x="286284" y="257798"/>
                        <a:pt x="281369" y="255732"/>
                        <a:pt x="277738" y="252101"/>
                      </a:cubicBezTo>
                      <a:cubicBezTo>
                        <a:pt x="249251" y="223614"/>
                        <a:pt x="290557" y="253525"/>
                        <a:pt x="256373" y="230736"/>
                      </a:cubicBezTo>
                      <a:cubicBezTo>
                        <a:pt x="253525" y="226463"/>
                        <a:pt x="249631" y="222726"/>
                        <a:pt x="247828" y="217918"/>
                      </a:cubicBezTo>
                      <a:cubicBezTo>
                        <a:pt x="244212" y="208275"/>
                        <a:pt x="240932" y="173793"/>
                        <a:pt x="239282" y="166643"/>
                      </a:cubicBezTo>
                      <a:cubicBezTo>
                        <a:pt x="237256" y="157866"/>
                        <a:pt x="233585" y="149552"/>
                        <a:pt x="230736" y="141006"/>
                      </a:cubicBezTo>
                      <a:cubicBezTo>
                        <a:pt x="229312" y="136733"/>
                        <a:pt x="230211" y="130685"/>
                        <a:pt x="226463" y="128187"/>
                      </a:cubicBezTo>
                      <a:cubicBezTo>
                        <a:pt x="222190" y="125338"/>
                        <a:pt x="217589" y="122929"/>
                        <a:pt x="213644" y="119641"/>
                      </a:cubicBezTo>
                      <a:cubicBezTo>
                        <a:pt x="209002" y="115772"/>
                        <a:pt x="205854" y="110174"/>
                        <a:pt x="200826" y="106822"/>
                      </a:cubicBezTo>
                      <a:cubicBezTo>
                        <a:pt x="196907" y="104209"/>
                        <a:pt x="173508" y="99055"/>
                        <a:pt x="170915" y="98277"/>
                      </a:cubicBezTo>
                      <a:cubicBezTo>
                        <a:pt x="162287" y="95689"/>
                        <a:pt x="152773" y="94728"/>
                        <a:pt x="145278" y="89731"/>
                      </a:cubicBezTo>
                      <a:cubicBezTo>
                        <a:pt x="137117" y="84290"/>
                        <a:pt x="129959" y="77895"/>
                        <a:pt x="119641" y="76912"/>
                      </a:cubicBezTo>
                      <a:cubicBezTo>
                        <a:pt x="94079" y="74478"/>
                        <a:pt x="68366" y="74063"/>
                        <a:pt x="42728" y="72639"/>
                      </a:cubicBezTo>
                      <a:cubicBezTo>
                        <a:pt x="31334" y="71215"/>
                        <a:pt x="19843" y="70420"/>
                        <a:pt x="8545" y="68366"/>
                      </a:cubicBezTo>
                      <a:cubicBezTo>
                        <a:pt x="4114" y="67560"/>
                        <a:pt x="1424" y="36319"/>
                        <a:pt x="0" y="29910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7" name="Freeform 46">
                  <a:extLst>
                    <a:ext uri="{FF2B5EF4-FFF2-40B4-BE49-F238E27FC236}">
                      <a16:creationId xmlns:a16="http://schemas.microsoft.com/office/drawing/2014/main" id="{D1C71BA6-36BD-6CDF-EB71-D74C4DB834B1}"/>
                    </a:ext>
                  </a:extLst>
                </p:cNvPr>
                <p:cNvSpPr/>
                <p:nvPr/>
              </p:nvSpPr>
              <p:spPr>
                <a:xfrm>
                  <a:off x="6251028" y="1718441"/>
                  <a:ext cx="316674" cy="874987"/>
                </a:xfrm>
                <a:custGeom>
                  <a:avLst/>
                  <a:gdLst>
                    <a:gd name="connsiteX0" fmla="*/ 0 w 316674"/>
                    <a:gd name="connsiteY0" fmla="*/ 0 h 874987"/>
                    <a:gd name="connsiteX1" fmla="*/ 0 w 316674"/>
                    <a:gd name="connsiteY1" fmla="*/ 0 h 874987"/>
                    <a:gd name="connsiteX2" fmla="*/ 94593 w 316674"/>
                    <a:gd name="connsiteY2" fmla="*/ 31531 h 874987"/>
                    <a:gd name="connsiteX3" fmla="*/ 126124 w 316674"/>
                    <a:gd name="connsiteY3" fmla="*/ 78828 h 874987"/>
                    <a:gd name="connsiteX4" fmla="*/ 126124 w 316674"/>
                    <a:gd name="connsiteY4" fmla="*/ 291662 h 874987"/>
                    <a:gd name="connsiteX5" fmla="*/ 110358 w 316674"/>
                    <a:gd name="connsiteY5" fmla="*/ 354725 h 874987"/>
                    <a:gd name="connsiteX6" fmla="*/ 102475 w 316674"/>
                    <a:gd name="connsiteY6" fmla="*/ 386256 h 874987"/>
                    <a:gd name="connsiteX7" fmla="*/ 110358 w 316674"/>
                    <a:gd name="connsiteY7" fmla="*/ 488731 h 874987"/>
                    <a:gd name="connsiteX8" fmla="*/ 118241 w 316674"/>
                    <a:gd name="connsiteY8" fmla="*/ 512380 h 874987"/>
                    <a:gd name="connsiteX9" fmla="*/ 141889 w 316674"/>
                    <a:gd name="connsiteY9" fmla="*/ 528145 h 874987"/>
                    <a:gd name="connsiteX10" fmla="*/ 157655 w 316674"/>
                    <a:gd name="connsiteY10" fmla="*/ 551793 h 874987"/>
                    <a:gd name="connsiteX11" fmla="*/ 197069 w 316674"/>
                    <a:gd name="connsiteY11" fmla="*/ 591207 h 874987"/>
                    <a:gd name="connsiteX12" fmla="*/ 204951 w 316674"/>
                    <a:gd name="connsiteY12" fmla="*/ 614856 h 874987"/>
                    <a:gd name="connsiteX13" fmla="*/ 220717 w 316674"/>
                    <a:gd name="connsiteY13" fmla="*/ 638504 h 874987"/>
                    <a:gd name="connsiteX14" fmla="*/ 236482 w 316674"/>
                    <a:gd name="connsiteY14" fmla="*/ 717331 h 874987"/>
                    <a:gd name="connsiteX15" fmla="*/ 252248 w 316674"/>
                    <a:gd name="connsiteY15" fmla="*/ 740980 h 874987"/>
                    <a:gd name="connsiteX16" fmla="*/ 299544 w 316674"/>
                    <a:gd name="connsiteY16" fmla="*/ 772511 h 874987"/>
                    <a:gd name="connsiteX17" fmla="*/ 307427 w 316674"/>
                    <a:gd name="connsiteY17" fmla="*/ 843456 h 874987"/>
                    <a:gd name="connsiteX18" fmla="*/ 299544 w 316674"/>
                    <a:gd name="connsiteY18" fmla="*/ 867104 h 874987"/>
                    <a:gd name="connsiteX19" fmla="*/ 275896 w 316674"/>
                    <a:gd name="connsiteY19" fmla="*/ 874987 h 874987"/>
                    <a:gd name="connsiteX20" fmla="*/ 252248 w 316674"/>
                    <a:gd name="connsiteY20" fmla="*/ 867104 h 874987"/>
                    <a:gd name="connsiteX21" fmla="*/ 197069 w 316674"/>
                    <a:gd name="connsiteY21" fmla="*/ 804042 h 874987"/>
                    <a:gd name="connsiteX22" fmla="*/ 181303 w 316674"/>
                    <a:gd name="connsiteY22" fmla="*/ 756745 h 874987"/>
                    <a:gd name="connsiteX23" fmla="*/ 173420 w 316674"/>
                    <a:gd name="connsiteY23" fmla="*/ 733097 h 874987"/>
                    <a:gd name="connsiteX24" fmla="*/ 141889 w 316674"/>
                    <a:gd name="connsiteY24" fmla="*/ 685800 h 874987"/>
                    <a:gd name="connsiteX25" fmla="*/ 110358 w 316674"/>
                    <a:gd name="connsiteY25" fmla="*/ 646387 h 874987"/>
                    <a:gd name="connsiteX26" fmla="*/ 63062 w 316674"/>
                    <a:gd name="connsiteY26" fmla="*/ 504497 h 874987"/>
                    <a:gd name="connsiteX27" fmla="*/ 47296 w 316674"/>
                    <a:gd name="connsiteY27" fmla="*/ 457200 h 874987"/>
                    <a:gd name="connsiteX28" fmla="*/ 39413 w 316674"/>
                    <a:gd name="connsiteY28" fmla="*/ 433552 h 874987"/>
                    <a:gd name="connsiteX29" fmla="*/ 63062 w 316674"/>
                    <a:gd name="connsiteY29" fmla="*/ 346842 h 874987"/>
                    <a:gd name="connsiteX30" fmla="*/ 70944 w 316674"/>
                    <a:gd name="connsiteY30" fmla="*/ 323193 h 874987"/>
                    <a:gd name="connsiteX31" fmla="*/ 63062 w 316674"/>
                    <a:gd name="connsiteY31" fmla="*/ 141890 h 874987"/>
                    <a:gd name="connsiteX32" fmla="*/ 47296 w 316674"/>
                    <a:gd name="connsiteY32" fmla="*/ 94593 h 874987"/>
                    <a:gd name="connsiteX33" fmla="*/ 23648 w 316674"/>
                    <a:gd name="connsiteY33" fmla="*/ 78828 h 874987"/>
                    <a:gd name="connsiteX34" fmla="*/ 0 w 316674"/>
                    <a:gd name="connsiteY34" fmla="*/ 0 h 87498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</a:cxnLst>
                  <a:rect l="l" t="t" r="r" b="b"/>
                  <a:pathLst>
                    <a:path w="316674" h="874987">
                      <a:moveTo>
                        <a:pt x="0" y="0"/>
                      </a:moveTo>
                      <a:lnTo>
                        <a:pt x="0" y="0"/>
                      </a:lnTo>
                      <a:cubicBezTo>
                        <a:pt x="22251" y="4945"/>
                        <a:pt x="73447" y="7365"/>
                        <a:pt x="94593" y="31531"/>
                      </a:cubicBezTo>
                      <a:cubicBezTo>
                        <a:pt x="107070" y="45791"/>
                        <a:pt x="126124" y="78828"/>
                        <a:pt x="126124" y="78828"/>
                      </a:cubicBezTo>
                      <a:cubicBezTo>
                        <a:pt x="152907" y="159183"/>
                        <a:pt x="142380" y="118261"/>
                        <a:pt x="126124" y="291662"/>
                      </a:cubicBezTo>
                      <a:cubicBezTo>
                        <a:pt x="124102" y="313235"/>
                        <a:pt x="115613" y="333704"/>
                        <a:pt x="110358" y="354725"/>
                      </a:cubicBezTo>
                      <a:lnTo>
                        <a:pt x="102475" y="386256"/>
                      </a:lnTo>
                      <a:cubicBezTo>
                        <a:pt x="105103" y="420414"/>
                        <a:pt x="106109" y="454736"/>
                        <a:pt x="110358" y="488731"/>
                      </a:cubicBezTo>
                      <a:cubicBezTo>
                        <a:pt x="111389" y="496976"/>
                        <a:pt x="113050" y="505891"/>
                        <a:pt x="118241" y="512380"/>
                      </a:cubicBezTo>
                      <a:cubicBezTo>
                        <a:pt x="124159" y="519778"/>
                        <a:pt x="134006" y="522890"/>
                        <a:pt x="141889" y="528145"/>
                      </a:cubicBezTo>
                      <a:cubicBezTo>
                        <a:pt x="147144" y="536028"/>
                        <a:pt x="150956" y="545094"/>
                        <a:pt x="157655" y="551793"/>
                      </a:cubicBezTo>
                      <a:cubicBezTo>
                        <a:pt x="210207" y="604345"/>
                        <a:pt x="155026" y="528146"/>
                        <a:pt x="197069" y="591207"/>
                      </a:cubicBezTo>
                      <a:cubicBezTo>
                        <a:pt x="199696" y="599090"/>
                        <a:pt x="201235" y="607424"/>
                        <a:pt x="204951" y="614856"/>
                      </a:cubicBezTo>
                      <a:cubicBezTo>
                        <a:pt x="209188" y="623330"/>
                        <a:pt x="217995" y="629430"/>
                        <a:pt x="220717" y="638504"/>
                      </a:cubicBezTo>
                      <a:cubicBezTo>
                        <a:pt x="231608" y="674806"/>
                        <a:pt x="221905" y="688177"/>
                        <a:pt x="236482" y="717331"/>
                      </a:cubicBezTo>
                      <a:cubicBezTo>
                        <a:pt x="240719" y="725805"/>
                        <a:pt x="245118" y="734741"/>
                        <a:pt x="252248" y="740980"/>
                      </a:cubicBezTo>
                      <a:cubicBezTo>
                        <a:pt x="266507" y="753457"/>
                        <a:pt x="299544" y="772511"/>
                        <a:pt x="299544" y="772511"/>
                      </a:cubicBezTo>
                      <a:cubicBezTo>
                        <a:pt x="322777" y="807359"/>
                        <a:pt x="319228" y="790354"/>
                        <a:pt x="307427" y="843456"/>
                      </a:cubicBezTo>
                      <a:cubicBezTo>
                        <a:pt x="305624" y="851567"/>
                        <a:pt x="305419" y="861229"/>
                        <a:pt x="299544" y="867104"/>
                      </a:cubicBezTo>
                      <a:cubicBezTo>
                        <a:pt x="293669" y="872979"/>
                        <a:pt x="283779" y="872359"/>
                        <a:pt x="275896" y="874987"/>
                      </a:cubicBezTo>
                      <a:cubicBezTo>
                        <a:pt x="268013" y="872359"/>
                        <a:pt x="259680" y="870820"/>
                        <a:pt x="252248" y="867104"/>
                      </a:cubicBezTo>
                      <a:cubicBezTo>
                        <a:pt x="226499" y="854229"/>
                        <a:pt x="206528" y="832418"/>
                        <a:pt x="197069" y="804042"/>
                      </a:cubicBezTo>
                      <a:lnTo>
                        <a:pt x="181303" y="756745"/>
                      </a:lnTo>
                      <a:cubicBezTo>
                        <a:pt x="178675" y="748862"/>
                        <a:pt x="178029" y="740011"/>
                        <a:pt x="173420" y="733097"/>
                      </a:cubicBezTo>
                      <a:cubicBezTo>
                        <a:pt x="162910" y="717331"/>
                        <a:pt x="147881" y="703775"/>
                        <a:pt x="141889" y="685800"/>
                      </a:cubicBezTo>
                      <a:cubicBezTo>
                        <a:pt x="131010" y="653164"/>
                        <a:pt x="140920" y="666761"/>
                        <a:pt x="110358" y="646387"/>
                      </a:cubicBezTo>
                      <a:lnTo>
                        <a:pt x="63062" y="504497"/>
                      </a:lnTo>
                      <a:lnTo>
                        <a:pt x="47296" y="457200"/>
                      </a:lnTo>
                      <a:lnTo>
                        <a:pt x="39413" y="433552"/>
                      </a:lnTo>
                      <a:cubicBezTo>
                        <a:pt x="50557" y="377836"/>
                        <a:pt x="43057" y="406857"/>
                        <a:pt x="63062" y="346842"/>
                      </a:cubicBezTo>
                      <a:lnTo>
                        <a:pt x="70944" y="323193"/>
                      </a:lnTo>
                      <a:cubicBezTo>
                        <a:pt x="68317" y="262759"/>
                        <a:pt x="69286" y="202060"/>
                        <a:pt x="63062" y="141890"/>
                      </a:cubicBezTo>
                      <a:cubicBezTo>
                        <a:pt x="61352" y="125360"/>
                        <a:pt x="61124" y="103811"/>
                        <a:pt x="47296" y="94593"/>
                      </a:cubicBezTo>
                      <a:lnTo>
                        <a:pt x="23648" y="78828"/>
                      </a:lnTo>
                      <a:cubicBezTo>
                        <a:pt x="12441" y="45209"/>
                        <a:pt x="3941" y="13138"/>
                        <a:pt x="0" y="0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9" name="Freeform 48">
                  <a:extLst>
                    <a:ext uri="{FF2B5EF4-FFF2-40B4-BE49-F238E27FC236}">
                      <a16:creationId xmlns:a16="http://schemas.microsoft.com/office/drawing/2014/main" id="{6B8AD286-D6C5-8DF2-F490-2152E57B00B2}"/>
                    </a:ext>
                  </a:extLst>
                </p:cNvPr>
                <p:cNvSpPr/>
                <p:nvPr/>
              </p:nvSpPr>
              <p:spPr>
                <a:xfrm>
                  <a:off x="6414967" y="3342290"/>
                  <a:ext cx="223207" cy="425669"/>
                </a:xfrm>
                <a:custGeom>
                  <a:avLst/>
                  <a:gdLst>
                    <a:gd name="connsiteX0" fmla="*/ 222316 w 223207"/>
                    <a:gd name="connsiteY0" fmla="*/ 0 h 425669"/>
                    <a:gd name="connsiteX1" fmla="*/ 222316 w 223207"/>
                    <a:gd name="connsiteY1" fmla="*/ 0 h 425669"/>
                    <a:gd name="connsiteX2" fmla="*/ 159254 w 223207"/>
                    <a:gd name="connsiteY2" fmla="*/ 23648 h 425669"/>
                    <a:gd name="connsiteX3" fmla="*/ 143488 w 223207"/>
                    <a:gd name="connsiteY3" fmla="*/ 70944 h 425669"/>
                    <a:gd name="connsiteX4" fmla="*/ 135605 w 223207"/>
                    <a:gd name="connsiteY4" fmla="*/ 94593 h 425669"/>
                    <a:gd name="connsiteX5" fmla="*/ 127723 w 223207"/>
                    <a:gd name="connsiteY5" fmla="*/ 118241 h 425669"/>
                    <a:gd name="connsiteX6" fmla="*/ 111957 w 223207"/>
                    <a:gd name="connsiteY6" fmla="*/ 141889 h 425669"/>
                    <a:gd name="connsiteX7" fmla="*/ 88309 w 223207"/>
                    <a:gd name="connsiteY7" fmla="*/ 189186 h 425669"/>
                    <a:gd name="connsiteX8" fmla="*/ 80426 w 223207"/>
                    <a:gd name="connsiteY8" fmla="*/ 212834 h 425669"/>
                    <a:gd name="connsiteX9" fmla="*/ 64661 w 223207"/>
                    <a:gd name="connsiteY9" fmla="*/ 236482 h 425669"/>
                    <a:gd name="connsiteX10" fmla="*/ 48895 w 223207"/>
                    <a:gd name="connsiteY10" fmla="*/ 283779 h 425669"/>
                    <a:gd name="connsiteX11" fmla="*/ 25247 w 223207"/>
                    <a:gd name="connsiteY11" fmla="*/ 331076 h 425669"/>
                    <a:gd name="connsiteX12" fmla="*/ 9481 w 223207"/>
                    <a:gd name="connsiteY12" fmla="*/ 354724 h 425669"/>
                    <a:gd name="connsiteX13" fmla="*/ 9481 w 223207"/>
                    <a:gd name="connsiteY13" fmla="*/ 417786 h 425669"/>
                    <a:gd name="connsiteX14" fmla="*/ 33130 w 223207"/>
                    <a:gd name="connsiteY14" fmla="*/ 425669 h 425669"/>
                    <a:gd name="connsiteX15" fmla="*/ 80426 w 223207"/>
                    <a:gd name="connsiteY15" fmla="*/ 402020 h 425669"/>
                    <a:gd name="connsiteX16" fmla="*/ 119840 w 223207"/>
                    <a:gd name="connsiteY16" fmla="*/ 362607 h 425669"/>
                    <a:gd name="connsiteX17" fmla="*/ 127723 w 223207"/>
                    <a:gd name="connsiteY17" fmla="*/ 338958 h 425669"/>
                    <a:gd name="connsiteX18" fmla="*/ 167136 w 223207"/>
                    <a:gd name="connsiteY18" fmla="*/ 291662 h 425669"/>
                    <a:gd name="connsiteX19" fmla="*/ 206550 w 223207"/>
                    <a:gd name="connsiteY19" fmla="*/ 173420 h 425669"/>
                    <a:gd name="connsiteX20" fmla="*/ 222316 w 223207"/>
                    <a:gd name="connsiteY20" fmla="*/ 118241 h 425669"/>
                    <a:gd name="connsiteX21" fmla="*/ 222316 w 223207"/>
                    <a:gd name="connsiteY21" fmla="*/ 0 h 42566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</a:cxnLst>
                  <a:rect l="l" t="t" r="r" b="b"/>
                  <a:pathLst>
                    <a:path w="223207" h="425669">
                      <a:moveTo>
                        <a:pt x="222316" y="0"/>
                      </a:moveTo>
                      <a:lnTo>
                        <a:pt x="222316" y="0"/>
                      </a:lnTo>
                      <a:cubicBezTo>
                        <a:pt x="201295" y="7883"/>
                        <a:pt x="175941" y="8630"/>
                        <a:pt x="159254" y="23648"/>
                      </a:cubicBezTo>
                      <a:cubicBezTo>
                        <a:pt x="146902" y="34765"/>
                        <a:pt x="148743" y="55179"/>
                        <a:pt x="143488" y="70944"/>
                      </a:cubicBezTo>
                      <a:lnTo>
                        <a:pt x="135605" y="94593"/>
                      </a:lnTo>
                      <a:cubicBezTo>
                        <a:pt x="132978" y="102476"/>
                        <a:pt x="132332" y="111328"/>
                        <a:pt x="127723" y="118241"/>
                      </a:cubicBezTo>
                      <a:lnTo>
                        <a:pt x="111957" y="141889"/>
                      </a:lnTo>
                      <a:cubicBezTo>
                        <a:pt x="92144" y="201329"/>
                        <a:pt x="118870" y="128065"/>
                        <a:pt x="88309" y="189186"/>
                      </a:cubicBezTo>
                      <a:cubicBezTo>
                        <a:pt x="84593" y="196618"/>
                        <a:pt x="84142" y="205402"/>
                        <a:pt x="80426" y="212834"/>
                      </a:cubicBezTo>
                      <a:cubicBezTo>
                        <a:pt x="76189" y="221308"/>
                        <a:pt x="68509" y="227825"/>
                        <a:pt x="64661" y="236482"/>
                      </a:cubicBezTo>
                      <a:cubicBezTo>
                        <a:pt x="57912" y="251668"/>
                        <a:pt x="58113" y="269951"/>
                        <a:pt x="48895" y="283779"/>
                      </a:cubicBezTo>
                      <a:cubicBezTo>
                        <a:pt x="3710" y="351558"/>
                        <a:pt x="57888" y="265796"/>
                        <a:pt x="25247" y="331076"/>
                      </a:cubicBezTo>
                      <a:cubicBezTo>
                        <a:pt x="21010" y="339550"/>
                        <a:pt x="14736" y="346841"/>
                        <a:pt x="9481" y="354724"/>
                      </a:cubicBezTo>
                      <a:cubicBezTo>
                        <a:pt x="1951" y="377317"/>
                        <a:pt x="-7429" y="392421"/>
                        <a:pt x="9481" y="417786"/>
                      </a:cubicBezTo>
                      <a:cubicBezTo>
                        <a:pt x="14090" y="424700"/>
                        <a:pt x="25247" y="423041"/>
                        <a:pt x="33130" y="425669"/>
                      </a:cubicBezTo>
                      <a:cubicBezTo>
                        <a:pt x="52365" y="419257"/>
                        <a:pt x="65144" y="417302"/>
                        <a:pt x="80426" y="402020"/>
                      </a:cubicBezTo>
                      <a:cubicBezTo>
                        <a:pt x="132974" y="349472"/>
                        <a:pt x="56783" y="404644"/>
                        <a:pt x="119840" y="362607"/>
                      </a:cubicBezTo>
                      <a:cubicBezTo>
                        <a:pt x="122468" y="354724"/>
                        <a:pt x="124007" y="346390"/>
                        <a:pt x="127723" y="338958"/>
                      </a:cubicBezTo>
                      <a:cubicBezTo>
                        <a:pt x="138698" y="317008"/>
                        <a:pt x="149702" y="309096"/>
                        <a:pt x="167136" y="291662"/>
                      </a:cubicBezTo>
                      <a:lnTo>
                        <a:pt x="206550" y="173420"/>
                      </a:lnTo>
                      <a:cubicBezTo>
                        <a:pt x="210810" y="160641"/>
                        <a:pt x="221609" y="130261"/>
                        <a:pt x="222316" y="118241"/>
                      </a:cubicBezTo>
                      <a:cubicBezTo>
                        <a:pt x="224322" y="84141"/>
                        <a:pt x="222316" y="19707"/>
                        <a:pt x="222316" y="0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0" name="Freeform 49">
                  <a:extLst>
                    <a:ext uri="{FF2B5EF4-FFF2-40B4-BE49-F238E27FC236}">
                      <a16:creationId xmlns:a16="http://schemas.microsoft.com/office/drawing/2014/main" id="{1642FD2A-C834-4E4D-2F07-43C1FB8C0B13}"/>
                    </a:ext>
                  </a:extLst>
                </p:cNvPr>
                <p:cNvSpPr/>
                <p:nvPr/>
              </p:nvSpPr>
              <p:spPr>
                <a:xfrm>
                  <a:off x="6471745" y="2546131"/>
                  <a:ext cx="331076" cy="748862"/>
                </a:xfrm>
                <a:custGeom>
                  <a:avLst/>
                  <a:gdLst>
                    <a:gd name="connsiteX0" fmla="*/ 126124 w 331076"/>
                    <a:gd name="connsiteY0" fmla="*/ 0 h 748862"/>
                    <a:gd name="connsiteX1" fmla="*/ 126124 w 331076"/>
                    <a:gd name="connsiteY1" fmla="*/ 0 h 748862"/>
                    <a:gd name="connsiteX2" fmla="*/ 86710 w 331076"/>
                    <a:gd name="connsiteY2" fmla="*/ 55179 h 748862"/>
                    <a:gd name="connsiteX3" fmla="*/ 63062 w 331076"/>
                    <a:gd name="connsiteY3" fmla="*/ 63062 h 748862"/>
                    <a:gd name="connsiteX4" fmla="*/ 23648 w 331076"/>
                    <a:gd name="connsiteY4" fmla="*/ 110359 h 748862"/>
                    <a:gd name="connsiteX5" fmla="*/ 0 w 331076"/>
                    <a:gd name="connsiteY5" fmla="*/ 126124 h 748862"/>
                    <a:gd name="connsiteX6" fmla="*/ 102476 w 331076"/>
                    <a:gd name="connsiteY6" fmla="*/ 157655 h 748862"/>
                    <a:gd name="connsiteX7" fmla="*/ 173421 w 331076"/>
                    <a:gd name="connsiteY7" fmla="*/ 173421 h 748862"/>
                    <a:gd name="connsiteX8" fmla="*/ 197069 w 331076"/>
                    <a:gd name="connsiteY8" fmla="*/ 189186 h 748862"/>
                    <a:gd name="connsiteX9" fmla="*/ 212834 w 331076"/>
                    <a:gd name="connsiteY9" fmla="*/ 212835 h 748862"/>
                    <a:gd name="connsiteX10" fmla="*/ 228600 w 331076"/>
                    <a:gd name="connsiteY10" fmla="*/ 283779 h 748862"/>
                    <a:gd name="connsiteX11" fmla="*/ 236483 w 331076"/>
                    <a:gd name="connsiteY11" fmla="*/ 315310 h 748862"/>
                    <a:gd name="connsiteX12" fmla="*/ 228600 w 331076"/>
                    <a:gd name="connsiteY12" fmla="*/ 378372 h 748862"/>
                    <a:gd name="connsiteX13" fmla="*/ 220717 w 331076"/>
                    <a:gd name="connsiteY13" fmla="*/ 402021 h 748862"/>
                    <a:gd name="connsiteX14" fmla="*/ 197069 w 331076"/>
                    <a:gd name="connsiteY14" fmla="*/ 417786 h 748862"/>
                    <a:gd name="connsiteX15" fmla="*/ 149772 w 331076"/>
                    <a:gd name="connsiteY15" fmla="*/ 488731 h 748862"/>
                    <a:gd name="connsiteX16" fmla="*/ 134007 w 331076"/>
                    <a:gd name="connsiteY16" fmla="*/ 512379 h 748862"/>
                    <a:gd name="connsiteX17" fmla="*/ 118241 w 331076"/>
                    <a:gd name="connsiteY17" fmla="*/ 559676 h 748862"/>
                    <a:gd name="connsiteX18" fmla="*/ 110358 w 331076"/>
                    <a:gd name="connsiteY18" fmla="*/ 583324 h 748862"/>
                    <a:gd name="connsiteX19" fmla="*/ 118241 w 331076"/>
                    <a:gd name="connsiteY19" fmla="*/ 717331 h 748862"/>
                    <a:gd name="connsiteX20" fmla="*/ 126124 w 331076"/>
                    <a:gd name="connsiteY20" fmla="*/ 740979 h 748862"/>
                    <a:gd name="connsiteX21" fmla="*/ 149772 w 331076"/>
                    <a:gd name="connsiteY21" fmla="*/ 748862 h 748862"/>
                    <a:gd name="connsiteX22" fmla="*/ 189186 w 331076"/>
                    <a:gd name="connsiteY22" fmla="*/ 709448 h 748862"/>
                    <a:gd name="connsiteX23" fmla="*/ 197069 w 331076"/>
                    <a:gd name="connsiteY23" fmla="*/ 685800 h 748862"/>
                    <a:gd name="connsiteX24" fmla="*/ 228600 w 331076"/>
                    <a:gd name="connsiteY24" fmla="*/ 638503 h 748862"/>
                    <a:gd name="connsiteX25" fmla="*/ 244365 w 331076"/>
                    <a:gd name="connsiteY25" fmla="*/ 614855 h 748862"/>
                    <a:gd name="connsiteX26" fmla="*/ 268014 w 331076"/>
                    <a:gd name="connsiteY26" fmla="*/ 543910 h 748862"/>
                    <a:gd name="connsiteX27" fmla="*/ 275896 w 331076"/>
                    <a:gd name="connsiteY27" fmla="*/ 520262 h 748862"/>
                    <a:gd name="connsiteX28" fmla="*/ 315310 w 331076"/>
                    <a:gd name="connsiteY28" fmla="*/ 472966 h 748862"/>
                    <a:gd name="connsiteX29" fmla="*/ 323193 w 331076"/>
                    <a:gd name="connsiteY29" fmla="*/ 425669 h 748862"/>
                    <a:gd name="connsiteX30" fmla="*/ 331076 w 331076"/>
                    <a:gd name="connsiteY30" fmla="*/ 386255 h 748862"/>
                    <a:gd name="connsiteX31" fmla="*/ 315310 w 331076"/>
                    <a:gd name="connsiteY31" fmla="*/ 165538 h 748862"/>
                    <a:gd name="connsiteX32" fmla="*/ 291662 w 331076"/>
                    <a:gd name="connsiteY32" fmla="*/ 86710 h 748862"/>
                    <a:gd name="connsiteX33" fmla="*/ 283779 w 331076"/>
                    <a:gd name="connsiteY33" fmla="*/ 63062 h 748862"/>
                    <a:gd name="connsiteX34" fmla="*/ 212834 w 331076"/>
                    <a:gd name="connsiteY34" fmla="*/ 31531 h 748862"/>
                    <a:gd name="connsiteX35" fmla="*/ 189186 w 331076"/>
                    <a:gd name="connsiteY35" fmla="*/ 23648 h 748862"/>
                    <a:gd name="connsiteX36" fmla="*/ 126124 w 331076"/>
                    <a:gd name="connsiteY36" fmla="*/ 0 h 74886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</a:cxnLst>
                  <a:rect l="l" t="t" r="r" b="b"/>
                  <a:pathLst>
                    <a:path w="331076" h="748862">
                      <a:moveTo>
                        <a:pt x="126124" y="0"/>
                      </a:moveTo>
                      <a:lnTo>
                        <a:pt x="126124" y="0"/>
                      </a:lnTo>
                      <a:cubicBezTo>
                        <a:pt x="112986" y="18393"/>
                        <a:pt x="102693" y="39196"/>
                        <a:pt x="86710" y="55179"/>
                      </a:cubicBezTo>
                      <a:cubicBezTo>
                        <a:pt x="80835" y="61054"/>
                        <a:pt x="69976" y="58453"/>
                        <a:pt x="63062" y="63062"/>
                      </a:cubicBezTo>
                      <a:cubicBezTo>
                        <a:pt x="24321" y="88890"/>
                        <a:pt x="52732" y="81275"/>
                        <a:pt x="23648" y="110359"/>
                      </a:cubicBezTo>
                      <a:cubicBezTo>
                        <a:pt x="16949" y="117058"/>
                        <a:pt x="7883" y="120869"/>
                        <a:pt x="0" y="126124"/>
                      </a:cubicBezTo>
                      <a:cubicBezTo>
                        <a:pt x="18149" y="180568"/>
                        <a:pt x="-1387" y="146114"/>
                        <a:pt x="102476" y="157655"/>
                      </a:cubicBezTo>
                      <a:cubicBezTo>
                        <a:pt x="118047" y="159385"/>
                        <a:pt x="155364" y="164393"/>
                        <a:pt x="173421" y="173421"/>
                      </a:cubicBezTo>
                      <a:cubicBezTo>
                        <a:pt x="181895" y="177658"/>
                        <a:pt x="189186" y="183931"/>
                        <a:pt x="197069" y="189186"/>
                      </a:cubicBezTo>
                      <a:cubicBezTo>
                        <a:pt x="202324" y="197069"/>
                        <a:pt x="208597" y="204361"/>
                        <a:pt x="212834" y="212835"/>
                      </a:cubicBezTo>
                      <a:cubicBezTo>
                        <a:pt x="223062" y="233292"/>
                        <a:pt x="224562" y="263591"/>
                        <a:pt x="228600" y="283779"/>
                      </a:cubicBezTo>
                      <a:cubicBezTo>
                        <a:pt x="230725" y="294402"/>
                        <a:pt x="233855" y="304800"/>
                        <a:pt x="236483" y="315310"/>
                      </a:cubicBezTo>
                      <a:cubicBezTo>
                        <a:pt x="233855" y="336331"/>
                        <a:pt x="232390" y="357529"/>
                        <a:pt x="228600" y="378372"/>
                      </a:cubicBezTo>
                      <a:cubicBezTo>
                        <a:pt x="227114" y="386547"/>
                        <a:pt x="225908" y="395532"/>
                        <a:pt x="220717" y="402021"/>
                      </a:cubicBezTo>
                      <a:cubicBezTo>
                        <a:pt x="214799" y="409419"/>
                        <a:pt x="204952" y="412531"/>
                        <a:pt x="197069" y="417786"/>
                      </a:cubicBezTo>
                      <a:lnTo>
                        <a:pt x="149772" y="488731"/>
                      </a:lnTo>
                      <a:cubicBezTo>
                        <a:pt x="144517" y="496614"/>
                        <a:pt x="137003" y="503391"/>
                        <a:pt x="134007" y="512379"/>
                      </a:cubicBezTo>
                      <a:lnTo>
                        <a:pt x="118241" y="559676"/>
                      </a:lnTo>
                      <a:lnTo>
                        <a:pt x="110358" y="583324"/>
                      </a:lnTo>
                      <a:cubicBezTo>
                        <a:pt x="112986" y="627993"/>
                        <a:pt x="113788" y="672807"/>
                        <a:pt x="118241" y="717331"/>
                      </a:cubicBezTo>
                      <a:cubicBezTo>
                        <a:pt x="119068" y="725599"/>
                        <a:pt x="120249" y="735104"/>
                        <a:pt x="126124" y="740979"/>
                      </a:cubicBezTo>
                      <a:cubicBezTo>
                        <a:pt x="131999" y="746854"/>
                        <a:pt x="141889" y="746234"/>
                        <a:pt x="149772" y="748862"/>
                      </a:cubicBezTo>
                      <a:cubicBezTo>
                        <a:pt x="173423" y="733096"/>
                        <a:pt x="176047" y="735726"/>
                        <a:pt x="189186" y="709448"/>
                      </a:cubicBezTo>
                      <a:cubicBezTo>
                        <a:pt x="192902" y="702016"/>
                        <a:pt x="193034" y="693063"/>
                        <a:pt x="197069" y="685800"/>
                      </a:cubicBezTo>
                      <a:cubicBezTo>
                        <a:pt x="206271" y="669237"/>
                        <a:pt x="218090" y="654269"/>
                        <a:pt x="228600" y="638503"/>
                      </a:cubicBezTo>
                      <a:cubicBezTo>
                        <a:pt x="233855" y="630620"/>
                        <a:pt x="241369" y="623843"/>
                        <a:pt x="244365" y="614855"/>
                      </a:cubicBezTo>
                      <a:lnTo>
                        <a:pt x="268014" y="543910"/>
                      </a:lnTo>
                      <a:cubicBezTo>
                        <a:pt x="270641" y="536027"/>
                        <a:pt x="270021" y="526137"/>
                        <a:pt x="275896" y="520262"/>
                      </a:cubicBezTo>
                      <a:cubicBezTo>
                        <a:pt x="306244" y="489915"/>
                        <a:pt x="293361" y="505890"/>
                        <a:pt x="315310" y="472966"/>
                      </a:cubicBezTo>
                      <a:cubicBezTo>
                        <a:pt x="317938" y="457200"/>
                        <a:pt x="320334" y="441394"/>
                        <a:pt x="323193" y="425669"/>
                      </a:cubicBezTo>
                      <a:cubicBezTo>
                        <a:pt x="325590" y="412487"/>
                        <a:pt x="331076" y="399653"/>
                        <a:pt x="331076" y="386255"/>
                      </a:cubicBezTo>
                      <a:cubicBezTo>
                        <a:pt x="331076" y="332665"/>
                        <a:pt x="326120" y="230395"/>
                        <a:pt x="315310" y="165538"/>
                      </a:cubicBezTo>
                      <a:cubicBezTo>
                        <a:pt x="311339" y="141716"/>
                        <a:pt x="298669" y="107730"/>
                        <a:pt x="291662" y="86710"/>
                      </a:cubicBezTo>
                      <a:cubicBezTo>
                        <a:pt x="289034" y="78827"/>
                        <a:pt x="290693" y="67671"/>
                        <a:pt x="283779" y="63062"/>
                      </a:cubicBezTo>
                      <a:cubicBezTo>
                        <a:pt x="246303" y="38079"/>
                        <a:pt x="269119" y="50293"/>
                        <a:pt x="212834" y="31531"/>
                      </a:cubicBezTo>
                      <a:cubicBezTo>
                        <a:pt x="204951" y="28903"/>
                        <a:pt x="197495" y="23648"/>
                        <a:pt x="189186" y="23648"/>
                      </a:cubicBezTo>
                      <a:lnTo>
                        <a:pt x="126124" y="0"/>
                      </a:ln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  <p:cxnSp>
          <p:nvCxnSpPr>
            <p:cNvPr id="4" name="Straight Connector 3">
              <a:extLst>
                <a:ext uri="{FF2B5EF4-FFF2-40B4-BE49-F238E27FC236}">
                  <a16:creationId xmlns:a16="http://schemas.microsoft.com/office/drawing/2014/main" id="{3EE4FB1B-6CD4-ED67-9B40-AB4630BC0C69}"/>
                </a:ext>
              </a:extLst>
            </p:cNvPr>
            <p:cNvCxnSpPr>
              <a:cxnSpLocks/>
            </p:cNvCxnSpPr>
            <p:nvPr/>
          </p:nvCxnSpPr>
          <p:spPr>
            <a:xfrm>
              <a:off x="2634855" y="2675342"/>
              <a:ext cx="450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2BD752C7-AE23-6AF6-A3E2-7236F9C88E1B}"/>
                </a:ext>
              </a:extLst>
            </p:cNvPr>
            <p:cNvCxnSpPr>
              <a:cxnSpLocks/>
            </p:cNvCxnSpPr>
            <p:nvPr/>
          </p:nvCxnSpPr>
          <p:spPr>
            <a:xfrm>
              <a:off x="2634855" y="4400956"/>
              <a:ext cx="450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2ECBC0E6-58D7-49F0-362C-61DFB4A656C9}"/>
                </a:ext>
              </a:extLst>
            </p:cNvPr>
            <p:cNvCxnSpPr>
              <a:cxnSpLocks/>
            </p:cNvCxnSpPr>
            <p:nvPr/>
          </p:nvCxnSpPr>
          <p:spPr>
            <a:xfrm>
              <a:off x="6045370" y="4400956"/>
              <a:ext cx="360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F03443B0-39D6-BBC8-445C-AE1CAD3DB9B9}"/>
                </a:ext>
              </a:extLst>
            </p:cNvPr>
            <p:cNvCxnSpPr>
              <a:cxnSpLocks/>
            </p:cNvCxnSpPr>
            <p:nvPr/>
          </p:nvCxnSpPr>
          <p:spPr>
            <a:xfrm>
              <a:off x="9070490" y="4400956"/>
              <a:ext cx="576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537475E7-58D0-8733-6435-FBC4E5D2C811}"/>
                </a:ext>
              </a:extLst>
            </p:cNvPr>
            <p:cNvSpPr txBox="1"/>
            <p:nvPr/>
          </p:nvSpPr>
          <p:spPr>
            <a:xfrm>
              <a:off x="2020104" y="2493703"/>
              <a:ext cx="92373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250nm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55FE4F1-2D5B-6CAC-3E2D-C50CBF399904}"/>
                </a:ext>
              </a:extLst>
            </p:cNvPr>
            <p:cNvSpPr txBox="1"/>
            <p:nvPr/>
          </p:nvSpPr>
          <p:spPr>
            <a:xfrm>
              <a:off x="2020104" y="4223768"/>
              <a:ext cx="92373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250nm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72631B8-FF6E-D8C2-78F0-99CB37E658CB}"/>
                </a:ext>
              </a:extLst>
            </p:cNvPr>
            <p:cNvSpPr txBox="1"/>
            <p:nvPr/>
          </p:nvSpPr>
          <p:spPr>
            <a:xfrm>
              <a:off x="5436757" y="4223768"/>
              <a:ext cx="92373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250nm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0346C0C0-2AE8-C485-9042-606518B72AF4}"/>
                </a:ext>
              </a:extLst>
            </p:cNvPr>
            <p:cNvSpPr txBox="1"/>
            <p:nvPr/>
          </p:nvSpPr>
          <p:spPr>
            <a:xfrm>
              <a:off x="8460080" y="4223768"/>
              <a:ext cx="92373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250n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74953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00</Words>
  <Application>Microsoft Macintosh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Eden, Emily</dc:creator>
  <cp:keywords/>
  <dc:description/>
  <cp:lastModifiedBy>Eden, Emily</cp:lastModifiedBy>
  <cp:revision>1</cp:revision>
  <dcterms:created xsi:type="dcterms:W3CDTF">2025-01-08T18:28:47Z</dcterms:created>
  <dcterms:modified xsi:type="dcterms:W3CDTF">2025-01-08T18:30:09Z</dcterms:modified>
  <cp:category/>
</cp:coreProperties>
</file>